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90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G\ARTICOLI\2022\The%20Use%20of%20Polarized%20light\Spettri%20-%20Figure%20aggiuntiv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43509692867341"/>
          <c:y val="3.4542196544752664E-2"/>
          <c:w val="0.80125383230872027"/>
          <c:h val="0.79882204504602128"/>
        </c:manualLayout>
      </c:layout>
      <c:scatterChart>
        <c:scatterStyle val="lineMarker"/>
        <c:varyColors val="0"/>
        <c:ser>
          <c:idx val="0"/>
          <c:order val="0"/>
          <c:tx>
            <c:strRef>
              <c:f>'SPETTRI Sorgente-Filtri'!$F$1</c:f>
              <c:strCache>
                <c:ptCount val="1"/>
                <c:pt idx="0">
                  <c:v>Polarizing Filter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SPETTRI Sorgente-Filtri'!$A$2:$A$552</c:f>
              <c:numCache>
                <c:formatCode>General</c:formatCode>
                <c:ptCount val="551"/>
                <c:pt idx="0">
                  <c:v>750</c:v>
                </c:pt>
                <c:pt idx="1">
                  <c:v>749</c:v>
                </c:pt>
                <c:pt idx="2">
                  <c:v>748</c:v>
                </c:pt>
                <c:pt idx="3">
                  <c:v>747</c:v>
                </c:pt>
                <c:pt idx="4">
                  <c:v>746</c:v>
                </c:pt>
                <c:pt idx="5">
                  <c:v>745</c:v>
                </c:pt>
                <c:pt idx="6">
                  <c:v>744</c:v>
                </c:pt>
                <c:pt idx="7">
                  <c:v>743</c:v>
                </c:pt>
                <c:pt idx="8">
                  <c:v>742</c:v>
                </c:pt>
                <c:pt idx="9">
                  <c:v>741</c:v>
                </c:pt>
                <c:pt idx="10">
                  <c:v>740</c:v>
                </c:pt>
                <c:pt idx="11">
                  <c:v>739</c:v>
                </c:pt>
                <c:pt idx="12">
                  <c:v>738</c:v>
                </c:pt>
                <c:pt idx="13">
                  <c:v>737</c:v>
                </c:pt>
                <c:pt idx="14">
                  <c:v>736</c:v>
                </c:pt>
                <c:pt idx="15">
                  <c:v>735</c:v>
                </c:pt>
                <c:pt idx="16">
                  <c:v>734</c:v>
                </c:pt>
                <c:pt idx="17">
                  <c:v>733</c:v>
                </c:pt>
                <c:pt idx="18">
                  <c:v>732</c:v>
                </c:pt>
                <c:pt idx="19">
                  <c:v>731</c:v>
                </c:pt>
                <c:pt idx="20">
                  <c:v>730</c:v>
                </c:pt>
                <c:pt idx="21">
                  <c:v>729</c:v>
                </c:pt>
                <c:pt idx="22">
                  <c:v>728</c:v>
                </c:pt>
                <c:pt idx="23">
                  <c:v>727</c:v>
                </c:pt>
                <c:pt idx="24">
                  <c:v>726</c:v>
                </c:pt>
                <c:pt idx="25">
                  <c:v>725</c:v>
                </c:pt>
                <c:pt idx="26">
                  <c:v>724</c:v>
                </c:pt>
                <c:pt idx="27">
                  <c:v>723</c:v>
                </c:pt>
                <c:pt idx="28">
                  <c:v>722</c:v>
                </c:pt>
                <c:pt idx="29">
                  <c:v>721</c:v>
                </c:pt>
                <c:pt idx="30">
                  <c:v>720</c:v>
                </c:pt>
                <c:pt idx="31">
                  <c:v>719</c:v>
                </c:pt>
                <c:pt idx="32">
                  <c:v>718</c:v>
                </c:pt>
                <c:pt idx="33">
                  <c:v>717</c:v>
                </c:pt>
                <c:pt idx="34">
                  <c:v>716</c:v>
                </c:pt>
                <c:pt idx="35">
                  <c:v>715</c:v>
                </c:pt>
                <c:pt idx="36">
                  <c:v>714</c:v>
                </c:pt>
                <c:pt idx="37">
                  <c:v>713</c:v>
                </c:pt>
                <c:pt idx="38">
                  <c:v>712</c:v>
                </c:pt>
                <c:pt idx="39">
                  <c:v>711</c:v>
                </c:pt>
                <c:pt idx="40">
                  <c:v>710</c:v>
                </c:pt>
                <c:pt idx="41">
                  <c:v>709</c:v>
                </c:pt>
                <c:pt idx="42">
                  <c:v>708</c:v>
                </c:pt>
                <c:pt idx="43">
                  <c:v>707</c:v>
                </c:pt>
                <c:pt idx="44">
                  <c:v>706</c:v>
                </c:pt>
                <c:pt idx="45">
                  <c:v>705</c:v>
                </c:pt>
                <c:pt idx="46">
                  <c:v>704</c:v>
                </c:pt>
                <c:pt idx="47">
                  <c:v>703</c:v>
                </c:pt>
                <c:pt idx="48">
                  <c:v>702</c:v>
                </c:pt>
                <c:pt idx="49">
                  <c:v>701</c:v>
                </c:pt>
                <c:pt idx="50">
                  <c:v>700</c:v>
                </c:pt>
                <c:pt idx="51">
                  <c:v>699</c:v>
                </c:pt>
                <c:pt idx="52">
                  <c:v>698</c:v>
                </c:pt>
                <c:pt idx="53">
                  <c:v>697</c:v>
                </c:pt>
                <c:pt idx="54">
                  <c:v>696</c:v>
                </c:pt>
                <c:pt idx="55">
                  <c:v>695</c:v>
                </c:pt>
                <c:pt idx="56">
                  <c:v>694</c:v>
                </c:pt>
                <c:pt idx="57">
                  <c:v>693</c:v>
                </c:pt>
                <c:pt idx="58">
                  <c:v>692</c:v>
                </c:pt>
                <c:pt idx="59">
                  <c:v>691</c:v>
                </c:pt>
                <c:pt idx="60">
                  <c:v>690</c:v>
                </c:pt>
                <c:pt idx="61">
                  <c:v>689</c:v>
                </c:pt>
                <c:pt idx="62">
                  <c:v>688</c:v>
                </c:pt>
                <c:pt idx="63">
                  <c:v>687</c:v>
                </c:pt>
                <c:pt idx="64">
                  <c:v>686</c:v>
                </c:pt>
                <c:pt idx="65">
                  <c:v>685</c:v>
                </c:pt>
                <c:pt idx="66">
                  <c:v>684</c:v>
                </c:pt>
                <c:pt idx="67">
                  <c:v>683</c:v>
                </c:pt>
                <c:pt idx="68">
                  <c:v>682</c:v>
                </c:pt>
                <c:pt idx="69">
                  <c:v>681</c:v>
                </c:pt>
                <c:pt idx="70">
                  <c:v>680</c:v>
                </c:pt>
                <c:pt idx="71">
                  <c:v>679</c:v>
                </c:pt>
                <c:pt idx="72">
                  <c:v>678</c:v>
                </c:pt>
                <c:pt idx="73">
                  <c:v>677</c:v>
                </c:pt>
                <c:pt idx="74">
                  <c:v>676</c:v>
                </c:pt>
                <c:pt idx="75">
                  <c:v>675</c:v>
                </c:pt>
                <c:pt idx="76">
                  <c:v>674</c:v>
                </c:pt>
                <c:pt idx="77">
                  <c:v>673</c:v>
                </c:pt>
                <c:pt idx="78">
                  <c:v>672</c:v>
                </c:pt>
                <c:pt idx="79">
                  <c:v>671</c:v>
                </c:pt>
                <c:pt idx="80">
                  <c:v>670</c:v>
                </c:pt>
                <c:pt idx="81">
                  <c:v>669</c:v>
                </c:pt>
                <c:pt idx="82">
                  <c:v>668</c:v>
                </c:pt>
                <c:pt idx="83">
                  <c:v>667</c:v>
                </c:pt>
                <c:pt idx="84">
                  <c:v>666</c:v>
                </c:pt>
                <c:pt idx="85">
                  <c:v>665</c:v>
                </c:pt>
                <c:pt idx="86">
                  <c:v>664</c:v>
                </c:pt>
                <c:pt idx="87">
                  <c:v>663</c:v>
                </c:pt>
                <c:pt idx="88">
                  <c:v>662</c:v>
                </c:pt>
                <c:pt idx="89">
                  <c:v>661</c:v>
                </c:pt>
                <c:pt idx="90">
                  <c:v>660</c:v>
                </c:pt>
                <c:pt idx="91">
                  <c:v>659</c:v>
                </c:pt>
                <c:pt idx="92">
                  <c:v>658</c:v>
                </c:pt>
                <c:pt idx="93">
                  <c:v>657</c:v>
                </c:pt>
                <c:pt idx="94">
                  <c:v>656</c:v>
                </c:pt>
                <c:pt idx="95">
                  <c:v>655</c:v>
                </c:pt>
                <c:pt idx="96">
                  <c:v>654</c:v>
                </c:pt>
                <c:pt idx="97">
                  <c:v>653</c:v>
                </c:pt>
                <c:pt idx="98">
                  <c:v>652</c:v>
                </c:pt>
                <c:pt idx="99">
                  <c:v>651</c:v>
                </c:pt>
                <c:pt idx="100">
                  <c:v>650</c:v>
                </c:pt>
                <c:pt idx="101">
                  <c:v>649</c:v>
                </c:pt>
                <c:pt idx="102">
                  <c:v>648</c:v>
                </c:pt>
                <c:pt idx="103">
                  <c:v>647</c:v>
                </c:pt>
                <c:pt idx="104">
                  <c:v>646</c:v>
                </c:pt>
                <c:pt idx="105">
                  <c:v>645</c:v>
                </c:pt>
                <c:pt idx="106">
                  <c:v>644</c:v>
                </c:pt>
                <c:pt idx="107">
                  <c:v>643</c:v>
                </c:pt>
                <c:pt idx="108">
                  <c:v>642</c:v>
                </c:pt>
                <c:pt idx="109">
                  <c:v>641</c:v>
                </c:pt>
                <c:pt idx="110">
                  <c:v>640</c:v>
                </c:pt>
                <c:pt idx="111">
                  <c:v>639</c:v>
                </c:pt>
                <c:pt idx="112">
                  <c:v>638</c:v>
                </c:pt>
                <c:pt idx="113">
                  <c:v>637</c:v>
                </c:pt>
                <c:pt idx="114">
                  <c:v>636</c:v>
                </c:pt>
                <c:pt idx="115">
                  <c:v>635</c:v>
                </c:pt>
                <c:pt idx="116">
                  <c:v>634</c:v>
                </c:pt>
                <c:pt idx="117">
                  <c:v>633</c:v>
                </c:pt>
                <c:pt idx="118">
                  <c:v>632</c:v>
                </c:pt>
                <c:pt idx="119">
                  <c:v>631</c:v>
                </c:pt>
                <c:pt idx="120">
                  <c:v>630</c:v>
                </c:pt>
                <c:pt idx="121">
                  <c:v>629</c:v>
                </c:pt>
                <c:pt idx="122">
                  <c:v>628</c:v>
                </c:pt>
                <c:pt idx="123">
                  <c:v>627</c:v>
                </c:pt>
                <c:pt idx="124">
                  <c:v>626</c:v>
                </c:pt>
                <c:pt idx="125">
                  <c:v>625</c:v>
                </c:pt>
                <c:pt idx="126">
                  <c:v>624</c:v>
                </c:pt>
                <c:pt idx="127">
                  <c:v>623</c:v>
                </c:pt>
                <c:pt idx="128">
                  <c:v>622</c:v>
                </c:pt>
                <c:pt idx="129">
                  <c:v>621</c:v>
                </c:pt>
                <c:pt idx="130">
                  <c:v>620</c:v>
                </c:pt>
                <c:pt idx="131">
                  <c:v>619</c:v>
                </c:pt>
                <c:pt idx="132">
                  <c:v>618</c:v>
                </c:pt>
                <c:pt idx="133">
                  <c:v>617</c:v>
                </c:pt>
                <c:pt idx="134">
                  <c:v>616</c:v>
                </c:pt>
                <c:pt idx="135">
                  <c:v>615</c:v>
                </c:pt>
                <c:pt idx="136">
                  <c:v>614</c:v>
                </c:pt>
                <c:pt idx="137">
                  <c:v>613</c:v>
                </c:pt>
                <c:pt idx="138">
                  <c:v>612</c:v>
                </c:pt>
                <c:pt idx="139">
                  <c:v>611</c:v>
                </c:pt>
                <c:pt idx="140">
                  <c:v>610</c:v>
                </c:pt>
                <c:pt idx="141">
                  <c:v>609</c:v>
                </c:pt>
                <c:pt idx="142">
                  <c:v>608</c:v>
                </c:pt>
                <c:pt idx="143">
                  <c:v>607</c:v>
                </c:pt>
                <c:pt idx="144">
                  <c:v>606</c:v>
                </c:pt>
                <c:pt idx="145">
                  <c:v>605</c:v>
                </c:pt>
                <c:pt idx="146">
                  <c:v>604</c:v>
                </c:pt>
                <c:pt idx="147">
                  <c:v>603</c:v>
                </c:pt>
                <c:pt idx="148">
                  <c:v>602</c:v>
                </c:pt>
                <c:pt idx="149">
                  <c:v>601</c:v>
                </c:pt>
                <c:pt idx="150">
                  <c:v>600</c:v>
                </c:pt>
                <c:pt idx="151">
                  <c:v>599</c:v>
                </c:pt>
                <c:pt idx="152">
                  <c:v>598</c:v>
                </c:pt>
                <c:pt idx="153">
                  <c:v>597</c:v>
                </c:pt>
                <c:pt idx="154">
                  <c:v>596</c:v>
                </c:pt>
                <c:pt idx="155">
                  <c:v>595</c:v>
                </c:pt>
                <c:pt idx="156">
                  <c:v>594</c:v>
                </c:pt>
                <c:pt idx="157">
                  <c:v>593</c:v>
                </c:pt>
                <c:pt idx="158">
                  <c:v>592</c:v>
                </c:pt>
                <c:pt idx="159">
                  <c:v>591</c:v>
                </c:pt>
                <c:pt idx="160">
                  <c:v>590</c:v>
                </c:pt>
                <c:pt idx="161">
                  <c:v>589</c:v>
                </c:pt>
                <c:pt idx="162">
                  <c:v>588</c:v>
                </c:pt>
                <c:pt idx="163">
                  <c:v>587</c:v>
                </c:pt>
                <c:pt idx="164">
                  <c:v>586</c:v>
                </c:pt>
                <c:pt idx="165">
                  <c:v>585</c:v>
                </c:pt>
                <c:pt idx="166">
                  <c:v>584</c:v>
                </c:pt>
                <c:pt idx="167">
                  <c:v>583</c:v>
                </c:pt>
                <c:pt idx="168">
                  <c:v>582</c:v>
                </c:pt>
                <c:pt idx="169">
                  <c:v>581</c:v>
                </c:pt>
                <c:pt idx="170">
                  <c:v>580</c:v>
                </c:pt>
                <c:pt idx="171">
                  <c:v>579</c:v>
                </c:pt>
                <c:pt idx="172">
                  <c:v>578</c:v>
                </c:pt>
                <c:pt idx="173">
                  <c:v>577</c:v>
                </c:pt>
                <c:pt idx="174">
                  <c:v>576</c:v>
                </c:pt>
                <c:pt idx="175">
                  <c:v>575</c:v>
                </c:pt>
                <c:pt idx="176">
                  <c:v>574</c:v>
                </c:pt>
                <c:pt idx="177">
                  <c:v>573</c:v>
                </c:pt>
                <c:pt idx="178">
                  <c:v>572</c:v>
                </c:pt>
                <c:pt idx="179">
                  <c:v>571</c:v>
                </c:pt>
                <c:pt idx="180">
                  <c:v>570</c:v>
                </c:pt>
                <c:pt idx="181">
                  <c:v>569</c:v>
                </c:pt>
                <c:pt idx="182">
                  <c:v>568</c:v>
                </c:pt>
                <c:pt idx="183">
                  <c:v>567</c:v>
                </c:pt>
                <c:pt idx="184">
                  <c:v>566</c:v>
                </c:pt>
                <c:pt idx="185">
                  <c:v>565</c:v>
                </c:pt>
                <c:pt idx="186">
                  <c:v>564</c:v>
                </c:pt>
                <c:pt idx="187">
                  <c:v>563</c:v>
                </c:pt>
                <c:pt idx="188">
                  <c:v>562</c:v>
                </c:pt>
                <c:pt idx="189">
                  <c:v>561</c:v>
                </c:pt>
                <c:pt idx="190">
                  <c:v>560</c:v>
                </c:pt>
                <c:pt idx="191">
                  <c:v>559</c:v>
                </c:pt>
                <c:pt idx="192">
                  <c:v>558</c:v>
                </c:pt>
                <c:pt idx="193">
                  <c:v>557</c:v>
                </c:pt>
                <c:pt idx="194">
                  <c:v>556</c:v>
                </c:pt>
                <c:pt idx="195">
                  <c:v>555</c:v>
                </c:pt>
                <c:pt idx="196">
                  <c:v>554</c:v>
                </c:pt>
                <c:pt idx="197">
                  <c:v>553</c:v>
                </c:pt>
                <c:pt idx="198">
                  <c:v>552</c:v>
                </c:pt>
                <c:pt idx="199">
                  <c:v>551</c:v>
                </c:pt>
                <c:pt idx="200">
                  <c:v>550</c:v>
                </c:pt>
                <c:pt idx="201">
                  <c:v>549</c:v>
                </c:pt>
                <c:pt idx="202">
                  <c:v>548</c:v>
                </c:pt>
                <c:pt idx="203">
                  <c:v>547</c:v>
                </c:pt>
                <c:pt idx="204">
                  <c:v>546</c:v>
                </c:pt>
                <c:pt idx="205">
                  <c:v>545</c:v>
                </c:pt>
                <c:pt idx="206">
                  <c:v>544</c:v>
                </c:pt>
                <c:pt idx="207">
                  <c:v>543</c:v>
                </c:pt>
                <c:pt idx="208">
                  <c:v>542</c:v>
                </c:pt>
                <c:pt idx="209">
                  <c:v>541</c:v>
                </c:pt>
                <c:pt idx="210">
                  <c:v>540</c:v>
                </c:pt>
                <c:pt idx="211">
                  <c:v>539</c:v>
                </c:pt>
                <c:pt idx="212">
                  <c:v>538</c:v>
                </c:pt>
                <c:pt idx="213">
                  <c:v>537</c:v>
                </c:pt>
                <c:pt idx="214">
                  <c:v>536</c:v>
                </c:pt>
                <c:pt idx="215">
                  <c:v>535</c:v>
                </c:pt>
                <c:pt idx="216">
                  <c:v>534</c:v>
                </c:pt>
                <c:pt idx="217">
                  <c:v>533</c:v>
                </c:pt>
                <c:pt idx="218">
                  <c:v>532</c:v>
                </c:pt>
                <c:pt idx="219">
                  <c:v>531</c:v>
                </c:pt>
                <c:pt idx="220">
                  <c:v>530</c:v>
                </c:pt>
                <c:pt idx="221">
                  <c:v>529</c:v>
                </c:pt>
                <c:pt idx="222">
                  <c:v>528</c:v>
                </c:pt>
                <c:pt idx="223">
                  <c:v>527</c:v>
                </c:pt>
                <c:pt idx="224">
                  <c:v>526</c:v>
                </c:pt>
                <c:pt idx="225">
                  <c:v>525</c:v>
                </c:pt>
                <c:pt idx="226">
                  <c:v>524</c:v>
                </c:pt>
                <c:pt idx="227">
                  <c:v>523</c:v>
                </c:pt>
                <c:pt idx="228">
                  <c:v>522</c:v>
                </c:pt>
                <c:pt idx="229">
                  <c:v>521</c:v>
                </c:pt>
                <c:pt idx="230">
                  <c:v>520</c:v>
                </c:pt>
                <c:pt idx="231">
                  <c:v>519</c:v>
                </c:pt>
                <c:pt idx="232">
                  <c:v>518</c:v>
                </c:pt>
                <c:pt idx="233">
                  <c:v>517</c:v>
                </c:pt>
                <c:pt idx="234">
                  <c:v>516</c:v>
                </c:pt>
                <c:pt idx="235">
                  <c:v>515</c:v>
                </c:pt>
                <c:pt idx="236">
                  <c:v>514</c:v>
                </c:pt>
                <c:pt idx="237">
                  <c:v>513</c:v>
                </c:pt>
                <c:pt idx="238">
                  <c:v>512</c:v>
                </c:pt>
                <c:pt idx="239">
                  <c:v>511</c:v>
                </c:pt>
                <c:pt idx="240">
                  <c:v>510</c:v>
                </c:pt>
                <c:pt idx="241">
                  <c:v>509</c:v>
                </c:pt>
                <c:pt idx="242">
                  <c:v>508</c:v>
                </c:pt>
                <c:pt idx="243">
                  <c:v>507</c:v>
                </c:pt>
                <c:pt idx="244">
                  <c:v>506</c:v>
                </c:pt>
                <c:pt idx="245">
                  <c:v>505</c:v>
                </c:pt>
                <c:pt idx="246">
                  <c:v>504</c:v>
                </c:pt>
                <c:pt idx="247">
                  <c:v>503</c:v>
                </c:pt>
                <c:pt idx="248">
                  <c:v>502</c:v>
                </c:pt>
                <c:pt idx="249">
                  <c:v>501</c:v>
                </c:pt>
                <c:pt idx="250">
                  <c:v>500</c:v>
                </c:pt>
                <c:pt idx="251">
                  <c:v>499</c:v>
                </c:pt>
                <c:pt idx="252">
                  <c:v>498</c:v>
                </c:pt>
                <c:pt idx="253">
                  <c:v>497</c:v>
                </c:pt>
                <c:pt idx="254">
                  <c:v>496</c:v>
                </c:pt>
                <c:pt idx="255">
                  <c:v>495</c:v>
                </c:pt>
                <c:pt idx="256">
                  <c:v>494</c:v>
                </c:pt>
                <c:pt idx="257">
                  <c:v>493</c:v>
                </c:pt>
                <c:pt idx="258">
                  <c:v>492</c:v>
                </c:pt>
                <c:pt idx="259">
                  <c:v>491</c:v>
                </c:pt>
                <c:pt idx="260">
                  <c:v>490</c:v>
                </c:pt>
                <c:pt idx="261">
                  <c:v>489</c:v>
                </c:pt>
                <c:pt idx="262">
                  <c:v>488</c:v>
                </c:pt>
                <c:pt idx="263">
                  <c:v>487</c:v>
                </c:pt>
                <c:pt idx="264">
                  <c:v>486</c:v>
                </c:pt>
                <c:pt idx="265">
                  <c:v>485</c:v>
                </c:pt>
                <c:pt idx="266">
                  <c:v>484</c:v>
                </c:pt>
                <c:pt idx="267">
                  <c:v>483</c:v>
                </c:pt>
                <c:pt idx="268">
                  <c:v>482</c:v>
                </c:pt>
                <c:pt idx="269">
                  <c:v>481</c:v>
                </c:pt>
                <c:pt idx="270">
                  <c:v>480</c:v>
                </c:pt>
                <c:pt idx="271">
                  <c:v>479</c:v>
                </c:pt>
                <c:pt idx="272">
                  <c:v>478</c:v>
                </c:pt>
                <c:pt idx="273">
                  <c:v>477</c:v>
                </c:pt>
                <c:pt idx="274">
                  <c:v>476</c:v>
                </c:pt>
                <c:pt idx="275">
                  <c:v>475</c:v>
                </c:pt>
                <c:pt idx="276">
                  <c:v>474</c:v>
                </c:pt>
                <c:pt idx="277">
                  <c:v>473</c:v>
                </c:pt>
                <c:pt idx="278">
                  <c:v>472</c:v>
                </c:pt>
                <c:pt idx="279">
                  <c:v>471</c:v>
                </c:pt>
                <c:pt idx="280">
                  <c:v>470</c:v>
                </c:pt>
                <c:pt idx="281">
                  <c:v>469</c:v>
                </c:pt>
                <c:pt idx="282">
                  <c:v>468</c:v>
                </c:pt>
                <c:pt idx="283">
                  <c:v>467</c:v>
                </c:pt>
                <c:pt idx="284">
                  <c:v>466</c:v>
                </c:pt>
                <c:pt idx="285">
                  <c:v>465</c:v>
                </c:pt>
                <c:pt idx="286">
                  <c:v>464</c:v>
                </c:pt>
                <c:pt idx="287">
                  <c:v>463</c:v>
                </c:pt>
                <c:pt idx="288">
                  <c:v>462</c:v>
                </c:pt>
                <c:pt idx="289">
                  <c:v>461</c:v>
                </c:pt>
                <c:pt idx="290">
                  <c:v>460</c:v>
                </c:pt>
                <c:pt idx="291">
                  <c:v>459</c:v>
                </c:pt>
                <c:pt idx="292">
                  <c:v>458</c:v>
                </c:pt>
                <c:pt idx="293">
                  <c:v>457</c:v>
                </c:pt>
                <c:pt idx="294">
                  <c:v>456</c:v>
                </c:pt>
                <c:pt idx="295">
                  <c:v>455</c:v>
                </c:pt>
                <c:pt idx="296">
                  <c:v>454</c:v>
                </c:pt>
                <c:pt idx="297">
                  <c:v>453</c:v>
                </c:pt>
                <c:pt idx="298">
                  <c:v>452</c:v>
                </c:pt>
                <c:pt idx="299">
                  <c:v>451</c:v>
                </c:pt>
                <c:pt idx="300">
                  <c:v>450</c:v>
                </c:pt>
                <c:pt idx="301">
                  <c:v>449</c:v>
                </c:pt>
                <c:pt idx="302">
                  <c:v>448</c:v>
                </c:pt>
                <c:pt idx="303">
                  <c:v>447</c:v>
                </c:pt>
                <c:pt idx="304">
                  <c:v>446</c:v>
                </c:pt>
                <c:pt idx="305">
                  <c:v>445</c:v>
                </c:pt>
                <c:pt idx="306">
                  <c:v>444</c:v>
                </c:pt>
                <c:pt idx="307">
                  <c:v>443</c:v>
                </c:pt>
                <c:pt idx="308">
                  <c:v>442</c:v>
                </c:pt>
                <c:pt idx="309">
                  <c:v>441</c:v>
                </c:pt>
                <c:pt idx="310">
                  <c:v>440</c:v>
                </c:pt>
                <c:pt idx="311">
                  <c:v>439</c:v>
                </c:pt>
                <c:pt idx="312">
                  <c:v>438</c:v>
                </c:pt>
                <c:pt idx="313">
                  <c:v>437</c:v>
                </c:pt>
                <c:pt idx="314">
                  <c:v>436</c:v>
                </c:pt>
                <c:pt idx="315">
                  <c:v>435</c:v>
                </c:pt>
                <c:pt idx="316">
                  <c:v>434</c:v>
                </c:pt>
                <c:pt idx="317">
                  <c:v>433</c:v>
                </c:pt>
                <c:pt idx="318">
                  <c:v>432</c:v>
                </c:pt>
                <c:pt idx="319">
                  <c:v>431</c:v>
                </c:pt>
                <c:pt idx="320">
                  <c:v>430</c:v>
                </c:pt>
                <c:pt idx="321">
                  <c:v>429</c:v>
                </c:pt>
                <c:pt idx="322">
                  <c:v>428</c:v>
                </c:pt>
                <c:pt idx="323">
                  <c:v>427</c:v>
                </c:pt>
                <c:pt idx="324">
                  <c:v>426</c:v>
                </c:pt>
                <c:pt idx="325">
                  <c:v>425</c:v>
                </c:pt>
                <c:pt idx="326">
                  <c:v>424</c:v>
                </c:pt>
                <c:pt idx="327">
                  <c:v>423</c:v>
                </c:pt>
                <c:pt idx="328">
                  <c:v>422</c:v>
                </c:pt>
                <c:pt idx="329">
                  <c:v>421</c:v>
                </c:pt>
                <c:pt idx="330">
                  <c:v>420</c:v>
                </c:pt>
                <c:pt idx="331">
                  <c:v>419</c:v>
                </c:pt>
                <c:pt idx="332">
                  <c:v>418</c:v>
                </c:pt>
                <c:pt idx="333">
                  <c:v>417</c:v>
                </c:pt>
                <c:pt idx="334">
                  <c:v>416</c:v>
                </c:pt>
                <c:pt idx="335">
                  <c:v>415</c:v>
                </c:pt>
                <c:pt idx="336">
                  <c:v>414</c:v>
                </c:pt>
                <c:pt idx="337">
                  <c:v>413</c:v>
                </c:pt>
                <c:pt idx="338">
                  <c:v>412</c:v>
                </c:pt>
                <c:pt idx="339">
                  <c:v>411</c:v>
                </c:pt>
                <c:pt idx="340">
                  <c:v>410</c:v>
                </c:pt>
                <c:pt idx="341">
                  <c:v>409</c:v>
                </c:pt>
                <c:pt idx="342">
                  <c:v>408</c:v>
                </c:pt>
                <c:pt idx="343">
                  <c:v>407</c:v>
                </c:pt>
                <c:pt idx="344">
                  <c:v>406</c:v>
                </c:pt>
                <c:pt idx="345">
                  <c:v>405</c:v>
                </c:pt>
                <c:pt idx="346">
                  <c:v>404</c:v>
                </c:pt>
                <c:pt idx="347">
                  <c:v>403</c:v>
                </c:pt>
                <c:pt idx="348">
                  <c:v>402</c:v>
                </c:pt>
                <c:pt idx="349">
                  <c:v>401</c:v>
                </c:pt>
                <c:pt idx="350">
                  <c:v>400</c:v>
                </c:pt>
                <c:pt idx="351">
                  <c:v>399</c:v>
                </c:pt>
                <c:pt idx="352">
                  <c:v>398</c:v>
                </c:pt>
                <c:pt idx="353">
                  <c:v>397</c:v>
                </c:pt>
                <c:pt idx="354">
                  <c:v>396</c:v>
                </c:pt>
                <c:pt idx="355">
                  <c:v>395</c:v>
                </c:pt>
                <c:pt idx="356">
                  <c:v>394</c:v>
                </c:pt>
                <c:pt idx="357">
                  <c:v>393</c:v>
                </c:pt>
                <c:pt idx="358">
                  <c:v>392</c:v>
                </c:pt>
                <c:pt idx="359">
                  <c:v>391</c:v>
                </c:pt>
                <c:pt idx="360">
                  <c:v>390</c:v>
                </c:pt>
                <c:pt idx="361">
                  <c:v>389</c:v>
                </c:pt>
                <c:pt idx="362">
                  <c:v>388</c:v>
                </c:pt>
                <c:pt idx="363">
                  <c:v>387</c:v>
                </c:pt>
                <c:pt idx="364">
                  <c:v>386</c:v>
                </c:pt>
                <c:pt idx="365">
                  <c:v>385</c:v>
                </c:pt>
                <c:pt idx="366">
                  <c:v>384</c:v>
                </c:pt>
                <c:pt idx="367">
                  <c:v>383</c:v>
                </c:pt>
                <c:pt idx="368">
                  <c:v>382</c:v>
                </c:pt>
                <c:pt idx="369">
                  <c:v>381</c:v>
                </c:pt>
                <c:pt idx="370">
                  <c:v>380</c:v>
                </c:pt>
                <c:pt idx="371">
                  <c:v>379</c:v>
                </c:pt>
                <c:pt idx="372">
                  <c:v>378</c:v>
                </c:pt>
                <c:pt idx="373">
                  <c:v>377</c:v>
                </c:pt>
                <c:pt idx="374">
                  <c:v>376</c:v>
                </c:pt>
                <c:pt idx="375">
                  <c:v>375</c:v>
                </c:pt>
                <c:pt idx="376">
                  <c:v>374</c:v>
                </c:pt>
                <c:pt idx="377">
                  <c:v>373</c:v>
                </c:pt>
                <c:pt idx="378">
                  <c:v>372</c:v>
                </c:pt>
                <c:pt idx="379">
                  <c:v>371</c:v>
                </c:pt>
                <c:pt idx="380">
                  <c:v>370</c:v>
                </c:pt>
                <c:pt idx="381">
                  <c:v>369</c:v>
                </c:pt>
                <c:pt idx="382">
                  <c:v>368</c:v>
                </c:pt>
                <c:pt idx="383">
                  <c:v>367</c:v>
                </c:pt>
                <c:pt idx="384">
                  <c:v>366</c:v>
                </c:pt>
                <c:pt idx="385">
                  <c:v>365</c:v>
                </c:pt>
                <c:pt idx="386">
                  <c:v>364</c:v>
                </c:pt>
                <c:pt idx="387">
                  <c:v>363</c:v>
                </c:pt>
                <c:pt idx="388">
                  <c:v>362</c:v>
                </c:pt>
                <c:pt idx="389">
                  <c:v>361</c:v>
                </c:pt>
                <c:pt idx="390">
                  <c:v>360</c:v>
                </c:pt>
                <c:pt idx="391">
                  <c:v>359</c:v>
                </c:pt>
                <c:pt idx="392">
                  <c:v>358</c:v>
                </c:pt>
                <c:pt idx="393">
                  <c:v>357</c:v>
                </c:pt>
                <c:pt idx="394">
                  <c:v>356</c:v>
                </c:pt>
                <c:pt idx="395">
                  <c:v>355</c:v>
                </c:pt>
                <c:pt idx="396">
                  <c:v>354</c:v>
                </c:pt>
                <c:pt idx="397">
                  <c:v>353</c:v>
                </c:pt>
                <c:pt idx="398">
                  <c:v>352</c:v>
                </c:pt>
                <c:pt idx="399">
                  <c:v>351</c:v>
                </c:pt>
                <c:pt idx="400">
                  <c:v>350</c:v>
                </c:pt>
                <c:pt idx="401">
                  <c:v>349</c:v>
                </c:pt>
                <c:pt idx="402">
                  <c:v>348</c:v>
                </c:pt>
                <c:pt idx="403">
                  <c:v>347</c:v>
                </c:pt>
                <c:pt idx="404">
                  <c:v>346</c:v>
                </c:pt>
                <c:pt idx="405">
                  <c:v>345</c:v>
                </c:pt>
                <c:pt idx="406">
                  <c:v>344</c:v>
                </c:pt>
                <c:pt idx="407">
                  <c:v>343</c:v>
                </c:pt>
                <c:pt idx="408">
                  <c:v>342</c:v>
                </c:pt>
                <c:pt idx="409">
                  <c:v>341</c:v>
                </c:pt>
                <c:pt idx="410">
                  <c:v>340</c:v>
                </c:pt>
                <c:pt idx="411">
                  <c:v>339</c:v>
                </c:pt>
                <c:pt idx="412">
                  <c:v>338</c:v>
                </c:pt>
                <c:pt idx="413">
                  <c:v>337</c:v>
                </c:pt>
                <c:pt idx="414">
                  <c:v>336</c:v>
                </c:pt>
                <c:pt idx="415">
                  <c:v>335</c:v>
                </c:pt>
                <c:pt idx="416">
                  <c:v>334</c:v>
                </c:pt>
                <c:pt idx="417">
                  <c:v>333</c:v>
                </c:pt>
                <c:pt idx="418">
                  <c:v>332</c:v>
                </c:pt>
                <c:pt idx="419">
                  <c:v>331</c:v>
                </c:pt>
                <c:pt idx="420">
                  <c:v>330</c:v>
                </c:pt>
                <c:pt idx="421">
                  <c:v>329</c:v>
                </c:pt>
                <c:pt idx="422">
                  <c:v>328</c:v>
                </c:pt>
                <c:pt idx="423">
                  <c:v>327</c:v>
                </c:pt>
                <c:pt idx="424">
                  <c:v>326</c:v>
                </c:pt>
                <c:pt idx="425">
                  <c:v>325</c:v>
                </c:pt>
                <c:pt idx="426">
                  <c:v>324</c:v>
                </c:pt>
                <c:pt idx="427">
                  <c:v>323</c:v>
                </c:pt>
                <c:pt idx="428">
                  <c:v>322</c:v>
                </c:pt>
                <c:pt idx="429">
                  <c:v>321</c:v>
                </c:pt>
                <c:pt idx="430">
                  <c:v>320</c:v>
                </c:pt>
                <c:pt idx="431">
                  <c:v>319</c:v>
                </c:pt>
                <c:pt idx="432">
                  <c:v>318</c:v>
                </c:pt>
                <c:pt idx="433">
                  <c:v>317</c:v>
                </c:pt>
                <c:pt idx="434">
                  <c:v>316</c:v>
                </c:pt>
                <c:pt idx="435">
                  <c:v>315</c:v>
                </c:pt>
                <c:pt idx="436">
                  <c:v>314</c:v>
                </c:pt>
                <c:pt idx="437">
                  <c:v>313</c:v>
                </c:pt>
                <c:pt idx="438">
                  <c:v>312</c:v>
                </c:pt>
                <c:pt idx="439">
                  <c:v>311</c:v>
                </c:pt>
                <c:pt idx="440">
                  <c:v>310</c:v>
                </c:pt>
                <c:pt idx="441">
                  <c:v>309</c:v>
                </c:pt>
                <c:pt idx="442">
                  <c:v>308</c:v>
                </c:pt>
                <c:pt idx="443">
                  <c:v>307</c:v>
                </c:pt>
                <c:pt idx="444">
                  <c:v>306</c:v>
                </c:pt>
                <c:pt idx="445">
                  <c:v>305</c:v>
                </c:pt>
                <c:pt idx="446">
                  <c:v>304</c:v>
                </c:pt>
                <c:pt idx="447">
                  <c:v>303</c:v>
                </c:pt>
                <c:pt idx="448">
                  <c:v>302</c:v>
                </c:pt>
                <c:pt idx="449">
                  <c:v>301</c:v>
                </c:pt>
                <c:pt idx="450">
                  <c:v>300</c:v>
                </c:pt>
                <c:pt idx="451">
                  <c:v>299</c:v>
                </c:pt>
                <c:pt idx="452">
                  <c:v>298</c:v>
                </c:pt>
                <c:pt idx="453">
                  <c:v>297</c:v>
                </c:pt>
                <c:pt idx="454">
                  <c:v>296</c:v>
                </c:pt>
                <c:pt idx="455">
                  <c:v>295</c:v>
                </c:pt>
                <c:pt idx="456">
                  <c:v>294</c:v>
                </c:pt>
                <c:pt idx="457">
                  <c:v>293</c:v>
                </c:pt>
                <c:pt idx="458">
                  <c:v>292</c:v>
                </c:pt>
                <c:pt idx="459">
                  <c:v>291</c:v>
                </c:pt>
                <c:pt idx="460">
                  <c:v>290</c:v>
                </c:pt>
                <c:pt idx="461">
                  <c:v>289</c:v>
                </c:pt>
                <c:pt idx="462">
                  <c:v>288</c:v>
                </c:pt>
                <c:pt idx="463">
                  <c:v>287</c:v>
                </c:pt>
                <c:pt idx="464">
                  <c:v>286</c:v>
                </c:pt>
                <c:pt idx="465">
                  <c:v>285</c:v>
                </c:pt>
                <c:pt idx="466">
                  <c:v>284</c:v>
                </c:pt>
                <c:pt idx="467">
                  <c:v>283</c:v>
                </c:pt>
                <c:pt idx="468">
                  <c:v>282</c:v>
                </c:pt>
                <c:pt idx="469">
                  <c:v>281</c:v>
                </c:pt>
                <c:pt idx="470">
                  <c:v>280</c:v>
                </c:pt>
                <c:pt idx="471">
                  <c:v>279</c:v>
                </c:pt>
                <c:pt idx="472">
                  <c:v>278</c:v>
                </c:pt>
                <c:pt idx="473">
                  <c:v>277</c:v>
                </c:pt>
                <c:pt idx="474">
                  <c:v>276</c:v>
                </c:pt>
                <c:pt idx="475">
                  <c:v>275</c:v>
                </c:pt>
                <c:pt idx="476">
                  <c:v>274</c:v>
                </c:pt>
                <c:pt idx="477">
                  <c:v>273</c:v>
                </c:pt>
                <c:pt idx="478">
                  <c:v>272</c:v>
                </c:pt>
                <c:pt idx="479">
                  <c:v>271</c:v>
                </c:pt>
                <c:pt idx="480">
                  <c:v>270</c:v>
                </c:pt>
                <c:pt idx="481">
                  <c:v>269</c:v>
                </c:pt>
                <c:pt idx="482">
                  <c:v>268</c:v>
                </c:pt>
                <c:pt idx="483">
                  <c:v>267</c:v>
                </c:pt>
                <c:pt idx="484">
                  <c:v>266</c:v>
                </c:pt>
                <c:pt idx="485">
                  <c:v>265</c:v>
                </c:pt>
                <c:pt idx="486">
                  <c:v>264</c:v>
                </c:pt>
                <c:pt idx="487">
                  <c:v>263</c:v>
                </c:pt>
                <c:pt idx="488">
                  <c:v>262</c:v>
                </c:pt>
                <c:pt idx="489">
                  <c:v>261</c:v>
                </c:pt>
                <c:pt idx="490">
                  <c:v>260</c:v>
                </c:pt>
                <c:pt idx="491">
                  <c:v>259</c:v>
                </c:pt>
                <c:pt idx="492">
                  <c:v>258</c:v>
                </c:pt>
                <c:pt idx="493">
                  <c:v>257</c:v>
                </c:pt>
                <c:pt idx="494">
                  <c:v>256</c:v>
                </c:pt>
                <c:pt idx="495">
                  <c:v>255</c:v>
                </c:pt>
                <c:pt idx="496">
                  <c:v>254</c:v>
                </c:pt>
                <c:pt idx="497">
                  <c:v>253</c:v>
                </c:pt>
                <c:pt idx="498">
                  <c:v>252</c:v>
                </c:pt>
                <c:pt idx="499">
                  <c:v>251</c:v>
                </c:pt>
                <c:pt idx="500">
                  <c:v>250</c:v>
                </c:pt>
              </c:numCache>
            </c:numRef>
          </c:xVal>
          <c:yVal>
            <c:numRef>
              <c:f>'SPETTRI Sorgente-Filtri'!$F$2:$F$552</c:f>
              <c:numCache>
                <c:formatCode>General</c:formatCode>
                <c:ptCount val="551"/>
                <c:pt idx="0">
                  <c:v>0.47388561000000001</c:v>
                </c:pt>
                <c:pt idx="1">
                  <c:v>0.47282975999999999</c:v>
                </c:pt>
                <c:pt idx="2">
                  <c:v>0.47208956000000002</c:v>
                </c:pt>
                <c:pt idx="3">
                  <c:v>0.47111088000000001</c:v>
                </c:pt>
                <c:pt idx="4">
                  <c:v>0.47032409999999997</c:v>
                </c:pt>
                <c:pt idx="5">
                  <c:v>0.46976075</c:v>
                </c:pt>
                <c:pt idx="6">
                  <c:v>0.46937688999999999</c:v>
                </c:pt>
                <c:pt idx="7">
                  <c:v>0.46878636999999995</c:v>
                </c:pt>
                <c:pt idx="8">
                  <c:v>0.46839152000000001</c:v>
                </c:pt>
                <c:pt idx="9">
                  <c:v>0.46796643000000004</c:v>
                </c:pt>
                <c:pt idx="10">
                  <c:v>0.46728937000000004</c:v>
                </c:pt>
                <c:pt idx="11">
                  <c:v>0.46699026000000005</c:v>
                </c:pt>
                <c:pt idx="12">
                  <c:v>0.46643434</c:v>
                </c:pt>
                <c:pt idx="13">
                  <c:v>0.46600861000000005</c:v>
                </c:pt>
                <c:pt idx="14">
                  <c:v>0.46532288999999999</c:v>
                </c:pt>
                <c:pt idx="15">
                  <c:v>0.46491528999999998</c:v>
                </c:pt>
                <c:pt idx="16">
                  <c:v>0.46420855999999999</c:v>
                </c:pt>
                <c:pt idx="17">
                  <c:v>0.46357711000000001</c:v>
                </c:pt>
                <c:pt idx="18">
                  <c:v>0.46308055000000004</c:v>
                </c:pt>
                <c:pt idx="19">
                  <c:v>0.46249284000000002</c:v>
                </c:pt>
                <c:pt idx="20">
                  <c:v>0.46198134000000002</c:v>
                </c:pt>
                <c:pt idx="21">
                  <c:v>0.46157829</c:v>
                </c:pt>
                <c:pt idx="22">
                  <c:v>0.46148897</c:v>
                </c:pt>
                <c:pt idx="23">
                  <c:v>0.46107577</c:v>
                </c:pt>
                <c:pt idx="24">
                  <c:v>0.46105590999999996</c:v>
                </c:pt>
                <c:pt idx="25">
                  <c:v>0.46082399000000002</c:v>
                </c:pt>
                <c:pt idx="26">
                  <c:v>0.46062609999999998</c:v>
                </c:pt>
                <c:pt idx="27">
                  <c:v>0.46024686000000004</c:v>
                </c:pt>
                <c:pt idx="28">
                  <c:v>0.45996845999999997</c:v>
                </c:pt>
                <c:pt idx="29">
                  <c:v>0.45958114</c:v>
                </c:pt>
                <c:pt idx="30">
                  <c:v>0.45934752000000001</c:v>
                </c:pt>
                <c:pt idx="31">
                  <c:v>0.45880400999999998</c:v>
                </c:pt>
                <c:pt idx="32">
                  <c:v>0.45832098999999998</c:v>
                </c:pt>
                <c:pt idx="33">
                  <c:v>0.45777285999999995</c:v>
                </c:pt>
                <c:pt idx="34">
                  <c:v>0.45731279999999996</c:v>
                </c:pt>
                <c:pt idx="35">
                  <c:v>0.45680352999999996</c:v>
                </c:pt>
                <c:pt idx="36">
                  <c:v>0.45644402000000001</c:v>
                </c:pt>
                <c:pt idx="37">
                  <c:v>0.45600997999999998</c:v>
                </c:pt>
                <c:pt idx="38">
                  <c:v>0.45572527000000002</c:v>
                </c:pt>
                <c:pt idx="39">
                  <c:v>0.45553226000000002</c:v>
                </c:pt>
                <c:pt idx="40">
                  <c:v>0.45547483</c:v>
                </c:pt>
                <c:pt idx="41">
                  <c:v>0.45559471000000001</c:v>
                </c:pt>
                <c:pt idx="42">
                  <c:v>0.45543523999999996</c:v>
                </c:pt>
                <c:pt idx="43">
                  <c:v>0.45534193000000001</c:v>
                </c:pt>
                <c:pt idx="44">
                  <c:v>0.45501209000000004</c:v>
                </c:pt>
                <c:pt idx="45">
                  <c:v>0.45470761999999998</c:v>
                </c:pt>
                <c:pt idx="46">
                  <c:v>0.45430124999999999</c:v>
                </c:pt>
                <c:pt idx="47">
                  <c:v>0.45369213000000003</c:v>
                </c:pt>
                <c:pt idx="48">
                  <c:v>0.45310982000000005</c:v>
                </c:pt>
                <c:pt idx="49">
                  <c:v>0.45251505000000003</c:v>
                </c:pt>
                <c:pt idx="50">
                  <c:v>0.45212235999999995</c:v>
                </c:pt>
                <c:pt idx="51">
                  <c:v>0.45171500000000003</c:v>
                </c:pt>
                <c:pt idx="52">
                  <c:v>0.45134090999999998</c:v>
                </c:pt>
                <c:pt idx="53">
                  <c:v>0.45099614000000005</c:v>
                </c:pt>
                <c:pt idx="54">
                  <c:v>0.45075707000000004</c:v>
                </c:pt>
                <c:pt idx="55">
                  <c:v>0.45068077000000001</c:v>
                </c:pt>
                <c:pt idx="56">
                  <c:v>0.45074441999999998</c:v>
                </c:pt>
                <c:pt idx="57">
                  <c:v>0.45067065000000001</c:v>
                </c:pt>
                <c:pt idx="58">
                  <c:v>0.45054693000000001</c:v>
                </c:pt>
                <c:pt idx="59">
                  <c:v>0.45039253000000001</c:v>
                </c:pt>
                <c:pt idx="60">
                  <c:v>0.44997531000000002</c:v>
                </c:pt>
                <c:pt idx="61">
                  <c:v>0.44958334</c:v>
                </c:pt>
                <c:pt idx="62">
                  <c:v>0.44907688999999995</c:v>
                </c:pt>
                <c:pt idx="63">
                  <c:v>0.44851533999999998</c:v>
                </c:pt>
                <c:pt idx="64">
                  <c:v>0.44799447999999997</c:v>
                </c:pt>
                <c:pt idx="65">
                  <c:v>0.44740769000000002</c:v>
                </c:pt>
                <c:pt idx="66">
                  <c:v>0.44701222000000002</c:v>
                </c:pt>
                <c:pt idx="67">
                  <c:v>0.44674034000000001</c:v>
                </c:pt>
                <c:pt idx="68">
                  <c:v>0.44653017</c:v>
                </c:pt>
                <c:pt idx="69">
                  <c:v>0.44641635999999996</c:v>
                </c:pt>
                <c:pt idx="70">
                  <c:v>0.44633252000000001</c:v>
                </c:pt>
                <c:pt idx="71">
                  <c:v>0.44629648000000005</c:v>
                </c:pt>
                <c:pt idx="72">
                  <c:v>0.44624502999999999</c:v>
                </c:pt>
                <c:pt idx="73">
                  <c:v>0.44611150999999999</c:v>
                </c:pt>
                <c:pt idx="74">
                  <c:v>0.44578034999999999</c:v>
                </c:pt>
                <c:pt idx="75">
                  <c:v>0.44531846000000003</c:v>
                </c:pt>
                <c:pt idx="76">
                  <c:v>0.44484450000000003</c:v>
                </c:pt>
                <c:pt idx="77">
                  <c:v>0.44433960999999994</c:v>
                </c:pt>
                <c:pt idx="78">
                  <c:v>0.44383718</c:v>
                </c:pt>
                <c:pt idx="79">
                  <c:v>0.44332864</c:v>
                </c:pt>
                <c:pt idx="80">
                  <c:v>0.44289216000000003</c:v>
                </c:pt>
                <c:pt idx="81">
                  <c:v>0.44261662000000002</c:v>
                </c:pt>
                <c:pt idx="82">
                  <c:v>0.44240784</c:v>
                </c:pt>
                <c:pt idx="83">
                  <c:v>0.44238086000000004</c:v>
                </c:pt>
                <c:pt idx="84">
                  <c:v>0.44245773999999999</c:v>
                </c:pt>
                <c:pt idx="85">
                  <c:v>0.4424478</c:v>
                </c:pt>
                <c:pt idx="86">
                  <c:v>0.44229498</c:v>
                </c:pt>
                <c:pt idx="87">
                  <c:v>0.4419999</c:v>
                </c:pt>
                <c:pt idx="88">
                  <c:v>0.44171051</c:v>
                </c:pt>
                <c:pt idx="89">
                  <c:v>0.44140826999999999</c:v>
                </c:pt>
                <c:pt idx="90">
                  <c:v>0.44100347999999995</c:v>
                </c:pt>
                <c:pt idx="91">
                  <c:v>0.44049286000000004</c:v>
                </c:pt>
                <c:pt idx="92">
                  <c:v>0.43989530000000004</c:v>
                </c:pt>
                <c:pt idx="93">
                  <c:v>0.43947785000000006</c:v>
                </c:pt>
                <c:pt idx="94">
                  <c:v>0.43917985000000004</c:v>
                </c:pt>
                <c:pt idx="95">
                  <c:v>0.43879446999999999</c:v>
                </c:pt>
                <c:pt idx="96">
                  <c:v>0.43868785999999999</c:v>
                </c:pt>
                <c:pt idx="97">
                  <c:v>0.43881585000000001</c:v>
                </c:pt>
                <c:pt idx="98">
                  <c:v>0.43883771999999999</c:v>
                </c:pt>
                <c:pt idx="99">
                  <c:v>0.43874386999999998</c:v>
                </c:pt>
                <c:pt idx="100">
                  <c:v>0.43865211999999998</c:v>
                </c:pt>
                <c:pt idx="101">
                  <c:v>0.43857888</c:v>
                </c:pt>
                <c:pt idx="102">
                  <c:v>0.43821911000000002</c:v>
                </c:pt>
                <c:pt idx="103">
                  <c:v>0.43772979999999995</c:v>
                </c:pt>
                <c:pt idx="104">
                  <c:v>0.43721684999999999</c:v>
                </c:pt>
                <c:pt idx="105">
                  <c:v>0.43671883</c:v>
                </c:pt>
                <c:pt idx="106">
                  <c:v>0.43631396</c:v>
                </c:pt>
                <c:pt idx="107">
                  <c:v>0.43606256000000004</c:v>
                </c:pt>
                <c:pt idx="108">
                  <c:v>0.43602556999999997</c:v>
                </c:pt>
                <c:pt idx="109">
                  <c:v>0.43601898</c:v>
                </c:pt>
                <c:pt idx="110">
                  <c:v>0.43601073000000001</c:v>
                </c:pt>
                <c:pt idx="111">
                  <c:v>0.43603991999999997</c:v>
                </c:pt>
                <c:pt idx="112">
                  <c:v>0.43598838000000001</c:v>
                </c:pt>
                <c:pt idx="113">
                  <c:v>0.43589163999999997</c:v>
                </c:pt>
                <c:pt idx="114">
                  <c:v>0.43572426999999997</c:v>
                </c:pt>
                <c:pt idx="115">
                  <c:v>0.43535916999999996</c:v>
                </c:pt>
                <c:pt idx="116">
                  <c:v>0.43488058000000002</c:v>
                </c:pt>
                <c:pt idx="117">
                  <c:v>0.43443156999999999</c:v>
                </c:pt>
                <c:pt idx="118">
                  <c:v>0.43409827999999995</c:v>
                </c:pt>
                <c:pt idx="119">
                  <c:v>0.43393441999999999</c:v>
                </c:pt>
                <c:pt idx="120">
                  <c:v>0.43366197999999995</c:v>
                </c:pt>
                <c:pt idx="121">
                  <c:v>0.43360916000000005</c:v>
                </c:pt>
                <c:pt idx="122">
                  <c:v>0.43363430999999997</c:v>
                </c:pt>
                <c:pt idx="123">
                  <c:v>0.43371505999999999</c:v>
                </c:pt>
                <c:pt idx="124">
                  <c:v>0.43372435000000004</c:v>
                </c:pt>
                <c:pt idx="125">
                  <c:v>0.43373572000000005</c:v>
                </c:pt>
                <c:pt idx="126">
                  <c:v>0.43363855000000001</c:v>
                </c:pt>
                <c:pt idx="127">
                  <c:v>0.43346175000000003</c:v>
                </c:pt>
                <c:pt idx="128">
                  <c:v>0.43309597999999999</c:v>
                </c:pt>
                <c:pt idx="129">
                  <c:v>0.43264595</c:v>
                </c:pt>
                <c:pt idx="130">
                  <c:v>0.43247921</c:v>
                </c:pt>
                <c:pt idx="131">
                  <c:v>0.43221716999999998</c:v>
                </c:pt>
                <c:pt idx="132">
                  <c:v>0.43210599999999999</c:v>
                </c:pt>
                <c:pt idx="133">
                  <c:v>0.43213911999999999</c:v>
                </c:pt>
                <c:pt idx="134">
                  <c:v>0.43212313000000002</c:v>
                </c:pt>
                <c:pt idx="135">
                  <c:v>0.43221071</c:v>
                </c:pt>
                <c:pt idx="136">
                  <c:v>0.43220536000000004</c:v>
                </c:pt>
                <c:pt idx="137">
                  <c:v>0.43214183</c:v>
                </c:pt>
                <c:pt idx="138">
                  <c:v>0.43218601999999995</c:v>
                </c:pt>
                <c:pt idx="139">
                  <c:v>0.43193988999999999</c:v>
                </c:pt>
                <c:pt idx="140">
                  <c:v>0.43159047</c:v>
                </c:pt>
                <c:pt idx="141">
                  <c:v>0.43123072000000001</c:v>
                </c:pt>
                <c:pt idx="142">
                  <c:v>0.43106788000000001</c:v>
                </c:pt>
                <c:pt idx="143">
                  <c:v>0.43101979000000001</c:v>
                </c:pt>
                <c:pt idx="144">
                  <c:v>0.43088422000000004</c:v>
                </c:pt>
                <c:pt idx="145">
                  <c:v>0.43112444999999999</c:v>
                </c:pt>
                <c:pt idx="146">
                  <c:v>0.43117230000000001</c:v>
                </c:pt>
                <c:pt idx="147">
                  <c:v>0.43111550999999998</c:v>
                </c:pt>
                <c:pt idx="148">
                  <c:v>0.43098761000000002</c:v>
                </c:pt>
                <c:pt idx="149">
                  <c:v>0.43088523000000001</c:v>
                </c:pt>
                <c:pt idx="150">
                  <c:v>0.43092360999999996</c:v>
                </c:pt>
                <c:pt idx="151">
                  <c:v>0.43058601000000002</c:v>
                </c:pt>
                <c:pt idx="152">
                  <c:v>0.43057020000000001</c:v>
                </c:pt>
                <c:pt idx="153">
                  <c:v>0.43030170000000001</c:v>
                </c:pt>
                <c:pt idx="154">
                  <c:v>0.43021735</c:v>
                </c:pt>
                <c:pt idx="155">
                  <c:v>0.43042501999999999</c:v>
                </c:pt>
                <c:pt idx="156">
                  <c:v>0.43042451999999998</c:v>
                </c:pt>
                <c:pt idx="157">
                  <c:v>0.43061199999999999</c:v>
                </c:pt>
                <c:pt idx="158">
                  <c:v>0.43047539999999995</c:v>
                </c:pt>
                <c:pt idx="159">
                  <c:v>0.43049532000000001</c:v>
                </c:pt>
                <c:pt idx="160">
                  <c:v>0.43038277000000003</c:v>
                </c:pt>
                <c:pt idx="161">
                  <c:v>0.43014715000000003</c:v>
                </c:pt>
                <c:pt idx="162">
                  <c:v>0.43011295999999999</c:v>
                </c:pt>
                <c:pt idx="163">
                  <c:v>0.42977722000000002</c:v>
                </c:pt>
                <c:pt idx="164">
                  <c:v>0.42995890000000003</c:v>
                </c:pt>
                <c:pt idx="165">
                  <c:v>0.43002037999999998</c:v>
                </c:pt>
                <c:pt idx="166">
                  <c:v>0.429948</c:v>
                </c:pt>
                <c:pt idx="167">
                  <c:v>0.43006051999999995</c:v>
                </c:pt>
                <c:pt idx="168">
                  <c:v>0.43008640999999997</c:v>
                </c:pt>
                <c:pt idx="169">
                  <c:v>0.43008370000000001</c:v>
                </c:pt>
                <c:pt idx="170">
                  <c:v>0.42993085999999997</c:v>
                </c:pt>
                <c:pt idx="171">
                  <c:v>0.42989761999999998</c:v>
                </c:pt>
                <c:pt idx="172">
                  <c:v>0.42996877</c:v>
                </c:pt>
                <c:pt idx="173">
                  <c:v>0.42967942999999997</c:v>
                </c:pt>
                <c:pt idx="174">
                  <c:v>0.42975194</c:v>
                </c:pt>
                <c:pt idx="175">
                  <c:v>0.42971224999999996</c:v>
                </c:pt>
                <c:pt idx="176">
                  <c:v>0.42980129</c:v>
                </c:pt>
                <c:pt idx="177">
                  <c:v>0.42991039000000003</c:v>
                </c:pt>
                <c:pt idx="178">
                  <c:v>0.42991196000000004</c:v>
                </c:pt>
                <c:pt idx="179">
                  <c:v>0.43005954000000002</c:v>
                </c:pt>
                <c:pt idx="180">
                  <c:v>0.43009956999999999</c:v>
                </c:pt>
                <c:pt idx="181">
                  <c:v>0.42991914999999997</c:v>
                </c:pt>
                <c:pt idx="182">
                  <c:v>0.42990392999999999</c:v>
                </c:pt>
                <c:pt idx="183">
                  <c:v>0.42983263999999999</c:v>
                </c:pt>
                <c:pt idx="184">
                  <c:v>0.42991579000000002</c:v>
                </c:pt>
                <c:pt idx="185">
                  <c:v>0.42990901000000004</c:v>
                </c:pt>
                <c:pt idx="186">
                  <c:v>0.42994349999999998</c:v>
                </c:pt>
                <c:pt idx="187">
                  <c:v>0.43019716000000002</c:v>
                </c:pt>
                <c:pt idx="188">
                  <c:v>0.43021231999999998</c:v>
                </c:pt>
                <c:pt idx="189">
                  <c:v>0.43016872999999994</c:v>
                </c:pt>
                <c:pt idx="190">
                  <c:v>0.43023542999999997</c:v>
                </c:pt>
                <c:pt idx="191">
                  <c:v>0.43016703000000001</c:v>
                </c:pt>
                <c:pt idx="192">
                  <c:v>0.43012517</c:v>
                </c:pt>
                <c:pt idx="193">
                  <c:v>0.43017187000000001</c:v>
                </c:pt>
                <c:pt idx="194">
                  <c:v>0.4301663</c:v>
                </c:pt>
                <c:pt idx="195">
                  <c:v>0.43032438999999995</c:v>
                </c:pt>
                <c:pt idx="196">
                  <c:v>0.43041660999999998</c:v>
                </c:pt>
                <c:pt idx="197">
                  <c:v>0.43055405999999996</c:v>
                </c:pt>
                <c:pt idx="198">
                  <c:v>0.43051295000000001</c:v>
                </c:pt>
                <c:pt idx="199">
                  <c:v>0.43048288000000001</c:v>
                </c:pt>
                <c:pt idx="200">
                  <c:v>0.43048408999999999</c:v>
                </c:pt>
                <c:pt idx="201">
                  <c:v>0.43051796000000003</c:v>
                </c:pt>
                <c:pt idx="202">
                  <c:v>0.43066226999999996</c:v>
                </c:pt>
                <c:pt idx="203">
                  <c:v>0.43068018000000002</c:v>
                </c:pt>
                <c:pt idx="204">
                  <c:v>0.43083201000000004</c:v>
                </c:pt>
                <c:pt idx="205">
                  <c:v>0.43082687999999997</c:v>
                </c:pt>
                <c:pt idx="206">
                  <c:v>0.43077737999999999</c:v>
                </c:pt>
                <c:pt idx="207">
                  <c:v>0.43083547999999999</c:v>
                </c:pt>
                <c:pt idx="208">
                  <c:v>0.43084566000000002</c:v>
                </c:pt>
                <c:pt idx="209">
                  <c:v>0.43095515000000001</c:v>
                </c:pt>
                <c:pt idx="210">
                  <c:v>0.43098014000000001</c:v>
                </c:pt>
                <c:pt idx="211">
                  <c:v>0.43096467999999999</c:v>
                </c:pt>
                <c:pt idx="212">
                  <c:v>0.43106771999999999</c:v>
                </c:pt>
                <c:pt idx="213">
                  <c:v>0.43095588000000001</c:v>
                </c:pt>
                <c:pt idx="214">
                  <c:v>0.43099766</c:v>
                </c:pt>
                <c:pt idx="215">
                  <c:v>0.43097254999999995</c:v>
                </c:pt>
                <c:pt idx="216">
                  <c:v>0.43099344000000001</c:v>
                </c:pt>
                <c:pt idx="217">
                  <c:v>0.43102770000000001</c:v>
                </c:pt>
                <c:pt idx="218">
                  <c:v>0.43108187000000003</c:v>
                </c:pt>
                <c:pt idx="219">
                  <c:v>0.43116881999999995</c:v>
                </c:pt>
                <c:pt idx="220">
                  <c:v>0.43107858999999998</c:v>
                </c:pt>
                <c:pt idx="221">
                  <c:v>0.43103487000000001</c:v>
                </c:pt>
                <c:pt idx="222">
                  <c:v>0.43094568999999999</c:v>
                </c:pt>
                <c:pt idx="223">
                  <c:v>0.43085580000000001</c:v>
                </c:pt>
                <c:pt idx="224">
                  <c:v>0.43084881000000003</c:v>
                </c:pt>
                <c:pt idx="225">
                  <c:v>0.43085507000000001</c:v>
                </c:pt>
                <c:pt idx="226">
                  <c:v>0.43078080000000002</c:v>
                </c:pt>
                <c:pt idx="227">
                  <c:v>0.43075024000000001</c:v>
                </c:pt>
                <c:pt idx="228">
                  <c:v>0.43071178000000004</c:v>
                </c:pt>
                <c:pt idx="229">
                  <c:v>0.43062724000000002</c:v>
                </c:pt>
                <c:pt idx="230">
                  <c:v>0.43042216000000005</c:v>
                </c:pt>
                <c:pt idx="231">
                  <c:v>0.43035339</c:v>
                </c:pt>
                <c:pt idx="232">
                  <c:v>0.43034931999999998</c:v>
                </c:pt>
                <c:pt idx="233">
                  <c:v>0.43031433999999996</c:v>
                </c:pt>
                <c:pt idx="234">
                  <c:v>0.43017049000000002</c:v>
                </c:pt>
                <c:pt idx="235">
                  <c:v>0.42991120999999999</c:v>
                </c:pt>
                <c:pt idx="236">
                  <c:v>0.42959116999999997</c:v>
                </c:pt>
                <c:pt idx="237">
                  <c:v>0.42939269000000002</c:v>
                </c:pt>
                <c:pt idx="238">
                  <c:v>0.42940295999999994</c:v>
                </c:pt>
                <c:pt idx="239">
                  <c:v>0.42928735000000001</c:v>
                </c:pt>
                <c:pt idx="240">
                  <c:v>0.42915312999999999</c:v>
                </c:pt>
                <c:pt idx="241">
                  <c:v>0.42905431999999999</c:v>
                </c:pt>
                <c:pt idx="242">
                  <c:v>0.42884134000000002</c:v>
                </c:pt>
                <c:pt idx="243">
                  <c:v>0.42844068000000002</c:v>
                </c:pt>
                <c:pt idx="244">
                  <c:v>0.42789681000000002</c:v>
                </c:pt>
                <c:pt idx="245">
                  <c:v>0.42754311</c:v>
                </c:pt>
                <c:pt idx="246">
                  <c:v>0.42734655999999999</c:v>
                </c:pt>
                <c:pt idx="247">
                  <c:v>0.42715692</c:v>
                </c:pt>
                <c:pt idx="248">
                  <c:v>0.42693815000000002</c:v>
                </c:pt>
                <c:pt idx="249">
                  <c:v>0.42661918999999998</c:v>
                </c:pt>
                <c:pt idx="250">
                  <c:v>0.42617857999999997</c:v>
                </c:pt>
                <c:pt idx="251">
                  <c:v>0.42569574999999998</c:v>
                </c:pt>
                <c:pt idx="252">
                  <c:v>0.42524996000000004</c:v>
                </c:pt>
                <c:pt idx="253">
                  <c:v>0.42475878</c:v>
                </c:pt>
                <c:pt idx="254">
                  <c:v>0.42435490000000003</c:v>
                </c:pt>
                <c:pt idx="255">
                  <c:v>0.42407916999999995</c:v>
                </c:pt>
                <c:pt idx="256">
                  <c:v>0.42369900999999999</c:v>
                </c:pt>
                <c:pt idx="257">
                  <c:v>0.42322684999999999</c:v>
                </c:pt>
                <c:pt idx="258">
                  <c:v>0.42277334000000005</c:v>
                </c:pt>
                <c:pt idx="259">
                  <c:v>0.42232016999999999</c:v>
                </c:pt>
                <c:pt idx="260">
                  <c:v>0.42187693000000004</c:v>
                </c:pt>
                <c:pt idx="261">
                  <c:v>0.42139411999999998</c:v>
                </c:pt>
                <c:pt idx="262">
                  <c:v>0.42107821000000001</c:v>
                </c:pt>
                <c:pt idx="263">
                  <c:v>0.42070545000000004</c:v>
                </c:pt>
                <c:pt idx="264">
                  <c:v>0.42023817999999996</c:v>
                </c:pt>
                <c:pt idx="265">
                  <c:v>0.41980280000000003</c:v>
                </c:pt>
                <c:pt idx="266">
                  <c:v>0.41929263</c:v>
                </c:pt>
                <c:pt idx="267">
                  <c:v>0.41897965999999998</c:v>
                </c:pt>
                <c:pt idx="268">
                  <c:v>0.41879316000000005</c:v>
                </c:pt>
                <c:pt idx="269">
                  <c:v>0.41845274000000005</c:v>
                </c:pt>
                <c:pt idx="270">
                  <c:v>0.41794713999999999</c:v>
                </c:pt>
                <c:pt idx="271">
                  <c:v>0.41743353999999999</c:v>
                </c:pt>
                <c:pt idx="272">
                  <c:v>0.41703043000000001</c:v>
                </c:pt>
                <c:pt idx="273">
                  <c:v>0.41671965999999999</c:v>
                </c:pt>
                <c:pt idx="274">
                  <c:v>0.41646453</c:v>
                </c:pt>
                <c:pt idx="275">
                  <c:v>0.41615853000000003</c:v>
                </c:pt>
                <c:pt idx="276">
                  <c:v>0.41578902999999995</c:v>
                </c:pt>
                <c:pt idx="277">
                  <c:v>0.41540196000000001</c:v>
                </c:pt>
                <c:pt idx="278">
                  <c:v>0.41483555999999999</c:v>
                </c:pt>
                <c:pt idx="279">
                  <c:v>0.41441563000000003</c:v>
                </c:pt>
                <c:pt idx="280">
                  <c:v>0.41410355999999998</c:v>
                </c:pt>
                <c:pt idx="281">
                  <c:v>0.41378999</c:v>
                </c:pt>
                <c:pt idx="282">
                  <c:v>0.41343677999999995</c:v>
                </c:pt>
                <c:pt idx="283">
                  <c:v>0.41283828</c:v>
                </c:pt>
                <c:pt idx="284">
                  <c:v>0.41231810000000002</c:v>
                </c:pt>
                <c:pt idx="285">
                  <c:v>0.4118638</c:v>
                </c:pt>
                <c:pt idx="286">
                  <c:v>0.41155123999999998</c:v>
                </c:pt>
                <c:pt idx="287">
                  <c:v>0.41111401999999997</c:v>
                </c:pt>
                <c:pt idx="288">
                  <c:v>0.41065118</c:v>
                </c:pt>
                <c:pt idx="289">
                  <c:v>0.40999681999999998</c:v>
                </c:pt>
                <c:pt idx="290">
                  <c:v>0.40930926000000001</c:v>
                </c:pt>
                <c:pt idx="291">
                  <c:v>0.40884984000000002</c:v>
                </c:pt>
                <c:pt idx="292">
                  <c:v>0.40832923999999998</c:v>
                </c:pt>
                <c:pt idx="293">
                  <c:v>0.40777722999999999</c:v>
                </c:pt>
                <c:pt idx="294">
                  <c:v>0.40729915</c:v>
                </c:pt>
                <c:pt idx="295">
                  <c:v>0.40661695999999997</c:v>
                </c:pt>
                <c:pt idx="296">
                  <c:v>0.40607554999999995</c:v>
                </c:pt>
                <c:pt idx="297">
                  <c:v>0.40561951999999996</c:v>
                </c:pt>
                <c:pt idx="298">
                  <c:v>0.40504339</c:v>
                </c:pt>
                <c:pt idx="299">
                  <c:v>0.40436032</c:v>
                </c:pt>
                <c:pt idx="300">
                  <c:v>0.40373587</c:v>
                </c:pt>
                <c:pt idx="301">
                  <c:v>0.40315268999999998</c:v>
                </c:pt>
                <c:pt idx="302">
                  <c:v>0.40242552000000004</c:v>
                </c:pt>
                <c:pt idx="303">
                  <c:v>0.40167491</c:v>
                </c:pt>
                <c:pt idx="304">
                  <c:v>0.40101422999999997</c:v>
                </c:pt>
                <c:pt idx="305">
                  <c:v>0.40032665000000001</c:v>
                </c:pt>
                <c:pt idx="306">
                  <c:v>0.39960991000000001</c:v>
                </c:pt>
                <c:pt idx="307">
                  <c:v>0.39890149999999996</c:v>
                </c:pt>
                <c:pt idx="308">
                  <c:v>0.39816401999999995</c:v>
                </c:pt>
                <c:pt idx="309">
                  <c:v>0.39752814000000003</c:v>
                </c:pt>
                <c:pt idx="310">
                  <c:v>0.39666825999999999</c:v>
                </c:pt>
                <c:pt idx="311">
                  <c:v>0.39588856</c:v>
                </c:pt>
                <c:pt idx="312">
                  <c:v>0.39517712999999999</c:v>
                </c:pt>
                <c:pt idx="313">
                  <c:v>0.39464018000000001</c:v>
                </c:pt>
                <c:pt idx="314">
                  <c:v>0.39375773000000003</c:v>
                </c:pt>
                <c:pt idx="315">
                  <c:v>0.39273873999999998</c:v>
                </c:pt>
                <c:pt idx="316">
                  <c:v>0.39188039000000002</c:v>
                </c:pt>
                <c:pt idx="317">
                  <c:v>0.39091220999999998</c:v>
                </c:pt>
                <c:pt idx="318">
                  <c:v>0.38992381999999998</c:v>
                </c:pt>
                <c:pt idx="319">
                  <c:v>0.38902875000000003</c:v>
                </c:pt>
                <c:pt idx="320">
                  <c:v>0.38791353000000001</c:v>
                </c:pt>
                <c:pt idx="321">
                  <c:v>0.38677639999999996</c:v>
                </c:pt>
                <c:pt idx="322">
                  <c:v>0.38560148</c:v>
                </c:pt>
                <c:pt idx="323">
                  <c:v>0.38432479999999997</c:v>
                </c:pt>
                <c:pt idx="324">
                  <c:v>0.38290497000000001</c:v>
                </c:pt>
                <c:pt idx="325">
                  <c:v>0.38137293999999999</c:v>
                </c:pt>
                <c:pt idx="326">
                  <c:v>0.37972971</c:v>
                </c:pt>
                <c:pt idx="327">
                  <c:v>0.37801509000000005</c:v>
                </c:pt>
                <c:pt idx="328">
                  <c:v>0.37605196999999996</c:v>
                </c:pt>
                <c:pt idx="329">
                  <c:v>0.37383856000000004</c:v>
                </c:pt>
                <c:pt idx="330">
                  <c:v>0.37132295999999998</c:v>
                </c:pt>
                <c:pt idx="331">
                  <c:v>0.36853982000000002</c:v>
                </c:pt>
                <c:pt idx="332">
                  <c:v>0.36538761000000003</c:v>
                </c:pt>
                <c:pt idx="333">
                  <c:v>0.36214218999999997</c:v>
                </c:pt>
                <c:pt idx="334">
                  <c:v>0.35827367999999998</c:v>
                </c:pt>
                <c:pt idx="335">
                  <c:v>0.35399242000000003</c:v>
                </c:pt>
                <c:pt idx="336">
                  <c:v>0.34894336000000004</c:v>
                </c:pt>
                <c:pt idx="337">
                  <c:v>0.34347005000000003</c:v>
                </c:pt>
                <c:pt idx="338">
                  <c:v>0.33726638999999997</c:v>
                </c:pt>
                <c:pt idx="339">
                  <c:v>0.33016230999999996</c:v>
                </c:pt>
                <c:pt idx="340">
                  <c:v>0.32222307</c:v>
                </c:pt>
                <c:pt idx="341">
                  <c:v>0.31316708999999998</c:v>
                </c:pt>
                <c:pt idx="342">
                  <c:v>0.30340855999999999</c:v>
                </c:pt>
                <c:pt idx="343">
                  <c:v>0.29230266999999999</c:v>
                </c:pt>
                <c:pt idx="344">
                  <c:v>0.27995945</c:v>
                </c:pt>
                <c:pt idx="345">
                  <c:v>0.26664727999999999</c:v>
                </c:pt>
                <c:pt idx="346">
                  <c:v>0.25211383999999998</c:v>
                </c:pt>
                <c:pt idx="347">
                  <c:v>0.23647572</c:v>
                </c:pt>
                <c:pt idx="348">
                  <c:v>0.21974378000000003</c:v>
                </c:pt>
                <c:pt idx="349">
                  <c:v>0.20231012000000001</c:v>
                </c:pt>
                <c:pt idx="350">
                  <c:v>0.1835936</c:v>
                </c:pt>
                <c:pt idx="351">
                  <c:v>0.16443792999999998</c:v>
                </c:pt>
                <c:pt idx="352">
                  <c:v>0.14517152999999999</c:v>
                </c:pt>
                <c:pt idx="353">
                  <c:v>0.1259208</c:v>
                </c:pt>
                <c:pt idx="354">
                  <c:v>0.10720792</c:v>
                </c:pt>
                <c:pt idx="355">
                  <c:v>8.9570650000000002E-2</c:v>
                </c:pt>
                <c:pt idx="356">
                  <c:v>7.2961280000000003E-2</c:v>
                </c:pt>
                <c:pt idx="357">
                  <c:v>5.7774900000000004E-2</c:v>
                </c:pt>
                <c:pt idx="358">
                  <c:v>4.422632E-2</c:v>
                </c:pt>
                <c:pt idx="359">
                  <c:v>3.2416839999999995E-2</c:v>
                </c:pt>
                <c:pt idx="360">
                  <c:v>2.2388129999999999E-2</c:v>
                </c:pt>
                <c:pt idx="361">
                  <c:v>1.4305749999999999E-2</c:v>
                </c:pt>
                <c:pt idx="362">
                  <c:v>7.8525499999999998E-3</c:v>
                </c:pt>
                <c:pt idx="363">
                  <c:v>2.8614299999999999E-3</c:v>
                </c:pt>
                <c:pt idx="364">
                  <c:v>-8.0553999999999999E-4</c:v>
                </c:pt>
                <c:pt idx="365">
                  <c:v>-3.48505E-3</c:v>
                </c:pt>
                <c:pt idx="366">
                  <c:v>-5.3354900000000009E-3</c:v>
                </c:pt>
                <c:pt idx="367">
                  <c:v>-6.5459900000000007E-3</c:v>
                </c:pt>
                <c:pt idx="368">
                  <c:v>-7.4142300000000008E-3</c:v>
                </c:pt>
                <c:pt idx="369">
                  <c:v>-7.9469699999999994E-3</c:v>
                </c:pt>
                <c:pt idx="370">
                  <c:v>-8.2939899999999993E-3</c:v>
                </c:pt>
                <c:pt idx="371">
                  <c:v>-8.4787500000000002E-3</c:v>
                </c:pt>
                <c:pt idx="372">
                  <c:v>-8.5927799999999995E-3</c:v>
                </c:pt>
                <c:pt idx="373">
                  <c:v>-8.7018900000000003E-3</c:v>
                </c:pt>
                <c:pt idx="374">
                  <c:v>-8.7477300000000004E-3</c:v>
                </c:pt>
                <c:pt idx="375">
                  <c:v>-8.7437299999999999E-3</c:v>
                </c:pt>
                <c:pt idx="376">
                  <c:v>-8.7892999999999999E-3</c:v>
                </c:pt>
                <c:pt idx="377">
                  <c:v>-8.77059E-3</c:v>
                </c:pt>
                <c:pt idx="378">
                  <c:v>-8.7803499999999993E-3</c:v>
                </c:pt>
                <c:pt idx="379">
                  <c:v>-8.7863699999999999E-3</c:v>
                </c:pt>
                <c:pt idx="380">
                  <c:v>-8.7732799999999996E-3</c:v>
                </c:pt>
                <c:pt idx="381">
                  <c:v>-8.7592599999999996E-3</c:v>
                </c:pt>
                <c:pt idx="382">
                  <c:v>-8.7351800000000004E-3</c:v>
                </c:pt>
                <c:pt idx="383">
                  <c:v>-8.7630699999999995E-3</c:v>
                </c:pt>
                <c:pt idx="384">
                  <c:v>-8.7751199999999991E-3</c:v>
                </c:pt>
                <c:pt idx="385">
                  <c:v>-8.8056300000000001E-3</c:v>
                </c:pt>
                <c:pt idx="386">
                  <c:v>-8.7744199999999998E-3</c:v>
                </c:pt>
                <c:pt idx="387">
                  <c:v>-8.752600000000001E-3</c:v>
                </c:pt>
                <c:pt idx="388">
                  <c:v>-8.7761999999999996E-3</c:v>
                </c:pt>
                <c:pt idx="389">
                  <c:v>-8.7688100000000001E-3</c:v>
                </c:pt>
                <c:pt idx="390">
                  <c:v>-8.7813600000000002E-3</c:v>
                </c:pt>
                <c:pt idx="391">
                  <c:v>-8.7853199999999992E-3</c:v>
                </c:pt>
                <c:pt idx="392">
                  <c:v>-8.7751100000000009E-3</c:v>
                </c:pt>
                <c:pt idx="393">
                  <c:v>-8.7555700000000007E-3</c:v>
                </c:pt>
                <c:pt idx="394">
                  <c:v>-8.75218E-3</c:v>
                </c:pt>
                <c:pt idx="395">
                  <c:v>-8.7580399999999999E-3</c:v>
                </c:pt>
                <c:pt idx="396">
                  <c:v>-8.7757800000000004E-3</c:v>
                </c:pt>
                <c:pt idx="397">
                  <c:v>-8.7811499999999997E-3</c:v>
                </c:pt>
                <c:pt idx="398">
                  <c:v>-8.767829999999999E-3</c:v>
                </c:pt>
                <c:pt idx="399">
                  <c:v>-8.7608800000000004E-3</c:v>
                </c:pt>
                <c:pt idx="400">
                  <c:v>-8.7560299999999997E-3</c:v>
                </c:pt>
                <c:pt idx="401">
                  <c:v>-8.7563199999999997E-3</c:v>
                </c:pt>
                <c:pt idx="402">
                  <c:v>-8.7635200000000003E-3</c:v>
                </c:pt>
                <c:pt idx="403">
                  <c:v>-8.7617500000000004E-3</c:v>
                </c:pt>
                <c:pt idx="404">
                  <c:v>-8.7860200000000003E-3</c:v>
                </c:pt>
                <c:pt idx="405">
                  <c:v>-8.7776199999999999E-3</c:v>
                </c:pt>
                <c:pt idx="406">
                  <c:v>-8.7624899999999995E-3</c:v>
                </c:pt>
                <c:pt idx="407">
                  <c:v>-8.7695399999999993E-3</c:v>
                </c:pt>
                <c:pt idx="408">
                  <c:v>-8.7571200000000002E-3</c:v>
                </c:pt>
                <c:pt idx="409">
                  <c:v>-8.7591700000000002E-3</c:v>
                </c:pt>
                <c:pt idx="410">
                  <c:v>-8.7713300000000008E-3</c:v>
                </c:pt>
                <c:pt idx="411">
                  <c:v>-8.7835399999999994E-3</c:v>
                </c:pt>
                <c:pt idx="412">
                  <c:v>-8.79805E-3</c:v>
                </c:pt>
                <c:pt idx="413">
                  <c:v>-8.7797699999999992E-3</c:v>
                </c:pt>
                <c:pt idx="414">
                  <c:v>-8.7834699999999998E-3</c:v>
                </c:pt>
                <c:pt idx="415">
                  <c:v>-8.7813700000000001E-3</c:v>
                </c:pt>
                <c:pt idx="416">
                  <c:v>-8.7942000000000003E-3</c:v>
                </c:pt>
                <c:pt idx="417">
                  <c:v>-8.7890299999999998E-3</c:v>
                </c:pt>
                <c:pt idx="418">
                  <c:v>-8.7992799999999996E-3</c:v>
                </c:pt>
                <c:pt idx="419">
                  <c:v>-8.8026800000000002E-3</c:v>
                </c:pt>
                <c:pt idx="420">
                  <c:v>-8.7578399999999994E-3</c:v>
                </c:pt>
                <c:pt idx="421">
                  <c:v>-8.7789200000000008E-3</c:v>
                </c:pt>
                <c:pt idx="422">
                  <c:v>-8.8153199999999998E-3</c:v>
                </c:pt>
                <c:pt idx="423">
                  <c:v>-8.8020500000000005E-3</c:v>
                </c:pt>
                <c:pt idx="424">
                  <c:v>-8.8119199999999991E-3</c:v>
                </c:pt>
                <c:pt idx="425">
                  <c:v>-8.8241800000000009E-3</c:v>
                </c:pt>
                <c:pt idx="426">
                  <c:v>-8.801670000000001E-3</c:v>
                </c:pt>
                <c:pt idx="427">
                  <c:v>-8.7717400000000001E-3</c:v>
                </c:pt>
                <c:pt idx="428">
                  <c:v>-8.7907699999999998E-3</c:v>
                </c:pt>
                <c:pt idx="429">
                  <c:v>-8.795589999999999E-3</c:v>
                </c:pt>
                <c:pt idx="430">
                  <c:v>-8.7945200000000001E-3</c:v>
                </c:pt>
                <c:pt idx="431">
                  <c:v>-8.8149500000000002E-3</c:v>
                </c:pt>
                <c:pt idx="432">
                  <c:v>-8.7828899999999998E-3</c:v>
                </c:pt>
                <c:pt idx="433">
                  <c:v>-8.7697899999999995E-3</c:v>
                </c:pt>
                <c:pt idx="434">
                  <c:v>-8.7764899999999996E-3</c:v>
                </c:pt>
                <c:pt idx="435">
                  <c:v>-8.7569499999999995E-3</c:v>
                </c:pt>
                <c:pt idx="436">
                  <c:v>-8.7867899999999992E-3</c:v>
                </c:pt>
                <c:pt idx="437">
                  <c:v>-8.7829599999999994E-3</c:v>
                </c:pt>
                <c:pt idx="438">
                  <c:v>-8.7900599999999988E-3</c:v>
                </c:pt>
                <c:pt idx="439">
                  <c:v>-8.7688699999999998E-3</c:v>
                </c:pt>
                <c:pt idx="440">
                  <c:v>-8.7521200000000004E-3</c:v>
                </c:pt>
                <c:pt idx="441">
                  <c:v>-8.7786900000000005E-3</c:v>
                </c:pt>
                <c:pt idx="442">
                  <c:v>-8.7687300000000006E-3</c:v>
                </c:pt>
                <c:pt idx="443">
                  <c:v>-8.7887099999999999E-3</c:v>
                </c:pt>
                <c:pt idx="444">
                  <c:v>-8.7915900000000002E-3</c:v>
                </c:pt>
                <c:pt idx="445">
                  <c:v>-8.7904799999999998E-3</c:v>
                </c:pt>
                <c:pt idx="446">
                  <c:v>-8.81236E-3</c:v>
                </c:pt>
                <c:pt idx="447">
                  <c:v>-8.7457899999999998E-3</c:v>
                </c:pt>
                <c:pt idx="448">
                  <c:v>-8.7687499999999988E-3</c:v>
                </c:pt>
                <c:pt idx="449">
                  <c:v>-8.7384899999999998E-3</c:v>
                </c:pt>
                <c:pt idx="450">
                  <c:v>-8.7723899999999997E-3</c:v>
                </c:pt>
                <c:pt idx="451">
                  <c:v>-8.8235899999999992E-3</c:v>
                </c:pt>
                <c:pt idx="452">
                  <c:v>-8.7718599999999994E-3</c:v>
                </c:pt>
                <c:pt idx="453">
                  <c:v>-8.8141199999999999E-3</c:v>
                </c:pt>
                <c:pt idx="454">
                  <c:v>-8.7882000000000012E-3</c:v>
                </c:pt>
                <c:pt idx="455">
                  <c:v>-8.7960899999999995E-3</c:v>
                </c:pt>
                <c:pt idx="456">
                  <c:v>-8.8365900000000001E-3</c:v>
                </c:pt>
                <c:pt idx="457">
                  <c:v>-8.7806600000000009E-3</c:v>
                </c:pt>
                <c:pt idx="458">
                  <c:v>-8.8152200000000003E-3</c:v>
                </c:pt>
                <c:pt idx="459">
                  <c:v>-8.7810700000000002E-3</c:v>
                </c:pt>
                <c:pt idx="460">
                  <c:v>-8.7959600000000002E-3</c:v>
                </c:pt>
                <c:pt idx="461">
                  <c:v>-8.8372700000000012E-3</c:v>
                </c:pt>
                <c:pt idx="462">
                  <c:v>-8.7971899999999999E-3</c:v>
                </c:pt>
                <c:pt idx="463">
                  <c:v>-8.82726E-3</c:v>
                </c:pt>
                <c:pt idx="464">
                  <c:v>-8.8314800000000009E-3</c:v>
                </c:pt>
                <c:pt idx="465">
                  <c:v>-8.8358099999999995E-3</c:v>
                </c:pt>
                <c:pt idx="466">
                  <c:v>-8.817160000000001E-3</c:v>
                </c:pt>
                <c:pt idx="467">
                  <c:v>-8.7732799999999996E-3</c:v>
                </c:pt>
                <c:pt idx="468">
                  <c:v>-8.8204500000000005E-3</c:v>
                </c:pt>
                <c:pt idx="469">
                  <c:v>-8.7484599999999996E-3</c:v>
                </c:pt>
                <c:pt idx="470">
                  <c:v>-8.7917199999999994E-3</c:v>
                </c:pt>
                <c:pt idx="471">
                  <c:v>-8.8100899999999996E-3</c:v>
                </c:pt>
                <c:pt idx="472">
                  <c:v>-8.8088999999999997E-3</c:v>
                </c:pt>
                <c:pt idx="473">
                  <c:v>-8.8405100000000011E-3</c:v>
                </c:pt>
                <c:pt idx="474">
                  <c:v>-8.7680399999999995E-3</c:v>
                </c:pt>
                <c:pt idx="475">
                  <c:v>-8.8142399999999992E-3</c:v>
                </c:pt>
                <c:pt idx="476">
                  <c:v>-8.7655099999999989E-3</c:v>
                </c:pt>
                <c:pt idx="477">
                  <c:v>-8.7870299999999995E-3</c:v>
                </c:pt>
                <c:pt idx="478">
                  <c:v>-8.8559499999999996E-3</c:v>
                </c:pt>
                <c:pt idx="479">
                  <c:v>-8.8001799999999995E-3</c:v>
                </c:pt>
                <c:pt idx="480">
                  <c:v>-8.8545900000000007E-3</c:v>
                </c:pt>
                <c:pt idx="481">
                  <c:v>-8.8018999999999997E-3</c:v>
                </c:pt>
                <c:pt idx="482">
                  <c:v>-8.8044500000000001E-3</c:v>
                </c:pt>
                <c:pt idx="483">
                  <c:v>-8.8234300000000002E-3</c:v>
                </c:pt>
                <c:pt idx="484">
                  <c:v>-8.7691899999999996E-3</c:v>
                </c:pt>
                <c:pt idx="485">
                  <c:v>-8.8420400000000007E-3</c:v>
                </c:pt>
                <c:pt idx="486">
                  <c:v>-8.8060199999999995E-3</c:v>
                </c:pt>
                <c:pt idx="487">
                  <c:v>-8.7995399999999998E-3</c:v>
                </c:pt>
                <c:pt idx="488">
                  <c:v>-8.8418300000000002E-3</c:v>
                </c:pt>
                <c:pt idx="489">
                  <c:v>-8.8167300000000001E-3</c:v>
                </c:pt>
                <c:pt idx="490">
                  <c:v>-8.8509999999999995E-3</c:v>
                </c:pt>
                <c:pt idx="491">
                  <c:v>-8.8064200000000006E-3</c:v>
                </c:pt>
                <c:pt idx="492">
                  <c:v>-8.8152400000000002E-3</c:v>
                </c:pt>
                <c:pt idx="493">
                  <c:v>-8.8367099999999994E-3</c:v>
                </c:pt>
                <c:pt idx="494">
                  <c:v>-8.7931399999999996E-3</c:v>
                </c:pt>
                <c:pt idx="495">
                  <c:v>-8.8173699999999997E-3</c:v>
                </c:pt>
                <c:pt idx="496">
                  <c:v>-8.7939000000000003E-3</c:v>
                </c:pt>
                <c:pt idx="497">
                  <c:v>-8.8498900000000009E-3</c:v>
                </c:pt>
                <c:pt idx="498">
                  <c:v>-8.8634999999999999E-3</c:v>
                </c:pt>
                <c:pt idx="499">
                  <c:v>-8.8354999999999996E-3</c:v>
                </c:pt>
                <c:pt idx="500">
                  <c:v>-8.8930499999999996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1B0-420F-A730-A5A6354D5ECD}"/>
            </c:ext>
          </c:extLst>
        </c:ser>
        <c:ser>
          <c:idx val="1"/>
          <c:order val="1"/>
          <c:tx>
            <c:strRef>
              <c:f>'SPETTRI Sorgente-Filtri'!$C$1</c:f>
              <c:strCache>
                <c:ptCount val="1"/>
                <c:pt idx="0">
                  <c:v>Blue Filter</c:v>
                </c:pt>
              </c:strCache>
            </c:strRef>
          </c:tx>
          <c:spPr>
            <a:ln w="2540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'SPETTRI Sorgente-Filtri'!$A$2:$A$552</c:f>
              <c:numCache>
                <c:formatCode>General</c:formatCode>
                <c:ptCount val="551"/>
                <c:pt idx="0">
                  <c:v>750</c:v>
                </c:pt>
                <c:pt idx="1">
                  <c:v>749</c:v>
                </c:pt>
                <c:pt idx="2">
                  <c:v>748</c:v>
                </c:pt>
                <c:pt idx="3">
                  <c:v>747</c:v>
                </c:pt>
                <c:pt idx="4">
                  <c:v>746</c:v>
                </c:pt>
                <c:pt idx="5">
                  <c:v>745</c:v>
                </c:pt>
                <c:pt idx="6">
                  <c:v>744</c:v>
                </c:pt>
                <c:pt idx="7">
                  <c:v>743</c:v>
                </c:pt>
                <c:pt idx="8">
                  <c:v>742</c:v>
                </c:pt>
                <c:pt idx="9">
                  <c:v>741</c:v>
                </c:pt>
                <c:pt idx="10">
                  <c:v>740</c:v>
                </c:pt>
                <c:pt idx="11">
                  <c:v>739</c:v>
                </c:pt>
                <c:pt idx="12">
                  <c:v>738</c:v>
                </c:pt>
                <c:pt idx="13">
                  <c:v>737</c:v>
                </c:pt>
                <c:pt idx="14">
                  <c:v>736</c:v>
                </c:pt>
                <c:pt idx="15">
                  <c:v>735</c:v>
                </c:pt>
                <c:pt idx="16">
                  <c:v>734</c:v>
                </c:pt>
                <c:pt idx="17">
                  <c:v>733</c:v>
                </c:pt>
                <c:pt idx="18">
                  <c:v>732</c:v>
                </c:pt>
                <c:pt idx="19">
                  <c:v>731</c:v>
                </c:pt>
                <c:pt idx="20">
                  <c:v>730</c:v>
                </c:pt>
                <c:pt idx="21">
                  <c:v>729</c:v>
                </c:pt>
                <c:pt idx="22">
                  <c:v>728</c:v>
                </c:pt>
                <c:pt idx="23">
                  <c:v>727</c:v>
                </c:pt>
                <c:pt idx="24">
                  <c:v>726</c:v>
                </c:pt>
                <c:pt idx="25">
                  <c:v>725</c:v>
                </c:pt>
                <c:pt idx="26">
                  <c:v>724</c:v>
                </c:pt>
                <c:pt idx="27">
                  <c:v>723</c:v>
                </c:pt>
                <c:pt idx="28">
                  <c:v>722</c:v>
                </c:pt>
                <c:pt idx="29">
                  <c:v>721</c:v>
                </c:pt>
                <c:pt idx="30">
                  <c:v>720</c:v>
                </c:pt>
                <c:pt idx="31">
                  <c:v>719</c:v>
                </c:pt>
                <c:pt idx="32">
                  <c:v>718</c:v>
                </c:pt>
                <c:pt idx="33">
                  <c:v>717</c:v>
                </c:pt>
                <c:pt idx="34">
                  <c:v>716</c:v>
                </c:pt>
                <c:pt idx="35">
                  <c:v>715</c:v>
                </c:pt>
                <c:pt idx="36">
                  <c:v>714</c:v>
                </c:pt>
                <c:pt idx="37">
                  <c:v>713</c:v>
                </c:pt>
                <c:pt idx="38">
                  <c:v>712</c:v>
                </c:pt>
                <c:pt idx="39">
                  <c:v>711</c:v>
                </c:pt>
                <c:pt idx="40">
                  <c:v>710</c:v>
                </c:pt>
                <c:pt idx="41">
                  <c:v>709</c:v>
                </c:pt>
                <c:pt idx="42">
                  <c:v>708</c:v>
                </c:pt>
                <c:pt idx="43">
                  <c:v>707</c:v>
                </c:pt>
                <c:pt idx="44">
                  <c:v>706</c:v>
                </c:pt>
                <c:pt idx="45">
                  <c:v>705</c:v>
                </c:pt>
                <c:pt idx="46">
                  <c:v>704</c:v>
                </c:pt>
                <c:pt idx="47">
                  <c:v>703</c:v>
                </c:pt>
                <c:pt idx="48">
                  <c:v>702</c:v>
                </c:pt>
                <c:pt idx="49">
                  <c:v>701</c:v>
                </c:pt>
                <c:pt idx="50">
                  <c:v>700</c:v>
                </c:pt>
                <c:pt idx="51">
                  <c:v>699</c:v>
                </c:pt>
                <c:pt idx="52">
                  <c:v>698</c:v>
                </c:pt>
                <c:pt idx="53">
                  <c:v>697</c:v>
                </c:pt>
                <c:pt idx="54">
                  <c:v>696</c:v>
                </c:pt>
                <c:pt idx="55">
                  <c:v>695</c:v>
                </c:pt>
                <c:pt idx="56">
                  <c:v>694</c:v>
                </c:pt>
                <c:pt idx="57">
                  <c:v>693</c:v>
                </c:pt>
                <c:pt idx="58">
                  <c:v>692</c:v>
                </c:pt>
                <c:pt idx="59">
                  <c:v>691</c:v>
                </c:pt>
                <c:pt idx="60">
                  <c:v>690</c:v>
                </c:pt>
                <c:pt idx="61">
                  <c:v>689</c:v>
                </c:pt>
                <c:pt idx="62">
                  <c:v>688</c:v>
                </c:pt>
                <c:pt idx="63">
                  <c:v>687</c:v>
                </c:pt>
                <c:pt idx="64">
                  <c:v>686</c:v>
                </c:pt>
                <c:pt idx="65">
                  <c:v>685</c:v>
                </c:pt>
                <c:pt idx="66">
                  <c:v>684</c:v>
                </c:pt>
                <c:pt idx="67">
                  <c:v>683</c:v>
                </c:pt>
                <c:pt idx="68">
                  <c:v>682</c:v>
                </c:pt>
                <c:pt idx="69">
                  <c:v>681</c:v>
                </c:pt>
                <c:pt idx="70">
                  <c:v>680</c:v>
                </c:pt>
                <c:pt idx="71">
                  <c:v>679</c:v>
                </c:pt>
                <c:pt idx="72">
                  <c:v>678</c:v>
                </c:pt>
                <c:pt idx="73">
                  <c:v>677</c:v>
                </c:pt>
                <c:pt idx="74">
                  <c:v>676</c:v>
                </c:pt>
                <c:pt idx="75">
                  <c:v>675</c:v>
                </c:pt>
                <c:pt idx="76">
                  <c:v>674</c:v>
                </c:pt>
                <c:pt idx="77">
                  <c:v>673</c:v>
                </c:pt>
                <c:pt idx="78">
                  <c:v>672</c:v>
                </c:pt>
                <c:pt idx="79">
                  <c:v>671</c:v>
                </c:pt>
                <c:pt idx="80">
                  <c:v>670</c:v>
                </c:pt>
                <c:pt idx="81">
                  <c:v>669</c:v>
                </c:pt>
                <c:pt idx="82">
                  <c:v>668</c:v>
                </c:pt>
                <c:pt idx="83">
                  <c:v>667</c:v>
                </c:pt>
                <c:pt idx="84">
                  <c:v>666</c:v>
                </c:pt>
                <c:pt idx="85">
                  <c:v>665</c:v>
                </c:pt>
                <c:pt idx="86">
                  <c:v>664</c:v>
                </c:pt>
                <c:pt idx="87">
                  <c:v>663</c:v>
                </c:pt>
                <c:pt idx="88">
                  <c:v>662</c:v>
                </c:pt>
                <c:pt idx="89">
                  <c:v>661</c:v>
                </c:pt>
                <c:pt idx="90">
                  <c:v>660</c:v>
                </c:pt>
                <c:pt idx="91">
                  <c:v>659</c:v>
                </c:pt>
                <c:pt idx="92">
                  <c:v>658</c:v>
                </c:pt>
                <c:pt idx="93">
                  <c:v>657</c:v>
                </c:pt>
                <c:pt idx="94">
                  <c:v>656</c:v>
                </c:pt>
                <c:pt idx="95">
                  <c:v>655</c:v>
                </c:pt>
                <c:pt idx="96">
                  <c:v>654</c:v>
                </c:pt>
                <c:pt idx="97">
                  <c:v>653</c:v>
                </c:pt>
                <c:pt idx="98">
                  <c:v>652</c:v>
                </c:pt>
                <c:pt idx="99">
                  <c:v>651</c:v>
                </c:pt>
                <c:pt idx="100">
                  <c:v>650</c:v>
                </c:pt>
                <c:pt idx="101">
                  <c:v>649</c:v>
                </c:pt>
                <c:pt idx="102">
                  <c:v>648</c:v>
                </c:pt>
                <c:pt idx="103">
                  <c:v>647</c:v>
                </c:pt>
                <c:pt idx="104">
                  <c:v>646</c:v>
                </c:pt>
                <c:pt idx="105">
                  <c:v>645</c:v>
                </c:pt>
                <c:pt idx="106">
                  <c:v>644</c:v>
                </c:pt>
                <c:pt idx="107">
                  <c:v>643</c:v>
                </c:pt>
                <c:pt idx="108">
                  <c:v>642</c:v>
                </c:pt>
                <c:pt idx="109">
                  <c:v>641</c:v>
                </c:pt>
                <c:pt idx="110">
                  <c:v>640</c:v>
                </c:pt>
                <c:pt idx="111">
                  <c:v>639</c:v>
                </c:pt>
                <c:pt idx="112">
                  <c:v>638</c:v>
                </c:pt>
                <c:pt idx="113">
                  <c:v>637</c:v>
                </c:pt>
                <c:pt idx="114">
                  <c:v>636</c:v>
                </c:pt>
                <c:pt idx="115">
                  <c:v>635</c:v>
                </c:pt>
                <c:pt idx="116">
                  <c:v>634</c:v>
                </c:pt>
                <c:pt idx="117">
                  <c:v>633</c:v>
                </c:pt>
                <c:pt idx="118">
                  <c:v>632</c:v>
                </c:pt>
                <c:pt idx="119">
                  <c:v>631</c:v>
                </c:pt>
                <c:pt idx="120">
                  <c:v>630</c:v>
                </c:pt>
                <c:pt idx="121">
                  <c:v>629</c:v>
                </c:pt>
                <c:pt idx="122">
                  <c:v>628</c:v>
                </c:pt>
                <c:pt idx="123">
                  <c:v>627</c:v>
                </c:pt>
                <c:pt idx="124">
                  <c:v>626</c:v>
                </c:pt>
                <c:pt idx="125">
                  <c:v>625</c:v>
                </c:pt>
                <c:pt idx="126">
                  <c:v>624</c:v>
                </c:pt>
                <c:pt idx="127">
                  <c:v>623</c:v>
                </c:pt>
                <c:pt idx="128">
                  <c:v>622</c:v>
                </c:pt>
                <c:pt idx="129">
                  <c:v>621</c:v>
                </c:pt>
                <c:pt idx="130">
                  <c:v>620</c:v>
                </c:pt>
                <c:pt idx="131">
                  <c:v>619</c:v>
                </c:pt>
                <c:pt idx="132">
                  <c:v>618</c:v>
                </c:pt>
                <c:pt idx="133">
                  <c:v>617</c:v>
                </c:pt>
                <c:pt idx="134">
                  <c:v>616</c:v>
                </c:pt>
                <c:pt idx="135">
                  <c:v>615</c:v>
                </c:pt>
                <c:pt idx="136">
                  <c:v>614</c:v>
                </c:pt>
                <c:pt idx="137">
                  <c:v>613</c:v>
                </c:pt>
                <c:pt idx="138">
                  <c:v>612</c:v>
                </c:pt>
                <c:pt idx="139">
                  <c:v>611</c:v>
                </c:pt>
                <c:pt idx="140">
                  <c:v>610</c:v>
                </c:pt>
                <c:pt idx="141">
                  <c:v>609</c:v>
                </c:pt>
                <c:pt idx="142">
                  <c:v>608</c:v>
                </c:pt>
                <c:pt idx="143">
                  <c:v>607</c:v>
                </c:pt>
                <c:pt idx="144">
                  <c:v>606</c:v>
                </c:pt>
                <c:pt idx="145">
                  <c:v>605</c:v>
                </c:pt>
                <c:pt idx="146">
                  <c:v>604</c:v>
                </c:pt>
                <c:pt idx="147">
                  <c:v>603</c:v>
                </c:pt>
                <c:pt idx="148">
                  <c:v>602</c:v>
                </c:pt>
                <c:pt idx="149">
                  <c:v>601</c:v>
                </c:pt>
                <c:pt idx="150">
                  <c:v>600</c:v>
                </c:pt>
                <c:pt idx="151">
                  <c:v>599</c:v>
                </c:pt>
                <c:pt idx="152">
                  <c:v>598</c:v>
                </c:pt>
                <c:pt idx="153">
                  <c:v>597</c:v>
                </c:pt>
                <c:pt idx="154">
                  <c:v>596</c:v>
                </c:pt>
                <c:pt idx="155">
                  <c:v>595</c:v>
                </c:pt>
                <c:pt idx="156">
                  <c:v>594</c:v>
                </c:pt>
                <c:pt idx="157">
                  <c:v>593</c:v>
                </c:pt>
                <c:pt idx="158">
                  <c:v>592</c:v>
                </c:pt>
                <c:pt idx="159">
                  <c:v>591</c:v>
                </c:pt>
                <c:pt idx="160">
                  <c:v>590</c:v>
                </c:pt>
                <c:pt idx="161">
                  <c:v>589</c:v>
                </c:pt>
                <c:pt idx="162">
                  <c:v>588</c:v>
                </c:pt>
                <c:pt idx="163">
                  <c:v>587</c:v>
                </c:pt>
                <c:pt idx="164">
                  <c:v>586</c:v>
                </c:pt>
                <c:pt idx="165">
                  <c:v>585</c:v>
                </c:pt>
                <c:pt idx="166">
                  <c:v>584</c:v>
                </c:pt>
                <c:pt idx="167">
                  <c:v>583</c:v>
                </c:pt>
                <c:pt idx="168">
                  <c:v>582</c:v>
                </c:pt>
                <c:pt idx="169">
                  <c:v>581</c:v>
                </c:pt>
                <c:pt idx="170">
                  <c:v>580</c:v>
                </c:pt>
                <c:pt idx="171">
                  <c:v>579</c:v>
                </c:pt>
                <c:pt idx="172">
                  <c:v>578</c:v>
                </c:pt>
                <c:pt idx="173">
                  <c:v>577</c:v>
                </c:pt>
                <c:pt idx="174">
                  <c:v>576</c:v>
                </c:pt>
                <c:pt idx="175">
                  <c:v>575</c:v>
                </c:pt>
                <c:pt idx="176">
                  <c:v>574</c:v>
                </c:pt>
                <c:pt idx="177">
                  <c:v>573</c:v>
                </c:pt>
                <c:pt idx="178">
                  <c:v>572</c:v>
                </c:pt>
                <c:pt idx="179">
                  <c:v>571</c:v>
                </c:pt>
                <c:pt idx="180">
                  <c:v>570</c:v>
                </c:pt>
                <c:pt idx="181">
                  <c:v>569</c:v>
                </c:pt>
                <c:pt idx="182">
                  <c:v>568</c:v>
                </c:pt>
                <c:pt idx="183">
                  <c:v>567</c:v>
                </c:pt>
                <c:pt idx="184">
                  <c:v>566</c:v>
                </c:pt>
                <c:pt idx="185">
                  <c:v>565</c:v>
                </c:pt>
                <c:pt idx="186">
                  <c:v>564</c:v>
                </c:pt>
                <c:pt idx="187">
                  <c:v>563</c:v>
                </c:pt>
                <c:pt idx="188">
                  <c:v>562</c:v>
                </c:pt>
                <c:pt idx="189">
                  <c:v>561</c:v>
                </c:pt>
                <c:pt idx="190">
                  <c:v>560</c:v>
                </c:pt>
                <c:pt idx="191">
                  <c:v>559</c:v>
                </c:pt>
                <c:pt idx="192">
                  <c:v>558</c:v>
                </c:pt>
                <c:pt idx="193">
                  <c:v>557</c:v>
                </c:pt>
                <c:pt idx="194">
                  <c:v>556</c:v>
                </c:pt>
                <c:pt idx="195">
                  <c:v>555</c:v>
                </c:pt>
                <c:pt idx="196">
                  <c:v>554</c:v>
                </c:pt>
                <c:pt idx="197">
                  <c:v>553</c:v>
                </c:pt>
                <c:pt idx="198">
                  <c:v>552</c:v>
                </c:pt>
                <c:pt idx="199">
                  <c:v>551</c:v>
                </c:pt>
                <c:pt idx="200">
                  <c:v>550</c:v>
                </c:pt>
                <c:pt idx="201">
                  <c:v>549</c:v>
                </c:pt>
                <c:pt idx="202">
                  <c:v>548</c:v>
                </c:pt>
                <c:pt idx="203">
                  <c:v>547</c:v>
                </c:pt>
                <c:pt idx="204">
                  <c:v>546</c:v>
                </c:pt>
                <c:pt idx="205">
                  <c:v>545</c:v>
                </c:pt>
                <c:pt idx="206">
                  <c:v>544</c:v>
                </c:pt>
                <c:pt idx="207">
                  <c:v>543</c:v>
                </c:pt>
                <c:pt idx="208">
                  <c:v>542</c:v>
                </c:pt>
                <c:pt idx="209">
                  <c:v>541</c:v>
                </c:pt>
                <c:pt idx="210">
                  <c:v>540</c:v>
                </c:pt>
                <c:pt idx="211">
                  <c:v>539</c:v>
                </c:pt>
                <c:pt idx="212">
                  <c:v>538</c:v>
                </c:pt>
                <c:pt idx="213">
                  <c:v>537</c:v>
                </c:pt>
                <c:pt idx="214">
                  <c:v>536</c:v>
                </c:pt>
                <c:pt idx="215">
                  <c:v>535</c:v>
                </c:pt>
                <c:pt idx="216">
                  <c:v>534</c:v>
                </c:pt>
                <c:pt idx="217">
                  <c:v>533</c:v>
                </c:pt>
                <c:pt idx="218">
                  <c:v>532</c:v>
                </c:pt>
                <c:pt idx="219">
                  <c:v>531</c:v>
                </c:pt>
                <c:pt idx="220">
                  <c:v>530</c:v>
                </c:pt>
                <c:pt idx="221">
                  <c:v>529</c:v>
                </c:pt>
                <c:pt idx="222">
                  <c:v>528</c:v>
                </c:pt>
                <c:pt idx="223">
                  <c:v>527</c:v>
                </c:pt>
                <c:pt idx="224">
                  <c:v>526</c:v>
                </c:pt>
                <c:pt idx="225">
                  <c:v>525</c:v>
                </c:pt>
                <c:pt idx="226">
                  <c:v>524</c:v>
                </c:pt>
                <c:pt idx="227">
                  <c:v>523</c:v>
                </c:pt>
                <c:pt idx="228">
                  <c:v>522</c:v>
                </c:pt>
                <c:pt idx="229">
                  <c:v>521</c:v>
                </c:pt>
                <c:pt idx="230">
                  <c:v>520</c:v>
                </c:pt>
                <c:pt idx="231">
                  <c:v>519</c:v>
                </c:pt>
                <c:pt idx="232">
                  <c:v>518</c:v>
                </c:pt>
                <c:pt idx="233">
                  <c:v>517</c:v>
                </c:pt>
                <c:pt idx="234">
                  <c:v>516</c:v>
                </c:pt>
                <c:pt idx="235">
                  <c:v>515</c:v>
                </c:pt>
                <c:pt idx="236">
                  <c:v>514</c:v>
                </c:pt>
                <c:pt idx="237">
                  <c:v>513</c:v>
                </c:pt>
                <c:pt idx="238">
                  <c:v>512</c:v>
                </c:pt>
                <c:pt idx="239">
                  <c:v>511</c:v>
                </c:pt>
                <c:pt idx="240">
                  <c:v>510</c:v>
                </c:pt>
                <c:pt idx="241">
                  <c:v>509</c:v>
                </c:pt>
                <c:pt idx="242">
                  <c:v>508</c:v>
                </c:pt>
                <c:pt idx="243">
                  <c:v>507</c:v>
                </c:pt>
                <c:pt idx="244">
                  <c:v>506</c:v>
                </c:pt>
                <c:pt idx="245">
                  <c:v>505</c:v>
                </c:pt>
                <c:pt idx="246">
                  <c:v>504</c:v>
                </c:pt>
                <c:pt idx="247">
                  <c:v>503</c:v>
                </c:pt>
                <c:pt idx="248">
                  <c:v>502</c:v>
                </c:pt>
                <c:pt idx="249">
                  <c:v>501</c:v>
                </c:pt>
                <c:pt idx="250">
                  <c:v>500</c:v>
                </c:pt>
                <c:pt idx="251">
                  <c:v>499</c:v>
                </c:pt>
                <c:pt idx="252">
                  <c:v>498</c:v>
                </c:pt>
                <c:pt idx="253">
                  <c:v>497</c:v>
                </c:pt>
                <c:pt idx="254">
                  <c:v>496</c:v>
                </c:pt>
                <c:pt idx="255">
                  <c:v>495</c:v>
                </c:pt>
                <c:pt idx="256">
                  <c:v>494</c:v>
                </c:pt>
                <c:pt idx="257">
                  <c:v>493</c:v>
                </c:pt>
                <c:pt idx="258">
                  <c:v>492</c:v>
                </c:pt>
                <c:pt idx="259">
                  <c:v>491</c:v>
                </c:pt>
                <c:pt idx="260">
                  <c:v>490</c:v>
                </c:pt>
                <c:pt idx="261">
                  <c:v>489</c:v>
                </c:pt>
                <c:pt idx="262">
                  <c:v>488</c:v>
                </c:pt>
                <c:pt idx="263">
                  <c:v>487</c:v>
                </c:pt>
                <c:pt idx="264">
                  <c:v>486</c:v>
                </c:pt>
                <c:pt idx="265">
                  <c:v>485</c:v>
                </c:pt>
                <c:pt idx="266">
                  <c:v>484</c:v>
                </c:pt>
                <c:pt idx="267">
                  <c:v>483</c:v>
                </c:pt>
                <c:pt idx="268">
                  <c:v>482</c:v>
                </c:pt>
                <c:pt idx="269">
                  <c:v>481</c:v>
                </c:pt>
                <c:pt idx="270">
                  <c:v>480</c:v>
                </c:pt>
                <c:pt idx="271">
                  <c:v>479</c:v>
                </c:pt>
                <c:pt idx="272">
                  <c:v>478</c:v>
                </c:pt>
                <c:pt idx="273">
                  <c:v>477</c:v>
                </c:pt>
                <c:pt idx="274">
                  <c:v>476</c:v>
                </c:pt>
                <c:pt idx="275">
                  <c:v>475</c:v>
                </c:pt>
                <c:pt idx="276">
                  <c:v>474</c:v>
                </c:pt>
                <c:pt idx="277">
                  <c:v>473</c:v>
                </c:pt>
                <c:pt idx="278">
                  <c:v>472</c:v>
                </c:pt>
                <c:pt idx="279">
                  <c:v>471</c:v>
                </c:pt>
                <c:pt idx="280">
                  <c:v>470</c:v>
                </c:pt>
                <c:pt idx="281">
                  <c:v>469</c:v>
                </c:pt>
                <c:pt idx="282">
                  <c:v>468</c:v>
                </c:pt>
                <c:pt idx="283">
                  <c:v>467</c:v>
                </c:pt>
                <c:pt idx="284">
                  <c:v>466</c:v>
                </c:pt>
                <c:pt idx="285">
                  <c:v>465</c:v>
                </c:pt>
                <c:pt idx="286">
                  <c:v>464</c:v>
                </c:pt>
                <c:pt idx="287">
                  <c:v>463</c:v>
                </c:pt>
                <c:pt idx="288">
                  <c:v>462</c:v>
                </c:pt>
                <c:pt idx="289">
                  <c:v>461</c:v>
                </c:pt>
                <c:pt idx="290">
                  <c:v>460</c:v>
                </c:pt>
                <c:pt idx="291">
                  <c:v>459</c:v>
                </c:pt>
                <c:pt idx="292">
                  <c:v>458</c:v>
                </c:pt>
                <c:pt idx="293">
                  <c:v>457</c:v>
                </c:pt>
                <c:pt idx="294">
                  <c:v>456</c:v>
                </c:pt>
                <c:pt idx="295">
                  <c:v>455</c:v>
                </c:pt>
                <c:pt idx="296">
                  <c:v>454</c:v>
                </c:pt>
                <c:pt idx="297">
                  <c:v>453</c:v>
                </c:pt>
                <c:pt idx="298">
                  <c:v>452</c:v>
                </c:pt>
                <c:pt idx="299">
                  <c:v>451</c:v>
                </c:pt>
                <c:pt idx="300">
                  <c:v>450</c:v>
                </c:pt>
                <c:pt idx="301">
                  <c:v>449</c:v>
                </c:pt>
                <c:pt idx="302">
                  <c:v>448</c:v>
                </c:pt>
                <c:pt idx="303">
                  <c:v>447</c:v>
                </c:pt>
                <c:pt idx="304">
                  <c:v>446</c:v>
                </c:pt>
                <c:pt idx="305">
                  <c:v>445</c:v>
                </c:pt>
                <c:pt idx="306">
                  <c:v>444</c:v>
                </c:pt>
                <c:pt idx="307">
                  <c:v>443</c:v>
                </c:pt>
                <c:pt idx="308">
                  <c:v>442</c:v>
                </c:pt>
                <c:pt idx="309">
                  <c:v>441</c:v>
                </c:pt>
                <c:pt idx="310">
                  <c:v>440</c:v>
                </c:pt>
                <c:pt idx="311">
                  <c:v>439</c:v>
                </c:pt>
                <c:pt idx="312">
                  <c:v>438</c:v>
                </c:pt>
                <c:pt idx="313">
                  <c:v>437</c:v>
                </c:pt>
                <c:pt idx="314">
                  <c:v>436</c:v>
                </c:pt>
                <c:pt idx="315">
                  <c:v>435</c:v>
                </c:pt>
                <c:pt idx="316">
                  <c:v>434</c:v>
                </c:pt>
                <c:pt idx="317">
                  <c:v>433</c:v>
                </c:pt>
                <c:pt idx="318">
                  <c:v>432</c:v>
                </c:pt>
                <c:pt idx="319">
                  <c:v>431</c:v>
                </c:pt>
                <c:pt idx="320">
                  <c:v>430</c:v>
                </c:pt>
                <c:pt idx="321">
                  <c:v>429</c:v>
                </c:pt>
                <c:pt idx="322">
                  <c:v>428</c:v>
                </c:pt>
                <c:pt idx="323">
                  <c:v>427</c:v>
                </c:pt>
                <c:pt idx="324">
                  <c:v>426</c:v>
                </c:pt>
                <c:pt idx="325">
                  <c:v>425</c:v>
                </c:pt>
                <c:pt idx="326">
                  <c:v>424</c:v>
                </c:pt>
                <c:pt idx="327">
                  <c:v>423</c:v>
                </c:pt>
                <c:pt idx="328">
                  <c:v>422</c:v>
                </c:pt>
                <c:pt idx="329">
                  <c:v>421</c:v>
                </c:pt>
                <c:pt idx="330">
                  <c:v>420</c:v>
                </c:pt>
                <c:pt idx="331">
                  <c:v>419</c:v>
                </c:pt>
                <c:pt idx="332">
                  <c:v>418</c:v>
                </c:pt>
                <c:pt idx="333">
                  <c:v>417</c:v>
                </c:pt>
                <c:pt idx="334">
                  <c:v>416</c:v>
                </c:pt>
                <c:pt idx="335">
                  <c:v>415</c:v>
                </c:pt>
                <c:pt idx="336">
                  <c:v>414</c:v>
                </c:pt>
                <c:pt idx="337">
                  <c:v>413</c:v>
                </c:pt>
                <c:pt idx="338">
                  <c:v>412</c:v>
                </c:pt>
                <c:pt idx="339">
                  <c:v>411</c:v>
                </c:pt>
                <c:pt idx="340">
                  <c:v>410</c:v>
                </c:pt>
                <c:pt idx="341">
                  <c:v>409</c:v>
                </c:pt>
                <c:pt idx="342">
                  <c:v>408</c:v>
                </c:pt>
                <c:pt idx="343">
                  <c:v>407</c:v>
                </c:pt>
                <c:pt idx="344">
                  <c:v>406</c:v>
                </c:pt>
                <c:pt idx="345">
                  <c:v>405</c:v>
                </c:pt>
                <c:pt idx="346">
                  <c:v>404</c:v>
                </c:pt>
                <c:pt idx="347">
                  <c:v>403</c:v>
                </c:pt>
                <c:pt idx="348">
                  <c:v>402</c:v>
                </c:pt>
                <c:pt idx="349">
                  <c:v>401</c:v>
                </c:pt>
                <c:pt idx="350">
                  <c:v>400</c:v>
                </c:pt>
                <c:pt idx="351">
                  <c:v>399</c:v>
                </c:pt>
                <c:pt idx="352">
                  <c:v>398</c:v>
                </c:pt>
                <c:pt idx="353">
                  <c:v>397</c:v>
                </c:pt>
                <c:pt idx="354">
                  <c:v>396</c:v>
                </c:pt>
                <c:pt idx="355">
                  <c:v>395</c:v>
                </c:pt>
                <c:pt idx="356">
                  <c:v>394</c:v>
                </c:pt>
                <c:pt idx="357">
                  <c:v>393</c:v>
                </c:pt>
                <c:pt idx="358">
                  <c:v>392</c:v>
                </c:pt>
                <c:pt idx="359">
                  <c:v>391</c:v>
                </c:pt>
                <c:pt idx="360">
                  <c:v>390</c:v>
                </c:pt>
                <c:pt idx="361">
                  <c:v>389</c:v>
                </c:pt>
                <c:pt idx="362">
                  <c:v>388</c:v>
                </c:pt>
                <c:pt idx="363">
                  <c:v>387</c:v>
                </c:pt>
                <c:pt idx="364">
                  <c:v>386</c:v>
                </c:pt>
                <c:pt idx="365">
                  <c:v>385</c:v>
                </c:pt>
                <c:pt idx="366">
                  <c:v>384</c:v>
                </c:pt>
                <c:pt idx="367">
                  <c:v>383</c:v>
                </c:pt>
                <c:pt idx="368">
                  <c:v>382</c:v>
                </c:pt>
                <c:pt idx="369">
                  <c:v>381</c:v>
                </c:pt>
                <c:pt idx="370">
                  <c:v>380</c:v>
                </c:pt>
                <c:pt idx="371">
                  <c:v>379</c:v>
                </c:pt>
                <c:pt idx="372">
                  <c:v>378</c:v>
                </c:pt>
                <c:pt idx="373">
                  <c:v>377</c:v>
                </c:pt>
                <c:pt idx="374">
                  <c:v>376</c:v>
                </c:pt>
                <c:pt idx="375">
                  <c:v>375</c:v>
                </c:pt>
                <c:pt idx="376">
                  <c:v>374</c:v>
                </c:pt>
                <c:pt idx="377">
                  <c:v>373</c:v>
                </c:pt>
                <c:pt idx="378">
                  <c:v>372</c:v>
                </c:pt>
                <c:pt idx="379">
                  <c:v>371</c:v>
                </c:pt>
                <c:pt idx="380">
                  <c:v>370</c:v>
                </c:pt>
                <c:pt idx="381">
                  <c:v>369</c:v>
                </c:pt>
                <c:pt idx="382">
                  <c:v>368</c:v>
                </c:pt>
                <c:pt idx="383">
                  <c:v>367</c:v>
                </c:pt>
                <c:pt idx="384">
                  <c:v>366</c:v>
                </c:pt>
                <c:pt idx="385">
                  <c:v>365</c:v>
                </c:pt>
                <c:pt idx="386">
                  <c:v>364</c:v>
                </c:pt>
                <c:pt idx="387">
                  <c:v>363</c:v>
                </c:pt>
                <c:pt idx="388">
                  <c:v>362</c:v>
                </c:pt>
                <c:pt idx="389">
                  <c:v>361</c:v>
                </c:pt>
                <c:pt idx="390">
                  <c:v>360</c:v>
                </c:pt>
                <c:pt idx="391">
                  <c:v>359</c:v>
                </c:pt>
                <c:pt idx="392">
                  <c:v>358</c:v>
                </c:pt>
                <c:pt idx="393">
                  <c:v>357</c:v>
                </c:pt>
                <c:pt idx="394">
                  <c:v>356</c:v>
                </c:pt>
                <c:pt idx="395">
                  <c:v>355</c:v>
                </c:pt>
                <c:pt idx="396">
                  <c:v>354</c:v>
                </c:pt>
                <c:pt idx="397">
                  <c:v>353</c:v>
                </c:pt>
                <c:pt idx="398">
                  <c:v>352</c:v>
                </c:pt>
                <c:pt idx="399">
                  <c:v>351</c:v>
                </c:pt>
                <c:pt idx="400">
                  <c:v>350</c:v>
                </c:pt>
                <c:pt idx="401">
                  <c:v>349</c:v>
                </c:pt>
                <c:pt idx="402">
                  <c:v>348</c:v>
                </c:pt>
                <c:pt idx="403">
                  <c:v>347</c:v>
                </c:pt>
                <c:pt idx="404">
                  <c:v>346</c:v>
                </c:pt>
                <c:pt idx="405">
                  <c:v>345</c:v>
                </c:pt>
                <c:pt idx="406">
                  <c:v>344</c:v>
                </c:pt>
                <c:pt idx="407">
                  <c:v>343</c:v>
                </c:pt>
                <c:pt idx="408">
                  <c:v>342</c:v>
                </c:pt>
                <c:pt idx="409">
                  <c:v>341</c:v>
                </c:pt>
                <c:pt idx="410">
                  <c:v>340</c:v>
                </c:pt>
                <c:pt idx="411">
                  <c:v>339</c:v>
                </c:pt>
                <c:pt idx="412">
                  <c:v>338</c:v>
                </c:pt>
                <c:pt idx="413">
                  <c:v>337</c:v>
                </c:pt>
                <c:pt idx="414">
                  <c:v>336</c:v>
                </c:pt>
                <c:pt idx="415">
                  <c:v>335</c:v>
                </c:pt>
                <c:pt idx="416">
                  <c:v>334</c:v>
                </c:pt>
                <c:pt idx="417">
                  <c:v>333</c:v>
                </c:pt>
                <c:pt idx="418">
                  <c:v>332</c:v>
                </c:pt>
                <c:pt idx="419">
                  <c:v>331</c:v>
                </c:pt>
                <c:pt idx="420">
                  <c:v>330</c:v>
                </c:pt>
                <c:pt idx="421">
                  <c:v>329</c:v>
                </c:pt>
                <c:pt idx="422">
                  <c:v>328</c:v>
                </c:pt>
                <c:pt idx="423">
                  <c:v>327</c:v>
                </c:pt>
                <c:pt idx="424">
                  <c:v>326</c:v>
                </c:pt>
                <c:pt idx="425">
                  <c:v>325</c:v>
                </c:pt>
                <c:pt idx="426">
                  <c:v>324</c:v>
                </c:pt>
                <c:pt idx="427">
                  <c:v>323</c:v>
                </c:pt>
                <c:pt idx="428">
                  <c:v>322</c:v>
                </c:pt>
                <c:pt idx="429">
                  <c:v>321</c:v>
                </c:pt>
                <c:pt idx="430">
                  <c:v>320</c:v>
                </c:pt>
                <c:pt idx="431">
                  <c:v>319</c:v>
                </c:pt>
                <c:pt idx="432">
                  <c:v>318</c:v>
                </c:pt>
                <c:pt idx="433">
                  <c:v>317</c:v>
                </c:pt>
                <c:pt idx="434">
                  <c:v>316</c:v>
                </c:pt>
                <c:pt idx="435">
                  <c:v>315</c:v>
                </c:pt>
                <c:pt idx="436">
                  <c:v>314</c:v>
                </c:pt>
                <c:pt idx="437">
                  <c:v>313</c:v>
                </c:pt>
                <c:pt idx="438">
                  <c:v>312</c:v>
                </c:pt>
                <c:pt idx="439">
                  <c:v>311</c:v>
                </c:pt>
                <c:pt idx="440">
                  <c:v>310</c:v>
                </c:pt>
                <c:pt idx="441">
                  <c:v>309</c:v>
                </c:pt>
                <c:pt idx="442">
                  <c:v>308</c:v>
                </c:pt>
                <c:pt idx="443">
                  <c:v>307</c:v>
                </c:pt>
                <c:pt idx="444">
                  <c:v>306</c:v>
                </c:pt>
                <c:pt idx="445">
                  <c:v>305</c:v>
                </c:pt>
                <c:pt idx="446">
                  <c:v>304</c:v>
                </c:pt>
                <c:pt idx="447">
                  <c:v>303</c:v>
                </c:pt>
                <c:pt idx="448">
                  <c:v>302</c:v>
                </c:pt>
                <c:pt idx="449">
                  <c:v>301</c:v>
                </c:pt>
                <c:pt idx="450">
                  <c:v>300</c:v>
                </c:pt>
                <c:pt idx="451">
                  <c:v>299</c:v>
                </c:pt>
                <c:pt idx="452">
                  <c:v>298</c:v>
                </c:pt>
                <c:pt idx="453">
                  <c:v>297</c:v>
                </c:pt>
                <c:pt idx="454">
                  <c:v>296</c:v>
                </c:pt>
                <c:pt idx="455">
                  <c:v>295</c:v>
                </c:pt>
                <c:pt idx="456">
                  <c:v>294</c:v>
                </c:pt>
                <c:pt idx="457">
                  <c:v>293</c:v>
                </c:pt>
                <c:pt idx="458">
                  <c:v>292</c:v>
                </c:pt>
                <c:pt idx="459">
                  <c:v>291</c:v>
                </c:pt>
                <c:pt idx="460">
                  <c:v>290</c:v>
                </c:pt>
                <c:pt idx="461">
                  <c:v>289</c:v>
                </c:pt>
                <c:pt idx="462">
                  <c:v>288</c:v>
                </c:pt>
                <c:pt idx="463">
                  <c:v>287</c:v>
                </c:pt>
                <c:pt idx="464">
                  <c:v>286</c:v>
                </c:pt>
                <c:pt idx="465">
                  <c:v>285</c:v>
                </c:pt>
                <c:pt idx="466">
                  <c:v>284</c:v>
                </c:pt>
                <c:pt idx="467">
                  <c:v>283</c:v>
                </c:pt>
                <c:pt idx="468">
                  <c:v>282</c:v>
                </c:pt>
                <c:pt idx="469">
                  <c:v>281</c:v>
                </c:pt>
                <c:pt idx="470">
                  <c:v>280</c:v>
                </c:pt>
                <c:pt idx="471">
                  <c:v>279</c:v>
                </c:pt>
                <c:pt idx="472">
                  <c:v>278</c:v>
                </c:pt>
                <c:pt idx="473">
                  <c:v>277</c:v>
                </c:pt>
                <c:pt idx="474">
                  <c:v>276</c:v>
                </c:pt>
                <c:pt idx="475">
                  <c:v>275</c:v>
                </c:pt>
                <c:pt idx="476">
                  <c:v>274</c:v>
                </c:pt>
                <c:pt idx="477">
                  <c:v>273</c:v>
                </c:pt>
                <c:pt idx="478">
                  <c:v>272</c:v>
                </c:pt>
                <c:pt idx="479">
                  <c:v>271</c:v>
                </c:pt>
                <c:pt idx="480">
                  <c:v>270</c:v>
                </c:pt>
                <c:pt idx="481">
                  <c:v>269</c:v>
                </c:pt>
                <c:pt idx="482">
                  <c:v>268</c:v>
                </c:pt>
                <c:pt idx="483">
                  <c:v>267</c:v>
                </c:pt>
                <c:pt idx="484">
                  <c:v>266</c:v>
                </c:pt>
                <c:pt idx="485">
                  <c:v>265</c:v>
                </c:pt>
                <c:pt idx="486">
                  <c:v>264</c:v>
                </c:pt>
                <c:pt idx="487">
                  <c:v>263</c:v>
                </c:pt>
                <c:pt idx="488">
                  <c:v>262</c:v>
                </c:pt>
                <c:pt idx="489">
                  <c:v>261</c:v>
                </c:pt>
                <c:pt idx="490">
                  <c:v>260</c:v>
                </c:pt>
                <c:pt idx="491">
                  <c:v>259</c:v>
                </c:pt>
                <c:pt idx="492">
                  <c:v>258</c:v>
                </c:pt>
                <c:pt idx="493">
                  <c:v>257</c:v>
                </c:pt>
                <c:pt idx="494">
                  <c:v>256</c:v>
                </c:pt>
                <c:pt idx="495">
                  <c:v>255</c:v>
                </c:pt>
                <c:pt idx="496">
                  <c:v>254</c:v>
                </c:pt>
                <c:pt idx="497">
                  <c:v>253</c:v>
                </c:pt>
                <c:pt idx="498">
                  <c:v>252</c:v>
                </c:pt>
                <c:pt idx="499">
                  <c:v>251</c:v>
                </c:pt>
                <c:pt idx="500">
                  <c:v>250</c:v>
                </c:pt>
              </c:numCache>
            </c:numRef>
          </c:xVal>
          <c:yVal>
            <c:numRef>
              <c:f>'SPETTRI Sorgente-Filtri'!$C$2:$C$552</c:f>
              <c:numCache>
                <c:formatCode>General</c:formatCode>
                <c:ptCount val="551"/>
                <c:pt idx="0">
                  <c:v>0.41620213</c:v>
                </c:pt>
                <c:pt idx="1">
                  <c:v>0.40728051999999998</c:v>
                </c:pt>
                <c:pt idx="2">
                  <c:v>0.39824015000000001</c:v>
                </c:pt>
                <c:pt idx="3">
                  <c:v>0.38906860999999998</c:v>
                </c:pt>
                <c:pt idx="4">
                  <c:v>0.37991956999999998</c:v>
                </c:pt>
                <c:pt idx="5">
                  <c:v>0.37124623000000001</c:v>
                </c:pt>
                <c:pt idx="6">
                  <c:v>0.36216755999999994</c:v>
                </c:pt>
                <c:pt idx="7">
                  <c:v>0.35321190999999996</c:v>
                </c:pt>
                <c:pt idx="8">
                  <c:v>0.34456417</c:v>
                </c:pt>
                <c:pt idx="9">
                  <c:v>0.33578038999999998</c:v>
                </c:pt>
                <c:pt idx="10">
                  <c:v>0.32692144000000001</c:v>
                </c:pt>
                <c:pt idx="11">
                  <c:v>0.31812066999999999</c:v>
                </c:pt>
                <c:pt idx="12">
                  <c:v>0.30954472999999999</c:v>
                </c:pt>
                <c:pt idx="13">
                  <c:v>0.30097457999999999</c:v>
                </c:pt>
                <c:pt idx="14">
                  <c:v>0.29221134999999998</c:v>
                </c:pt>
                <c:pt idx="15">
                  <c:v>0.28368289000000002</c:v>
                </c:pt>
                <c:pt idx="16">
                  <c:v>0.27530992999999998</c:v>
                </c:pt>
                <c:pt idx="17">
                  <c:v>0.26685569999999997</c:v>
                </c:pt>
                <c:pt idx="18">
                  <c:v>0.25843959999999999</c:v>
                </c:pt>
                <c:pt idx="19">
                  <c:v>0.25014316999999997</c:v>
                </c:pt>
                <c:pt idx="20">
                  <c:v>0.24183905</c:v>
                </c:pt>
                <c:pt idx="21">
                  <c:v>0.23352499999999998</c:v>
                </c:pt>
                <c:pt idx="22">
                  <c:v>0.22526875000000002</c:v>
                </c:pt>
                <c:pt idx="23">
                  <c:v>0.21697269999999999</c:v>
                </c:pt>
                <c:pt idx="24">
                  <c:v>0.20888494999999999</c:v>
                </c:pt>
                <c:pt idx="25">
                  <c:v>0.20080127</c:v>
                </c:pt>
                <c:pt idx="26">
                  <c:v>0.19290306000000002</c:v>
                </c:pt>
                <c:pt idx="27">
                  <c:v>0.18486412000000002</c:v>
                </c:pt>
                <c:pt idx="28">
                  <c:v>0.17700437999999999</c:v>
                </c:pt>
                <c:pt idx="29">
                  <c:v>0.16932454</c:v>
                </c:pt>
                <c:pt idx="30">
                  <c:v>0.16162945000000001</c:v>
                </c:pt>
                <c:pt idx="31">
                  <c:v>0.15407082</c:v>
                </c:pt>
                <c:pt idx="32">
                  <c:v>0.14657054</c:v>
                </c:pt>
                <c:pt idx="33">
                  <c:v>0.13917942</c:v>
                </c:pt>
                <c:pt idx="34">
                  <c:v>0.13194552000000001</c:v>
                </c:pt>
                <c:pt idx="35">
                  <c:v>0.12492464</c:v>
                </c:pt>
                <c:pt idx="36">
                  <c:v>0.11807005999999999</c:v>
                </c:pt>
                <c:pt idx="37">
                  <c:v>0.11134591000000001</c:v>
                </c:pt>
                <c:pt idx="38">
                  <c:v>0.10480313000000001</c:v>
                </c:pt>
                <c:pt idx="39">
                  <c:v>9.8497479999999998E-2</c:v>
                </c:pt>
                <c:pt idx="40">
                  <c:v>9.2411130000000008E-2</c:v>
                </c:pt>
                <c:pt idx="41">
                  <c:v>8.6434800000000006E-2</c:v>
                </c:pt>
                <c:pt idx="42">
                  <c:v>8.0584260000000005E-2</c:v>
                </c:pt>
                <c:pt idx="43">
                  <c:v>7.4947139999999995E-2</c:v>
                </c:pt>
                <c:pt idx="44">
                  <c:v>6.9536319999999999E-2</c:v>
                </c:pt>
                <c:pt idx="45">
                  <c:v>6.4322999999999991E-2</c:v>
                </c:pt>
                <c:pt idx="46">
                  <c:v>5.9351939999999999E-2</c:v>
                </c:pt>
                <c:pt idx="47">
                  <c:v>5.4572969999999998E-2</c:v>
                </c:pt>
                <c:pt idx="48">
                  <c:v>5.0034850000000006E-2</c:v>
                </c:pt>
                <c:pt idx="49">
                  <c:v>4.5766790000000002E-2</c:v>
                </c:pt>
                <c:pt idx="50">
                  <c:v>4.1697559999999995E-2</c:v>
                </c:pt>
                <c:pt idx="51">
                  <c:v>3.7820190000000004E-2</c:v>
                </c:pt>
                <c:pt idx="52">
                  <c:v>3.4120879999999999E-2</c:v>
                </c:pt>
                <c:pt idx="53">
                  <c:v>3.064221E-2</c:v>
                </c:pt>
                <c:pt idx="54">
                  <c:v>2.7391909999999998E-2</c:v>
                </c:pt>
                <c:pt idx="55">
                  <c:v>2.436864E-2</c:v>
                </c:pt>
                <c:pt idx="56">
                  <c:v>2.1598240000000001E-2</c:v>
                </c:pt>
                <c:pt idx="57">
                  <c:v>1.90244E-2</c:v>
                </c:pt>
                <c:pt idx="58">
                  <c:v>1.669006E-2</c:v>
                </c:pt>
                <c:pt idx="59">
                  <c:v>1.4565809999999998E-2</c:v>
                </c:pt>
                <c:pt idx="60">
                  <c:v>1.256259E-2</c:v>
                </c:pt>
                <c:pt idx="61">
                  <c:v>1.0742089999999999E-2</c:v>
                </c:pt>
                <c:pt idx="62">
                  <c:v>9.1669300000000002E-3</c:v>
                </c:pt>
                <c:pt idx="63">
                  <c:v>7.7298100000000002E-3</c:v>
                </c:pt>
                <c:pt idx="64">
                  <c:v>6.4361500000000007E-3</c:v>
                </c:pt>
                <c:pt idx="65">
                  <c:v>5.3184900000000004E-3</c:v>
                </c:pt>
                <c:pt idx="66">
                  <c:v>4.3127199999999999E-3</c:v>
                </c:pt>
                <c:pt idx="67">
                  <c:v>3.4259899999999999E-3</c:v>
                </c:pt>
                <c:pt idx="68">
                  <c:v>2.6519E-3</c:v>
                </c:pt>
                <c:pt idx="69">
                  <c:v>1.9720300000000001E-3</c:v>
                </c:pt>
                <c:pt idx="70">
                  <c:v>1.43435E-3</c:v>
                </c:pt>
                <c:pt idx="71">
                  <c:v>9.4990000000000005E-4</c:v>
                </c:pt>
                <c:pt idx="72">
                  <c:v>5.6853000000000003E-4</c:v>
                </c:pt>
                <c:pt idx="73">
                  <c:v>2.6404999999999999E-4</c:v>
                </c:pt>
                <c:pt idx="74">
                  <c:v>1.1119999999999999E-5</c:v>
                </c:pt>
                <c:pt idx="75">
                  <c:v>-1.6292000000000002E-4</c:v>
                </c:pt>
                <c:pt idx="76">
                  <c:v>-3.4416000000000004E-4</c:v>
                </c:pt>
                <c:pt idx="77">
                  <c:v>-4.5858000000000004E-4</c:v>
                </c:pt>
                <c:pt idx="78">
                  <c:v>-5.3255999999999996E-4</c:v>
                </c:pt>
                <c:pt idx="79">
                  <c:v>-5.9237999999999999E-4</c:v>
                </c:pt>
                <c:pt idx="80">
                  <c:v>-5.8230999999999995E-4</c:v>
                </c:pt>
                <c:pt idx="81">
                  <c:v>-5.7434000000000001E-4</c:v>
                </c:pt>
                <c:pt idx="82">
                  <c:v>-5.1663000000000002E-4</c:v>
                </c:pt>
                <c:pt idx="83">
                  <c:v>-4.2762000000000003E-4</c:v>
                </c:pt>
                <c:pt idx="84">
                  <c:v>-3.4463000000000001E-4</c:v>
                </c:pt>
                <c:pt idx="85">
                  <c:v>-2.1184E-4</c:v>
                </c:pt>
                <c:pt idx="86">
                  <c:v>-8.7180000000000002E-5</c:v>
                </c:pt>
                <c:pt idx="87">
                  <c:v>8.4139999999999991E-5</c:v>
                </c:pt>
                <c:pt idx="88">
                  <c:v>2.6869000000000003E-4</c:v>
                </c:pt>
                <c:pt idx="89">
                  <c:v>4.4922999999999995E-4</c:v>
                </c:pt>
                <c:pt idx="90">
                  <c:v>6.9877999999999997E-4</c:v>
                </c:pt>
                <c:pt idx="91">
                  <c:v>9.1082999999999995E-4</c:v>
                </c:pt>
                <c:pt idx="92">
                  <c:v>1.1190200000000001E-3</c:v>
                </c:pt>
                <c:pt idx="93">
                  <c:v>1.29582E-3</c:v>
                </c:pt>
                <c:pt idx="94">
                  <c:v>1.4135900000000002E-3</c:v>
                </c:pt>
                <c:pt idx="95">
                  <c:v>1.5242600000000002E-3</c:v>
                </c:pt>
                <c:pt idx="96">
                  <c:v>1.5983600000000001E-3</c:v>
                </c:pt>
                <c:pt idx="97">
                  <c:v>1.6738500000000002E-3</c:v>
                </c:pt>
                <c:pt idx="98">
                  <c:v>1.7117899999999999E-3</c:v>
                </c:pt>
                <c:pt idx="99">
                  <c:v>1.7027500000000001E-3</c:v>
                </c:pt>
                <c:pt idx="100">
                  <c:v>1.6977800000000001E-3</c:v>
                </c:pt>
                <c:pt idx="101">
                  <c:v>1.6188700000000001E-3</c:v>
                </c:pt>
                <c:pt idx="102">
                  <c:v>1.5318100000000002E-3</c:v>
                </c:pt>
                <c:pt idx="103">
                  <c:v>1.3864399999999999E-3</c:v>
                </c:pt>
                <c:pt idx="104">
                  <c:v>1.1935299999999999E-3</c:v>
                </c:pt>
                <c:pt idx="105">
                  <c:v>9.9660000000000005E-4</c:v>
                </c:pt>
                <c:pt idx="106">
                  <c:v>7.7519000000000004E-4</c:v>
                </c:pt>
                <c:pt idx="107">
                  <c:v>5.5581000000000001E-4</c:v>
                </c:pt>
                <c:pt idx="108">
                  <c:v>3.2110999999999999E-4</c:v>
                </c:pt>
                <c:pt idx="109">
                  <c:v>6.6060000000000001E-5</c:v>
                </c:pt>
                <c:pt idx="110">
                  <c:v>-1.6975000000000001E-4</c:v>
                </c:pt>
                <c:pt idx="111">
                  <c:v>-4.2090000000000004E-4</c:v>
                </c:pt>
                <c:pt idx="112">
                  <c:v>-6.6184999999999996E-4</c:v>
                </c:pt>
                <c:pt idx="113">
                  <c:v>-9.4762999999999998E-4</c:v>
                </c:pt>
                <c:pt idx="114">
                  <c:v>-1.2235200000000001E-3</c:v>
                </c:pt>
                <c:pt idx="115">
                  <c:v>-1.4533199999999999E-3</c:v>
                </c:pt>
                <c:pt idx="116">
                  <c:v>-1.6861000000000001E-3</c:v>
                </c:pt>
                <c:pt idx="117">
                  <c:v>-1.86232E-3</c:v>
                </c:pt>
                <c:pt idx="118">
                  <c:v>-2.0507099999999999E-3</c:v>
                </c:pt>
                <c:pt idx="119">
                  <c:v>-2.2423999999999999E-3</c:v>
                </c:pt>
                <c:pt idx="120">
                  <c:v>-2.4152599999999998E-3</c:v>
                </c:pt>
                <c:pt idx="121">
                  <c:v>-2.59961E-3</c:v>
                </c:pt>
                <c:pt idx="122">
                  <c:v>-2.7276499999999999E-3</c:v>
                </c:pt>
                <c:pt idx="123">
                  <c:v>-2.8667900000000001E-3</c:v>
                </c:pt>
                <c:pt idx="124">
                  <c:v>-2.9858600000000003E-3</c:v>
                </c:pt>
                <c:pt idx="125">
                  <c:v>-3.0441400000000003E-3</c:v>
                </c:pt>
                <c:pt idx="126">
                  <c:v>-3.1281900000000003E-3</c:v>
                </c:pt>
                <c:pt idx="127">
                  <c:v>-3.1606099999999999E-3</c:v>
                </c:pt>
                <c:pt idx="128">
                  <c:v>-3.1946799999999997E-3</c:v>
                </c:pt>
                <c:pt idx="129">
                  <c:v>-3.2401000000000001E-3</c:v>
                </c:pt>
                <c:pt idx="130">
                  <c:v>-3.23069E-3</c:v>
                </c:pt>
                <c:pt idx="131">
                  <c:v>-3.2451300000000001E-3</c:v>
                </c:pt>
                <c:pt idx="132">
                  <c:v>-3.2121200000000002E-3</c:v>
                </c:pt>
                <c:pt idx="133">
                  <c:v>-3.1737900000000001E-3</c:v>
                </c:pt>
                <c:pt idx="134">
                  <c:v>-3.1002299999999998E-3</c:v>
                </c:pt>
                <c:pt idx="135">
                  <c:v>-2.9680099999999997E-3</c:v>
                </c:pt>
                <c:pt idx="136">
                  <c:v>-2.8500399999999999E-3</c:v>
                </c:pt>
                <c:pt idx="137">
                  <c:v>-2.6864599999999999E-3</c:v>
                </c:pt>
                <c:pt idx="138">
                  <c:v>-2.5201299999999998E-3</c:v>
                </c:pt>
                <c:pt idx="139">
                  <c:v>-2.32635E-3</c:v>
                </c:pt>
                <c:pt idx="140">
                  <c:v>-2.0657600000000003E-3</c:v>
                </c:pt>
                <c:pt idx="141">
                  <c:v>-1.80211E-3</c:v>
                </c:pt>
                <c:pt idx="142">
                  <c:v>-1.4352999999999998E-3</c:v>
                </c:pt>
                <c:pt idx="143">
                  <c:v>-1.0667000000000001E-3</c:v>
                </c:pt>
                <c:pt idx="144">
                  <c:v>-6.5604999999999993E-4</c:v>
                </c:pt>
                <c:pt idx="145">
                  <c:v>-1.2839000000000001E-4</c:v>
                </c:pt>
                <c:pt idx="146">
                  <c:v>3.9539999999999996E-4</c:v>
                </c:pt>
                <c:pt idx="147">
                  <c:v>9.9971999999999995E-4</c:v>
                </c:pt>
                <c:pt idx="148">
                  <c:v>1.6459699999999999E-3</c:v>
                </c:pt>
                <c:pt idx="149">
                  <c:v>2.3547199999999998E-3</c:v>
                </c:pt>
                <c:pt idx="150">
                  <c:v>3.1872200000000002E-3</c:v>
                </c:pt>
                <c:pt idx="151">
                  <c:v>4.0274200000000003E-3</c:v>
                </c:pt>
                <c:pt idx="152">
                  <c:v>4.9979500000000001E-3</c:v>
                </c:pt>
                <c:pt idx="153">
                  <c:v>6.0421800000000003E-3</c:v>
                </c:pt>
                <c:pt idx="154">
                  <c:v>7.1019799999999999E-3</c:v>
                </c:pt>
                <c:pt idx="155">
                  <c:v>8.3164800000000011E-3</c:v>
                </c:pt>
                <c:pt idx="156">
                  <c:v>9.4746900000000009E-3</c:v>
                </c:pt>
                <c:pt idx="157">
                  <c:v>1.0790589999999999E-2</c:v>
                </c:pt>
                <c:pt idx="158">
                  <c:v>1.213348E-2</c:v>
                </c:pt>
                <c:pt idx="159">
                  <c:v>1.350196E-2</c:v>
                </c:pt>
                <c:pt idx="160">
                  <c:v>1.5056590000000002E-2</c:v>
                </c:pt>
                <c:pt idx="161">
                  <c:v>1.6601319999999999E-2</c:v>
                </c:pt>
                <c:pt idx="162">
                  <c:v>1.8294520000000002E-2</c:v>
                </c:pt>
                <c:pt idx="163">
                  <c:v>2.005036E-2</c:v>
                </c:pt>
                <c:pt idx="164">
                  <c:v>2.1809569999999997E-2</c:v>
                </c:pt>
                <c:pt idx="165">
                  <c:v>2.368259E-2</c:v>
                </c:pt>
                <c:pt idx="166">
                  <c:v>2.5586350000000001E-2</c:v>
                </c:pt>
                <c:pt idx="167">
                  <c:v>2.76051E-2</c:v>
                </c:pt>
                <c:pt idx="168">
                  <c:v>2.9760749999999999E-2</c:v>
                </c:pt>
                <c:pt idx="169">
                  <c:v>3.1970770000000003E-2</c:v>
                </c:pt>
                <c:pt idx="170">
                  <c:v>3.42936E-2</c:v>
                </c:pt>
                <c:pt idx="171">
                  <c:v>3.6727870000000003E-2</c:v>
                </c:pt>
                <c:pt idx="172">
                  <c:v>3.9283459999999999E-2</c:v>
                </c:pt>
                <c:pt idx="173">
                  <c:v>4.1928910000000007E-2</c:v>
                </c:pt>
                <c:pt idx="174">
                  <c:v>4.4671990000000002E-2</c:v>
                </c:pt>
                <c:pt idx="175">
                  <c:v>4.7505519999999996E-2</c:v>
                </c:pt>
                <c:pt idx="176">
                  <c:v>5.0529560000000001E-2</c:v>
                </c:pt>
                <c:pt idx="177">
                  <c:v>5.3690839999999997E-2</c:v>
                </c:pt>
                <c:pt idx="178">
                  <c:v>5.7022959999999998E-2</c:v>
                </c:pt>
                <c:pt idx="179">
                  <c:v>6.0482570000000006E-2</c:v>
                </c:pt>
                <c:pt idx="180">
                  <c:v>6.4193609999999998E-2</c:v>
                </c:pt>
                <c:pt idx="181">
                  <c:v>6.7998530000000001E-2</c:v>
                </c:pt>
                <c:pt idx="182">
                  <c:v>7.2061810000000004E-2</c:v>
                </c:pt>
                <c:pt idx="183">
                  <c:v>7.626687E-2</c:v>
                </c:pt>
                <c:pt idx="184">
                  <c:v>8.064781E-2</c:v>
                </c:pt>
                <c:pt idx="185">
                  <c:v>8.5189580000000001E-2</c:v>
                </c:pt>
                <c:pt idx="186">
                  <c:v>8.986174999999999E-2</c:v>
                </c:pt>
                <c:pt idx="187">
                  <c:v>9.4746220000000006E-2</c:v>
                </c:pt>
                <c:pt idx="188">
                  <c:v>9.9798659999999997E-2</c:v>
                </c:pt>
                <c:pt idx="189">
                  <c:v>0.10519982</c:v>
                </c:pt>
                <c:pt idx="190">
                  <c:v>0.11066433999999999</c:v>
                </c:pt>
                <c:pt idx="191">
                  <c:v>0.11638963000000001</c:v>
                </c:pt>
                <c:pt idx="192">
                  <c:v>0.12226884</c:v>
                </c:pt>
                <c:pt idx="193">
                  <c:v>0.12831202999999999</c:v>
                </c:pt>
                <c:pt idx="194">
                  <c:v>0.13458274000000001</c:v>
                </c:pt>
                <c:pt idx="195">
                  <c:v>0.14104678000000001</c:v>
                </c:pt>
                <c:pt idx="196">
                  <c:v>0.14768456999999999</c:v>
                </c:pt>
                <c:pt idx="197">
                  <c:v>0.15465165</c:v>
                </c:pt>
                <c:pt idx="198">
                  <c:v>0.16172796</c:v>
                </c:pt>
                <c:pt idx="199">
                  <c:v>0.16892024</c:v>
                </c:pt>
                <c:pt idx="200">
                  <c:v>0.17649430999999999</c:v>
                </c:pt>
                <c:pt idx="201">
                  <c:v>0.18417280999999999</c:v>
                </c:pt>
                <c:pt idx="202">
                  <c:v>0.19197825999999998</c:v>
                </c:pt>
                <c:pt idx="203">
                  <c:v>0.19987943000000002</c:v>
                </c:pt>
                <c:pt idx="204">
                  <c:v>0.20775127000000002</c:v>
                </c:pt>
                <c:pt idx="205">
                  <c:v>0.21555599</c:v>
                </c:pt>
                <c:pt idx="206">
                  <c:v>0.22344017000000002</c:v>
                </c:pt>
                <c:pt idx="207">
                  <c:v>0.23131419</c:v>
                </c:pt>
                <c:pt idx="208">
                  <c:v>0.23922017000000001</c:v>
                </c:pt>
                <c:pt idx="209">
                  <c:v>0.24705996999999999</c:v>
                </c:pt>
                <c:pt idx="210">
                  <c:v>0.25493182999999997</c:v>
                </c:pt>
                <c:pt idx="211">
                  <c:v>0.26266518999999999</c:v>
                </c:pt>
                <c:pt idx="212">
                  <c:v>0.27041256000000002</c:v>
                </c:pt>
                <c:pt idx="213">
                  <c:v>0.27811328000000002</c:v>
                </c:pt>
                <c:pt idx="214">
                  <c:v>0.28579194999999996</c:v>
                </c:pt>
                <c:pt idx="215">
                  <c:v>0.29330087999999999</c:v>
                </c:pt>
                <c:pt idx="216">
                  <c:v>0.30079572999999998</c:v>
                </c:pt>
                <c:pt idx="217">
                  <c:v>0.30823305000000001</c:v>
                </c:pt>
                <c:pt idx="218">
                  <c:v>0.31567137000000001</c:v>
                </c:pt>
                <c:pt idx="219">
                  <c:v>0.32305428999999997</c:v>
                </c:pt>
                <c:pt idx="220">
                  <c:v>0.33041626000000002</c:v>
                </c:pt>
                <c:pt idx="221">
                  <c:v>0.33782002</c:v>
                </c:pt>
                <c:pt idx="222">
                  <c:v>0.34518222000000004</c:v>
                </c:pt>
                <c:pt idx="223">
                  <c:v>0.35262676999999998</c:v>
                </c:pt>
                <c:pt idx="224">
                  <c:v>0.36014014000000005</c:v>
                </c:pt>
                <c:pt idx="225">
                  <c:v>0.36779632000000001</c:v>
                </c:pt>
                <c:pt idx="226">
                  <c:v>0.37571066999999997</c:v>
                </c:pt>
                <c:pt idx="227">
                  <c:v>0.38391059</c:v>
                </c:pt>
                <c:pt idx="228">
                  <c:v>0.39241697999999997</c:v>
                </c:pt>
                <c:pt idx="229">
                  <c:v>0.40122031000000002</c:v>
                </c:pt>
                <c:pt idx="230">
                  <c:v>0.41056835999999997</c:v>
                </c:pt>
                <c:pt idx="231">
                  <c:v>0.42017172000000003</c:v>
                </c:pt>
                <c:pt idx="232">
                  <c:v>0.42992635000000001</c:v>
                </c:pt>
                <c:pt idx="233">
                  <c:v>0.43979246000000005</c:v>
                </c:pt>
                <c:pt idx="234">
                  <c:v>0.44955426000000004</c:v>
                </c:pt>
                <c:pt idx="235">
                  <c:v>0.45921866</c:v>
                </c:pt>
                <c:pt idx="236">
                  <c:v>0.46855454000000002</c:v>
                </c:pt>
                <c:pt idx="237">
                  <c:v>0.47734532000000002</c:v>
                </c:pt>
                <c:pt idx="238">
                  <c:v>0.48572272</c:v>
                </c:pt>
                <c:pt idx="239">
                  <c:v>0.49346559999999995</c:v>
                </c:pt>
                <c:pt idx="240">
                  <c:v>0.50068440000000003</c:v>
                </c:pt>
                <c:pt idx="241">
                  <c:v>0.50733654000000006</c:v>
                </c:pt>
                <c:pt idx="242">
                  <c:v>0.51360687999999999</c:v>
                </c:pt>
                <c:pt idx="243">
                  <c:v>0.51953033999999998</c:v>
                </c:pt>
                <c:pt idx="244">
                  <c:v>0.52536649000000002</c:v>
                </c:pt>
                <c:pt idx="245">
                  <c:v>0.53144053000000002</c:v>
                </c:pt>
                <c:pt idx="246">
                  <c:v>0.53745056000000002</c:v>
                </c:pt>
                <c:pt idx="247">
                  <c:v>0.54367902000000001</c:v>
                </c:pt>
                <c:pt idx="248">
                  <c:v>0.55016140999999996</c:v>
                </c:pt>
                <c:pt idx="249">
                  <c:v>0.55680236999999999</c:v>
                </c:pt>
                <c:pt idx="250">
                  <c:v>0.56371442000000005</c:v>
                </c:pt>
                <c:pt idx="251">
                  <c:v>0.57073934999999998</c:v>
                </c:pt>
                <c:pt idx="252">
                  <c:v>0.57775624999999997</c:v>
                </c:pt>
                <c:pt idx="253">
                  <c:v>0.58412584000000001</c:v>
                </c:pt>
                <c:pt idx="254">
                  <c:v>0.59000187999999998</c:v>
                </c:pt>
                <c:pt idx="255">
                  <c:v>0.59553873000000002</c:v>
                </c:pt>
                <c:pt idx="256">
                  <c:v>0.60027247000000006</c:v>
                </c:pt>
                <c:pt idx="257">
                  <c:v>0.60433884999999998</c:v>
                </c:pt>
                <c:pt idx="258">
                  <c:v>0.60775067000000005</c:v>
                </c:pt>
                <c:pt idx="259">
                  <c:v>0.61048046999999994</c:v>
                </c:pt>
                <c:pt idx="260">
                  <c:v>0.61260625000000002</c:v>
                </c:pt>
                <c:pt idx="261">
                  <c:v>0.61430622000000001</c:v>
                </c:pt>
                <c:pt idx="262">
                  <c:v>0.61604615000000007</c:v>
                </c:pt>
                <c:pt idx="263">
                  <c:v>0.61770373999999995</c:v>
                </c:pt>
                <c:pt idx="264">
                  <c:v>0.61947898000000001</c:v>
                </c:pt>
                <c:pt idx="265">
                  <c:v>0.62148612999999997</c:v>
                </c:pt>
                <c:pt idx="266">
                  <c:v>0.62388406000000007</c:v>
                </c:pt>
                <c:pt idx="267">
                  <c:v>0.62684386000000003</c:v>
                </c:pt>
                <c:pt idx="268">
                  <c:v>0.63017676999999994</c:v>
                </c:pt>
                <c:pt idx="269">
                  <c:v>0.63383880999999997</c:v>
                </c:pt>
                <c:pt idx="270">
                  <c:v>0.63781874000000005</c:v>
                </c:pt>
                <c:pt idx="271">
                  <c:v>0.64168023000000007</c:v>
                </c:pt>
                <c:pt idx="272">
                  <c:v>0.64538548000000007</c:v>
                </c:pt>
                <c:pt idx="273">
                  <c:v>0.64866055</c:v>
                </c:pt>
                <c:pt idx="274">
                  <c:v>0.65129478000000007</c:v>
                </c:pt>
                <c:pt idx="275">
                  <c:v>0.65307028</c:v>
                </c:pt>
                <c:pt idx="276">
                  <c:v>0.65366955000000004</c:v>
                </c:pt>
                <c:pt idx="277">
                  <c:v>0.65357792000000003</c:v>
                </c:pt>
                <c:pt idx="278">
                  <c:v>0.65267590999999991</c:v>
                </c:pt>
                <c:pt idx="279">
                  <c:v>0.65118054000000003</c:v>
                </c:pt>
                <c:pt idx="280">
                  <c:v>0.64943662999999996</c:v>
                </c:pt>
                <c:pt idx="281">
                  <c:v>0.64781674</c:v>
                </c:pt>
                <c:pt idx="282">
                  <c:v>0.64666703999999997</c:v>
                </c:pt>
                <c:pt idx="283">
                  <c:v>0.64583386000000009</c:v>
                </c:pt>
                <c:pt idx="284">
                  <c:v>0.64571306000000006</c:v>
                </c:pt>
                <c:pt idx="285">
                  <c:v>0.64636497999999998</c:v>
                </c:pt>
                <c:pt idx="286">
                  <c:v>0.64763589999999993</c:v>
                </c:pt>
                <c:pt idx="287">
                  <c:v>0.64906711000000006</c:v>
                </c:pt>
                <c:pt idx="288">
                  <c:v>0.65044584000000005</c:v>
                </c:pt>
                <c:pt idx="289">
                  <c:v>0.65155756999999992</c:v>
                </c:pt>
                <c:pt idx="290">
                  <c:v>0.65213977999999995</c:v>
                </c:pt>
                <c:pt idx="291">
                  <c:v>0.65221633999999995</c:v>
                </c:pt>
                <c:pt idx="292">
                  <c:v>0.65138722999999998</c:v>
                </c:pt>
                <c:pt idx="293">
                  <c:v>0.64959843000000006</c:v>
                </c:pt>
                <c:pt idx="294">
                  <c:v>0.64754729</c:v>
                </c:pt>
                <c:pt idx="295">
                  <c:v>0.64489633999999996</c:v>
                </c:pt>
                <c:pt idx="296">
                  <c:v>0.64231099999999997</c:v>
                </c:pt>
                <c:pt idx="297">
                  <c:v>0.63986651999999999</c:v>
                </c:pt>
                <c:pt idx="298">
                  <c:v>0.63773179000000002</c:v>
                </c:pt>
                <c:pt idx="299">
                  <c:v>0.63606043999999995</c:v>
                </c:pt>
                <c:pt idx="300">
                  <c:v>0.63494391999999999</c:v>
                </c:pt>
                <c:pt idx="301">
                  <c:v>0.63440842000000008</c:v>
                </c:pt>
                <c:pt idx="302">
                  <c:v>0.63424237999999999</c:v>
                </c:pt>
                <c:pt idx="303">
                  <c:v>0.63431766000000001</c:v>
                </c:pt>
                <c:pt idx="304">
                  <c:v>0.63428313000000003</c:v>
                </c:pt>
                <c:pt idx="305">
                  <c:v>0.63358365999999999</c:v>
                </c:pt>
                <c:pt idx="306">
                  <c:v>0.63230759000000003</c:v>
                </c:pt>
                <c:pt idx="307">
                  <c:v>0.62994466000000005</c:v>
                </c:pt>
                <c:pt idx="308">
                  <c:v>0.62655559999999999</c:v>
                </c:pt>
                <c:pt idx="309">
                  <c:v>0.62214736999999998</c:v>
                </c:pt>
                <c:pt idx="310">
                  <c:v>0.61636305999999996</c:v>
                </c:pt>
                <c:pt idx="311">
                  <c:v>0.60991241000000007</c:v>
                </c:pt>
                <c:pt idx="312">
                  <c:v>0.60315726000000003</c:v>
                </c:pt>
                <c:pt idx="313">
                  <c:v>0.59631318</c:v>
                </c:pt>
                <c:pt idx="314">
                  <c:v>0.58982027000000004</c:v>
                </c:pt>
                <c:pt idx="315">
                  <c:v>0.58386083999999994</c:v>
                </c:pt>
                <c:pt idx="316">
                  <c:v>0.57877830000000008</c:v>
                </c:pt>
                <c:pt idx="317">
                  <c:v>0.57399303999999995</c:v>
                </c:pt>
                <c:pt idx="318">
                  <c:v>0.57009363999999996</c:v>
                </c:pt>
                <c:pt idx="319">
                  <c:v>0.56650394000000004</c:v>
                </c:pt>
                <c:pt idx="320">
                  <c:v>0.56283679999999991</c:v>
                </c:pt>
                <c:pt idx="321">
                  <c:v>0.55869133999999998</c:v>
                </c:pt>
                <c:pt idx="322">
                  <c:v>0.55423113000000002</c:v>
                </c:pt>
                <c:pt idx="323">
                  <c:v>0.54901347</c:v>
                </c:pt>
                <c:pt idx="324">
                  <c:v>0.54306818000000001</c:v>
                </c:pt>
                <c:pt idx="325">
                  <c:v>0.53675001999999994</c:v>
                </c:pt>
                <c:pt idx="326">
                  <c:v>0.53010924999999998</c:v>
                </c:pt>
                <c:pt idx="327">
                  <c:v>0.52336791999999999</c:v>
                </c:pt>
                <c:pt idx="328">
                  <c:v>0.51665452000000001</c:v>
                </c:pt>
                <c:pt idx="329">
                  <c:v>0.51050980999999995</c:v>
                </c:pt>
                <c:pt idx="330">
                  <c:v>0.50443996000000002</c:v>
                </c:pt>
                <c:pt idx="331">
                  <c:v>0.49887376999999999</c:v>
                </c:pt>
                <c:pt idx="332">
                  <c:v>0.49337857000000002</c:v>
                </c:pt>
                <c:pt idx="333">
                  <c:v>0.48786357000000002</c:v>
                </c:pt>
                <c:pt idx="334">
                  <c:v>0.48190721000000003</c:v>
                </c:pt>
                <c:pt idx="335">
                  <c:v>0.47534602999999997</c:v>
                </c:pt>
                <c:pt idx="336">
                  <c:v>0.46782324000000003</c:v>
                </c:pt>
                <c:pt idx="337">
                  <c:v>0.45958886999999998</c:v>
                </c:pt>
                <c:pt idx="338">
                  <c:v>0.45034714999999997</c:v>
                </c:pt>
                <c:pt idx="339">
                  <c:v>0.44053657000000002</c:v>
                </c:pt>
                <c:pt idx="340">
                  <c:v>0.43016051</c:v>
                </c:pt>
                <c:pt idx="341">
                  <c:v>0.41948495999999996</c:v>
                </c:pt>
                <c:pt idx="342">
                  <c:v>0.40911923</c:v>
                </c:pt>
                <c:pt idx="343">
                  <c:v>0.39853580999999999</c:v>
                </c:pt>
                <c:pt idx="344">
                  <c:v>0.38759436000000003</c:v>
                </c:pt>
                <c:pt idx="345">
                  <c:v>0.37670315000000004</c:v>
                </c:pt>
                <c:pt idx="346">
                  <c:v>0.36509310999999994</c:v>
                </c:pt>
                <c:pt idx="347">
                  <c:v>0.35323104</c:v>
                </c:pt>
                <c:pt idx="348">
                  <c:v>0.34067019999999998</c:v>
                </c:pt>
                <c:pt idx="349">
                  <c:v>0.32750463000000002</c:v>
                </c:pt>
                <c:pt idx="350">
                  <c:v>0.31360129000000003</c:v>
                </c:pt>
                <c:pt idx="351">
                  <c:v>0.29954732000000001</c:v>
                </c:pt>
                <c:pt idx="352">
                  <c:v>0.28550395000000001</c:v>
                </c:pt>
                <c:pt idx="353">
                  <c:v>0.27166167000000002</c:v>
                </c:pt>
                <c:pt idx="354">
                  <c:v>0.25798768</c:v>
                </c:pt>
                <c:pt idx="355">
                  <c:v>0.24469225999999999</c:v>
                </c:pt>
                <c:pt idx="356">
                  <c:v>0.23152041000000001</c:v>
                </c:pt>
                <c:pt idx="357">
                  <c:v>0.2184818</c:v>
                </c:pt>
                <c:pt idx="358">
                  <c:v>0.20546161999999998</c:v>
                </c:pt>
                <c:pt idx="359">
                  <c:v>0.19221786999999999</c:v>
                </c:pt>
                <c:pt idx="360">
                  <c:v>0.17894338999999998</c:v>
                </c:pt>
                <c:pt idx="361">
                  <c:v>0.16592289000000002</c:v>
                </c:pt>
                <c:pt idx="362">
                  <c:v>0.15322907999999999</c:v>
                </c:pt>
                <c:pt idx="363">
                  <c:v>0.14100616999999999</c:v>
                </c:pt>
                <c:pt idx="364">
                  <c:v>0.12934120999999998</c:v>
                </c:pt>
                <c:pt idx="365">
                  <c:v>0.11835813999999999</c:v>
                </c:pt>
                <c:pt idx="366">
                  <c:v>0.10782416</c:v>
                </c:pt>
                <c:pt idx="367">
                  <c:v>9.8095389999999991E-2</c:v>
                </c:pt>
                <c:pt idx="368">
                  <c:v>8.8782949999999999E-2</c:v>
                </c:pt>
                <c:pt idx="369">
                  <c:v>8.0078029999999994E-2</c:v>
                </c:pt>
                <c:pt idx="370">
                  <c:v>7.1934159999999997E-2</c:v>
                </c:pt>
                <c:pt idx="371">
                  <c:v>6.4352279999999998E-2</c:v>
                </c:pt>
                <c:pt idx="372">
                  <c:v>5.7098329999999996E-2</c:v>
                </c:pt>
                <c:pt idx="373">
                  <c:v>4.9745419999999999E-2</c:v>
                </c:pt>
                <c:pt idx="374">
                  <c:v>4.4135350000000004E-2</c:v>
                </c:pt>
                <c:pt idx="375">
                  <c:v>3.8862969999999997E-2</c:v>
                </c:pt>
                <c:pt idx="376">
                  <c:v>3.3957189999999998E-2</c:v>
                </c:pt>
                <c:pt idx="377">
                  <c:v>2.9661900000000001E-2</c:v>
                </c:pt>
                <c:pt idx="378">
                  <c:v>2.5619659999999999E-2</c:v>
                </c:pt>
                <c:pt idx="379">
                  <c:v>2.19578E-2</c:v>
                </c:pt>
                <c:pt idx="380">
                  <c:v>1.8605510000000002E-2</c:v>
                </c:pt>
                <c:pt idx="381">
                  <c:v>1.5544659999999998E-2</c:v>
                </c:pt>
                <c:pt idx="382">
                  <c:v>1.289216E-2</c:v>
                </c:pt>
                <c:pt idx="383">
                  <c:v>1.0405599999999999E-2</c:v>
                </c:pt>
                <c:pt idx="384">
                  <c:v>8.2669200000000005E-3</c:v>
                </c:pt>
                <c:pt idx="385">
                  <c:v>6.2939199999999997E-3</c:v>
                </c:pt>
                <c:pt idx="386">
                  <c:v>4.5745100000000004E-3</c:v>
                </c:pt>
                <c:pt idx="387">
                  <c:v>3.0847400000000003E-3</c:v>
                </c:pt>
                <c:pt idx="388">
                  <c:v>1.6722699999999998E-3</c:v>
                </c:pt>
                <c:pt idx="389">
                  <c:v>4.8208000000000002E-4</c:v>
                </c:pt>
                <c:pt idx="390">
                  <c:v>-6.1242000000000002E-4</c:v>
                </c:pt>
                <c:pt idx="391">
                  <c:v>-1.53118E-3</c:v>
                </c:pt>
                <c:pt idx="392">
                  <c:v>-2.3036899999999997E-3</c:v>
                </c:pt>
                <c:pt idx="393">
                  <c:v>-3.0021199999999996E-3</c:v>
                </c:pt>
                <c:pt idx="394">
                  <c:v>-3.5586299999999997E-3</c:v>
                </c:pt>
                <c:pt idx="395">
                  <c:v>-4.08267E-3</c:v>
                </c:pt>
                <c:pt idx="396">
                  <c:v>-4.5132599999999998E-3</c:v>
                </c:pt>
                <c:pt idx="397">
                  <c:v>-4.8735899999999997E-3</c:v>
                </c:pt>
                <c:pt idx="398">
                  <c:v>-5.2120700000000001E-3</c:v>
                </c:pt>
                <c:pt idx="399">
                  <c:v>-5.4629300000000004E-3</c:v>
                </c:pt>
                <c:pt idx="400">
                  <c:v>-5.7349899999999997E-3</c:v>
                </c:pt>
                <c:pt idx="401">
                  <c:v>-5.9308599999999996E-3</c:v>
                </c:pt>
                <c:pt idx="402">
                  <c:v>-6.0824900000000003E-3</c:v>
                </c:pt>
                <c:pt idx="403">
                  <c:v>-6.2039800000000004E-3</c:v>
                </c:pt>
                <c:pt idx="404">
                  <c:v>-6.2965E-3</c:v>
                </c:pt>
                <c:pt idx="405">
                  <c:v>-6.4293900000000001E-3</c:v>
                </c:pt>
                <c:pt idx="406">
                  <c:v>-6.5064900000000002E-3</c:v>
                </c:pt>
                <c:pt idx="407">
                  <c:v>-6.5787799999999994E-3</c:v>
                </c:pt>
                <c:pt idx="408">
                  <c:v>-6.64351E-3</c:v>
                </c:pt>
                <c:pt idx="409">
                  <c:v>-6.6718999999999997E-3</c:v>
                </c:pt>
                <c:pt idx="410">
                  <c:v>-6.7154599999999995E-3</c:v>
                </c:pt>
                <c:pt idx="411">
                  <c:v>-6.7134999999999998E-3</c:v>
                </c:pt>
                <c:pt idx="412">
                  <c:v>-6.7118999999999998E-3</c:v>
                </c:pt>
                <c:pt idx="413">
                  <c:v>-6.6732400000000004E-3</c:v>
                </c:pt>
                <c:pt idx="414">
                  <c:v>-6.6456300000000005E-3</c:v>
                </c:pt>
                <c:pt idx="415">
                  <c:v>-6.6481199999999996E-3</c:v>
                </c:pt>
                <c:pt idx="416">
                  <c:v>-6.6056800000000001E-3</c:v>
                </c:pt>
                <c:pt idx="417">
                  <c:v>-6.5475799999999999E-3</c:v>
                </c:pt>
                <c:pt idx="418">
                  <c:v>-6.4560600000000004E-3</c:v>
                </c:pt>
                <c:pt idx="419">
                  <c:v>-6.3700199999999997E-3</c:v>
                </c:pt>
                <c:pt idx="420">
                  <c:v>-6.2436699999999998E-3</c:v>
                </c:pt>
                <c:pt idx="421">
                  <c:v>-6.0926399999999999E-3</c:v>
                </c:pt>
                <c:pt idx="422">
                  <c:v>-5.9773699999999992E-3</c:v>
                </c:pt>
                <c:pt idx="423">
                  <c:v>-5.8163600000000005E-3</c:v>
                </c:pt>
                <c:pt idx="424">
                  <c:v>-5.6682900000000003E-3</c:v>
                </c:pt>
                <c:pt idx="425">
                  <c:v>-5.5286599999999995E-3</c:v>
                </c:pt>
                <c:pt idx="426">
                  <c:v>-5.3677100000000004E-3</c:v>
                </c:pt>
                <c:pt idx="427">
                  <c:v>-5.2400599999999995E-3</c:v>
                </c:pt>
                <c:pt idx="428">
                  <c:v>-5.12533E-3</c:v>
                </c:pt>
                <c:pt idx="429">
                  <c:v>-5.0816300000000002E-3</c:v>
                </c:pt>
                <c:pt idx="430">
                  <c:v>-5.1369099999999997E-3</c:v>
                </c:pt>
                <c:pt idx="431">
                  <c:v>-5.3589800000000002E-3</c:v>
                </c:pt>
                <c:pt idx="432">
                  <c:v>-5.7360299999999996E-3</c:v>
                </c:pt>
                <c:pt idx="433">
                  <c:v>-6.2608799999999999E-3</c:v>
                </c:pt>
                <c:pt idx="434">
                  <c:v>-6.9310300000000004E-3</c:v>
                </c:pt>
                <c:pt idx="435">
                  <c:v>-7.5832200000000008E-3</c:v>
                </c:pt>
                <c:pt idx="436">
                  <c:v>-8.1256399999999999E-3</c:v>
                </c:pt>
                <c:pt idx="437">
                  <c:v>-8.4935900000000005E-3</c:v>
                </c:pt>
                <c:pt idx="438">
                  <c:v>-8.7044299999999991E-3</c:v>
                </c:pt>
                <c:pt idx="439">
                  <c:v>-8.7840499999999998E-3</c:v>
                </c:pt>
                <c:pt idx="440">
                  <c:v>-8.7987299999999994E-3</c:v>
                </c:pt>
                <c:pt idx="441">
                  <c:v>-8.78519E-3</c:v>
                </c:pt>
                <c:pt idx="442">
                  <c:v>-8.7568100000000003E-3</c:v>
                </c:pt>
                <c:pt idx="443">
                  <c:v>-8.7475199999999999E-3</c:v>
                </c:pt>
                <c:pt idx="444">
                  <c:v>-8.7547299999999988E-3</c:v>
                </c:pt>
                <c:pt idx="445">
                  <c:v>-8.7742299999999992E-3</c:v>
                </c:pt>
                <c:pt idx="446">
                  <c:v>-8.7939300000000001E-3</c:v>
                </c:pt>
                <c:pt idx="447">
                  <c:v>-8.7631400000000009E-3</c:v>
                </c:pt>
                <c:pt idx="448">
                  <c:v>-8.7871800000000003E-3</c:v>
                </c:pt>
                <c:pt idx="449">
                  <c:v>-8.7677700000000011E-3</c:v>
                </c:pt>
                <c:pt idx="450">
                  <c:v>-8.7767299999999999E-3</c:v>
                </c:pt>
                <c:pt idx="451">
                  <c:v>-8.7834699999999998E-3</c:v>
                </c:pt>
                <c:pt idx="452">
                  <c:v>-8.7252300000000005E-3</c:v>
                </c:pt>
                <c:pt idx="453">
                  <c:v>-8.7978500000000012E-3</c:v>
                </c:pt>
                <c:pt idx="454">
                  <c:v>-8.79688E-3</c:v>
                </c:pt>
                <c:pt idx="455">
                  <c:v>-8.8253700000000008E-3</c:v>
                </c:pt>
                <c:pt idx="456">
                  <c:v>-8.8506999999999995E-3</c:v>
                </c:pt>
                <c:pt idx="457">
                  <c:v>-8.7958499999999992E-3</c:v>
                </c:pt>
                <c:pt idx="458">
                  <c:v>-8.8293199999999999E-3</c:v>
                </c:pt>
                <c:pt idx="459">
                  <c:v>-8.7886600000000002E-3</c:v>
                </c:pt>
                <c:pt idx="460">
                  <c:v>-8.7981299999999995E-3</c:v>
                </c:pt>
                <c:pt idx="461">
                  <c:v>-8.8166700000000004E-3</c:v>
                </c:pt>
                <c:pt idx="462">
                  <c:v>-8.7733199999999994E-3</c:v>
                </c:pt>
                <c:pt idx="463">
                  <c:v>-8.8175000000000007E-3</c:v>
                </c:pt>
                <c:pt idx="464">
                  <c:v>-8.8054499999999994E-3</c:v>
                </c:pt>
                <c:pt idx="465">
                  <c:v>-8.83689E-3</c:v>
                </c:pt>
                <c:pt idx="466">
                  <c:v>-8.84536E-3</c:v>
                </c:pt>
                <c:pt idx="467">
                  <c:v>-8.80038E-3</c:v>
                </c:pt>
                <c:pt idx="468">
                  <c:v>-8.8280400000000005E-3</c:v>
                </c:pt>
                <c:pt idx="469">
                  <c:v>-8.736540000000001E-3</c:v>
                </c:pt>
                <c:pt idx="470">
                  <c:v>-8.7689700000000009E-3</c:v>
                </c:pt>
                <c:pt idx="471">
                  <c:v>-8.7981699999999993E-3</c:v>
                </c:pt>
                <c:pt idx="472">
                  <c:v>-8.7926600000000008E-3</c:v>
                </c:pt>
                <c:pt idx="473">
                  <c:v>-8.8556699999999995E-3</c:v>
                </c:pt>
                <c:pt idx="474">
                  <c:v>-8.7810300000000004E-3</c:v>
                </c:pt>
                <c:pt idx="475">
                  <c:v>-8.8358800000000008E-3</c:v>
                </c:pt>
                <c:pt idx="476">
                  <c:v>-8.8142099999999994E-3</c:v>
                </c:pt>
                <c:pt idx="477">
                  <c:v>-8.7794499999999994E-3</c:v>
                </c:pt>
                <c:pt idx="478">
                  <c:v>-8.8245800000000003E-3</c:v>
                </c:pt>
                <c:pt idx="479">
                  <c:v>-8.7774700000000008E-3</c:v>
                </c:pt>
                <c:pt idx="480">
                  <c:v>-8.8080699999999994E-3</c:v>
                </c:pt>
                <c:pt idx="481">
                  <c:v>-8.82462E-3</c:v>
                </c:pt>
                <c:pt idx="482">
                  <c:v>-8.8304100000000003E-3</c:v>
                </c:pt>
                <c:pt idx="483">
                  <c:v>-8.8569699999999987E-3</c:v>
                </c:pt>
                <c:pt idx="484">
                  <c:v>-8.8027299999999999E-3</c:v>
                </c:pt>
                <c:pt idx="485">
                  <c:v>-8.8333800000000001E-3</c:v>
                </c:pt>
                <c:pt idx="486">
                  <c:v>-8.8265900000000005E-3</c:v>
                </c:pt>
                <c:pt idx="487">
                  <c:v>-8.7973800000000005E-3</c:v>
                </c:pt>
                <c:pt idx="488">
                  <c:v>-8.8190999999999999E-3</c:v>
                </c:pt>
                <c:pt idx="489">
                  <c:v>-8.7994100000000006E-3</c:v>
                </c:pt>
                <c:pt idx="490">
                  <c:v>-8.8282599999999992E-3</c:v>
                </c:pt>
                <c:pt idx="491">
                  <c:v>-8.8334999999999993E-3</c:v>
                </c:pt>
                <c:pt idx="492">
                  <c:v>-8.84449E-3</c:v>
                </c:pt>
                <c:pt idx="493">
                  <c:v>-8.8507999999999989E-3</c:v>
                </c:pt>
                <c:pt idx="494">
                  <c:v>-8.8148199999999993E-3</c:v>
                </c:pt>
                <c:pt idx="495">
                  <c:v>-8.8141199999999999E-3</c:v>
                </c:pt>
                <c:pt idx="496">
                  <c:v>-8.8177499999999992E-3</c:v>
                </c:pt>
                <c:pt idx="497">
                  <c:v>-8.8271100000000009E-3</c:v>
                </c:pt>
                <c:pt idx="498">
                  <c:v>-8.8298700000000001E-3</c:v>
                </c:pt>
                <c:pt idx="499">
                  <c:v>-8.8192400000000008E-3</c:v>
                </c:pt>
                <c:pt idx="500">
                  <c:v>-8.84098E-3</c:v>
                </c:pt>
                <c:pt idx="501">
                  <c:v>0</c:v>
                </c:pt>
                <c:pt idx="502">
                  <c:v>0</c:v>
                </c:pt>
                <c:pt idx="503">
                  <c:v>0</c:v>
                </c:pt>
                <c:pt idx="504">
                  <c:v>0</c:v>
                </c:pt>
                <c:pt idx="505">
                  <c:v>0</c:v>
                </c:pt>
                <c:pt idx="506">
                  <c:v>0</c:v>
                </c:pt>
                <c:pt idx="507">
                  <c:v>0</c:v>
                </c:pt>
                <c:pt idx="508">
                  <c:v>0</c:v>
                </c:pt>
                <c:pt idx="509">
                  <c:v>0</c:v>
                </c:pt>
                <c:pt idx="510">
                  <c:v>0</c:v>
                </c:pt>
                <c:pt idx="511">
                  <c:v>0</c:v>
                </c:pt>
                <c:pt idx="512">
                  <c:v>0</c:v>
                </c:pt>
                <c:pt idx="513">
                  <c:v>0</c:v>
                </c:pt>
                <c:pt idx="514">
                  <c:v>0</c:v>
                </c:pt>
                <c:pt idx="515">
                  <c:v>0</c:v>
                </c:pt>
                <c:pt idx="516">
                  <c:v>0</c:v>
                </c:pt>
                <c:pt idx="517">
                  <c:v>0</c:v>
                </c:pt>
                <c:pt idx="518">
                  <c:v>0</c:v>
                </c:pt>
                <c:pt idx="519">
                  <c:v>0</c:v>
                </c:pt>
                <c:pt idx="520">
                  <c:v>0</c:v>
                </c:pt>
                <c:pt idx="521">
                  <c:v>0</c:v>
                </c:pt>
                <c:pt idx="522">
                  <c:v>0</c:v>
                </c:pt>
                <c:pt idx="523">
                  <c:v>0</c:v>
                </c:pt>
                <c:pt idx="524">
                  <c:v>0</c:v>
                </c:pt>
                <c:pt idx="525">
                  <c:v>0</c:v>
                </c:pt>
                <c:pt idx="526">
                  <c:v>0</c:v>
                </c:pt>
                <c:pt idx="527">
                  <c:v>0</c:v>
                </c:pt>
                <c:pt idx="528">
                  <c:v>0</c:v>
                </c:pt>
                <c:pt idx="529">
                  <c:v>0</c:v>
                </c:pt>
                <c:pt idx="530">
                  <c:v>0</c:v>
                </c:pt>
                <c:pt idx="531">
                  <c:v>0</c:v>
                </c:pt>
                <c:pt idx="532">
                  <c:v>0</c:v>
                </c:pt>
                <c:pt idx="533">
                  <c:v>0</c:v>
                </c:pt>
                <c:pt idx="534">
                  <c:v>0</c:v>
                </c:pt>
                <c:pt idx="535">
                  <c:v>0</c:v>
                </c:pt>
                <c:pt idx="536">
                  <c:v>0</c:v>
                </c:pt>
                <c:pt idx="537">
                  <c:v>0</c:v>
                </c:pt>
                <c:pt idx="538">
                  <c:v>0</c:v>
                </c:pt>
                <c:pt idx="539">
                  <c:v>0</c:v>
                </c:pt>
                <c:pt idx="540">
                  <c:v>0</c:v>
                </c:pt>
                <c:pt idx="541">
                  <c:v>0</c:v>
                </c:pt>
                <c:pt idx="542">
                  <c:v>0</c:v>
                </c:pt>
                <c:pt idx="543">
                  <c:v>0</c:v>
                </c:pt>
                <c:pt idx="544">
                  <c:v>0</c:v>
                </c:pt>
                <c:pt idx="545">
                  <c:v>0</c:v>
                </c:pt>
                <c:pt idx="546">
                  <c:v>0</c:v>
                </c:pt>
                <c:pt idx="547">
                  <c:v>0</c:v>
                </c:pt>
                <c:pt idx="548">
                  <c:v>0</c:v>
                </c:pt>
                <c:pt idx="549">
                  <c:v>0</c:v>
                </c:pt>
                <c:pt idx="55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1B0-420F-A730-A5A6354D5ECD}"/>
            </c:ext>
          </c:extLst>
        </c:ser>
        <c:ser>
          <c:idx val="2"/>
          <c:order val="2"/>
          <c:tx>
            <c:strRef>
              <c:f>'SPETTRI Sorgente-Filtri'!$E$1</c:f>
              <c:strCache>
                <c:ptCount val="1"/>
                <c:pt idx="0">
                  <c:v>Grey Filter</c:v>
                </c:pt>
              </c:strCache>
            </c:strRef>
          </c:tx>
          <c:spPr>
            <a:ln w="25400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xVal>
            <c:numRef>
              <c:f>'SPETTRI Sorgente-Filtri'!$A$2:$A$552</c:f>
              <c:numCache>
                <c:formatCode>General</c:formatCode>
                <c:ptCount val="551"/>
                <c:pt idx="0">
                  <c:v>750</c:v>
                </c:pt>
                <c:pt idx="1">
                  <c:v>749</c:v>
                </c:pt>
                <c:pt idx="2">
                  <c:v>748</c:v>
                </c:pt>
                <c:pt idx="3">
                  <c:v>747</c:v>
                </c:pt>
                <c:pt idx="4">
                  <c:v>746</c:v>
                </c:pt>
                <c:pt idx="5">
                  <c:v>745</c:v>
                </c:pt>
                <c:pt idx="6">
                  <c:v>744</c:v>
                </c:pt>
                <c:pt idx="7">
                  <c:v>743</c:v>
                </c:pt>
                <c:pt idx="8">
                  <c:v>742</c:v>
                </c:pt>
                <c:pt idx="9">
                  <c:v>741</c:v>
                </c:pt>
                <c:pt idx="10">
                  <c:v>740</c:v>
                </c:pt>
                <c:pt idx="11">
                  <c:v>739</c:v>
                </c:pt>
                <c:pt idx="12">
                  <c:v>738</c:v>
                </c:pt>
                <c:pt idx="13">
                  <c:v>737</c:v>
                </c:pt>
                <c:pt idx="14">
                  <c:v>736</c:v>
                </c:pt>
                <c:pt idx="15">
                  <c:v>735</c:v>
                </c:pt>
                <c:pt idx="16">
                  <c:v>734</c:v>
                </c:pt>
                <c:pt idx="17">
                  <c:v>733</c:v>
                </c:pt>
                <c:pt idx="18">
                  <c:v>732</c:v>
                </c:pt>
                <c:pt idx="19">
                  <c:v>731</c:v>
                </c:pt>
                <c:pt idx="20">
                  <c:v>730</c:v>
                </c:pt>
                <c:pt idx="21">
                  <c:v>729</c:v>
                </c:pt>
                <c:pt idx="22">
                  <c:v>728</c:v>
                </c:pt>
                <c:pt idx="23">
                  <c:v>727</c:v>
                </c:pt>
                <c:pt idx="24">
                  <c:v>726</c:v>
                </c:pt>
                <c:pt idx="25">
                  <c:v>725</c:v>
                </c:pt>
                <c:pt idx="26">
                  <c:v>724</c:v>
                </c:pt>
                <c:pt idx="27">
                  <c:v>723</c:v>
                </c:pt>
                <c:pt idx="28">
                  <c:v>722</c:v>
                </c:pt>
                <c:pt idx="29">
                  <c:v>721</c:v>
                </c:pt>
                <c:pt idx="30">
                  <c:v>720</c:v>
                </c:pt>
                <c:pt idx="31">
                  <c:v>719</c:v>
                </c:pt>
                <c:pt idx="32">
                  <c:v>718</c:v>
                </c:pt>
                <c:pt idx="33">
                  <c:v>717</c:v>
                </c:pt>
                <c:pt idx="34">
                  <c:v>716</c:v>
                </c:pt>
                <c:pt idx="35">
                  <c:v>715</c:v>
                </c:pt>
                <c:pt idx="36">
                  <c:v>714</c:v>
                </c:pt>
                <c:pt idx="37">
                  <c:v>713</c:v>
                </c:pt>
                <c:pt idx="38">
                  <c:v>712</c:v>
                </c:pt>
                <c:pt idx="39">
                  <c:v>711</c:v>
                </c:pt>
                <c:pt idx="40">
                  <c:v>710</c:v>
                </c:pt>
                <c:pt idx="41">
                  <c:v>709</c:v>
                </c:pt>
                <c:pt idx="42">
                  <c:v>708</c:v>
                </c:pt>
                <c:pt idx="43">
                  <c:v>707</c:v>
                </c:pt>
                <c:pt idx="44">
                  <c:v>706</c:v>
                </c:pt>
                <c:pt idx="45">
                  <c:v>705</c:v>
                </c:pt>
                <c:pt idx="46">
                  <c:v>704</c:v>
                </c:pt>
                <c:pt idx="47">
                  <c:v>703</c:v>
                </c:pt>
                <c:pt idx="48">
                  <c:v>702</c:v>
                </c:pt>
                <c:pt idx="49">
                  <c:v>701</c:v>
                </c:pt>
                <c:pt idx="50">
                  <c:v>700</c:v>
                </c:pt>
                <c:pt idx="51">
                  <c:v>699</c:v>
                </c:pt>
                <c:pt idx="52">
                  <c:v>698</c:v>
                </c:pt>
                <c:pt idx="53">
                  <c:v>697</c:v>
                </c:pt>
                <c:pt idx="54">
                  <c:v>696</c:v>
                </c:pt>
                <c:pt idx="55">
                  <c:v>695</c:v>
                </c:pt>
                <c:pt idx="56">
                  <c:v>694</c:v>
                </c:pt>
                <c:pt idx="57">
                  <c:v>693</c:v>
                </c:pt>
                <c:pt idx="58">
                  <c:v>692</c:v>
                </c:pt>
                <c:pt idx="59">
                  <c:v>691</c:v>
                </c:pt>
                <c:pt idx="60">
                  <c:v>690</c:v>
                </c:pt>
                <c:pt idx="61">
                  <c:v>689</c:v>
                </c:pt>
                <c:pt idx="62">
                  <c:v>688</c:v>
                </c:pt>
                <c:pt idx="63">
                  <c:v>687</c:v>
                </c:pt>
                <c:pt idx="64">
                  <c:v>686</c:v>
                </c:pt>
                <c:pt idx="65">
                  <c:v>685</c:v>
                </c:pt>
                <c:pt idx="66">
                  <c:v>684</c:v>
                </c:pt>
                <c:pt idx="67">
                  <c:v>683</c:v>
                </c:pt>
                <c:pt idx="68">
                  <c:v>682</c:v>
                </c:pt>
                <c:pt idx="69">
                  <c:v>681</c:v>
                </c:pt>
                <c:pt idx="70">
                  <c:v>680</c:v>
                </c:pt>
                <c:pt idx="71">
                  <c:v>679</c:v>
                </c:pt>
                <c:pt idx="72">
                  <c:v>678</c:v>
                </c:pt>
                <c:pt idx="73">
                  <c:v>677</c:v>
                </c:pt>
                <c:pt idx="74">
                  <c:v>676</c:v>
                </c:pt>
                <c:pt idx="75">
                  <c:v>675</c:v>
                </c:pt>
                <c:pt idx="76">
                  <c:v>674</c:v>
                </c:pt>
                <c:pt idx="77">
                  <c:v>673</c:v>
                </c:pt>
                <c:pt idx="78">
                  <c:v>672</c:v>
                </c:pt>
                <c:pt idx="79">
                  <c:v>671</c:v>
                </c:pt>
                <c:pt idx="80">
                  <c:v>670</c:v>
                </c:pt>
                <c:pt idx="81">
                  <c:v>669</c:v>
                </c:pt>
                <c:pt idx="82">
                  <c:v>668</c:v>
                </c:pt>
                <c:pt idx="83">
                  <c:v>667</c:v>
                </c:pt>
                <c:pt idx="84">
                  <c:v>666</c:v>
                </c:pt>
                <c:pt idx="85">
                  <c:v>665</c:v>
                </c:pt>
                <c:pt idx="86">
                  <c:v>664</c:v>
                </c:pt>
                <c:pt idx="87">
                  <c:v>663</c:v>
                </c:pt>
                <c:pt idx="88">
                  <c:v>662</c:v>
                </c:pt>
                <c:pt idx="89">
                  <c:v>661</c:v>
                </c:pt>
                <c:pt idx="90">
                  <c:v>660</c:v>
                </c:pt>
                <c:pt idx="91">
                  <c:v>659</c:v>
                </c:pt>
                <c:pt idx="92">
                  <c:v>658</c:v>
                </c:pt>
                <c:pt idx="93">
                  <c:v>657</c:v>
                </c:pt>
                <c:pt idx="94">
                  <c:v>656</c:v>
                </c:pt>
                <c:pt idx="95">
                  <c:v>655</c:v>
                </c:pt>
                <c:pt idx="96">
                  <c:v>654</c:v>
                </c:pt>
                <c:pt idx="97">
                  <c:v>653</c:v>
                </c:pt>
                <c:pt idx="98">
                  <c:v>652</c:v>
                </c:pt>
                <c:pt idx="99">
                  <c:v>651</c:v>
                </c:pt>
                <c:pt idx="100">
                  <c:v>650</c:v>
                </c:pt>
                <c:pt idx="101">
                  <c:v>649</c:v>
                </c:pt>
                <c:pt idx="102">
                  <c:v>648</c:v>
                </c:pt>
                <c:pt idx="103">
                  <c:v>647</c:v>
                </c:pt>
                <c:pt idx="104">
                  <c:v>646</c:v>
                </c:pt>
                <c:pt idx="105">
                  <c:v>645</c:v>
                </c:pt>
                <c:pt idx="106">
                  <c:v>644</c:v>
                </c:pt>
                <c:pt idx="107">
                  <c:v>643</c:v>
                </c:pt>
                <c:pt idx="108">
                  <c:v>642</c:v>
                </c:pt>
                <c:pt idx="109">
                  <c:v>641</c:v>
                </c:pt>
                <c:pt idx="110">
                  <c:v>640</c:v>
                </c:pt>
                <c:pt idx="111">
                  <c:v>639</c:v>
                </c:pt>
                <c:pt idx="112">
                  <c:v>638</c:v>
                </c:pt>
                <c:pt idx="113">
                  <c:v>637</c:v>
                </c:pt>
                <c:pt idx="114">
                  <c:v>636</c:v>
                </c:pt>
                <c:pt idx="115">
                  <c:v>635</c:v>
                </c:pt>
                <c:pt idx="116">
                  <c:v>634</c:v>
                </c:pt>
                <c:pt idx="117">
                  <c:v>633</c:v>
                </c:pt>
                <c:pt idx="118">
                  <c:v>632</c:v>
                </c:pt>
                <c:pt idx="119">
                  <c:v>631</c:v>
                </c:pt>
                <c:pt idx="120">
                  <c:v>630</c:v>
                </c:pt>
                <c:pt idx="121">
                  <c:v>629</c:v>
                </c:pt>
                <c:pt idx="122">
                  <c:v>628</c:v>
                </c:pt>
                <c:pt idx="123">
                  <c:v>627</c:v>
                </c:pt>
                <c:pt idx="124">
                  <c:v>626</c:v>
                </c:pt>
                <c:pt idx="125">
                  <c:v>625</c:v>
                </c:pt>
                <c:pt idx="126">
                  <c:v>624</c:v>
                </c:pt>
                <c:pt idx="127">
                  <c:v>623</c:v>
                </c:pt>
                <c:pt idx="128">
                  <c:v>622</c:v>
                </c:pt>
                <c:pt idx="129">
                  <c:v>621</c:v>
                </c:pt>
                <c:pt idx="130">
                  <c:v>620</c:v>
                </c:pt>
                <c:pt idx="131">
                  <c:v>619</c:v>
                </c:pt>
                <c:pt idx="132">
                  <c:v>618</c:v>
                </c:pt>
                <c:pt idx="133">
                  <c:v>617</c:v>
                </c:pt>
                <c:pt idx="134">
                  <c:v>616</c:v>
                </c:pt>
                <c:pt idx="135">
                  <c:v>615</c:v>
                </c:pt>
                <c:pt idx="136">
                  <c:v>614</c:v>
                </c:pt>
                <c:pt idx="137">
                  <c:v>613</c:v>
                </c:pt>
                <c:pt idx="138">
                  <c:v>612</c:v>
                </c:pt>
                <c:pt idx="139">
                  <c:v>611</c:v>
                </c:pt>
                <c:pt idx="140">
                  <c:v>610</c:v>
                </c:pt>
                <c:pt idx="141">
                  <c:v>609</c:v>
                </c:pt>
                <c:pt idx="142">
                  <c:v>608</c:v>
                </c:pt>
                <c:pt idx="143">
                  <c:v>607</c:v>
                </c:pt>
                <c:pt idx="144">
                  <c:v>606</c:v>
                </c:pt>
                <c:pt idx="145">
                  <c:v>605</c:v>
                </c:pt>
                <c:pt idx="146">
                  <c:v>604</c:v>
                </c:pt>
                <c:pt idx="147">
                  <c:v>603</c:v>
                </c:pt>
                <c:pt idx="148">
                  <c:v>602</c:v>
                </c:pt>
                <c:pt idx="149">
                  <c:v>601</c:v>
                </c:pt>
                <c:pt idx="150">
                  <c:v>600</c:v>
                </c:pt>
                <c:pt idx="151">
                  <c:v>599</c:v>
                </c:pt>
                <c:pt idx="152">
                  <c:v>598</c:v>
                </c:pt>
                <c:pt idx="153">
                  <c:v>597</c:v>
                </c:pt>
                <c:pt idx="154">
                  <c:v>596</c:v>
                </c:pt>
                <c:pt idx="155">
                  <c:v>595</c:v>
                </c:pt>
                <c:pt idx="156">
                  <c:v>594</c:v>
                </c:pt>
                <c:pt idx="157">
                  <c:v>593</c:v>
                </c:pt>
                <c:pt idx="158">
                  <c:v>592</c:v>
                </c:pt>
                <c:pt idx="159">
                  <c:v>591</c:v>
                </c:pt>
                <c:pt idx="160">
                  <c:v>590</c:v>
                </c:pt>
                <c:pt idx="161">
                  <c:v>589</c:v>
                </c:pt>
                <c:pt idx="162">
                  <c:v>588</c:v>
                </c:pt>
                <c:pt idx="163">
                  <c:v>587</c:v>
                </c:pt>
                <c:pt idx="164">
                  <c:v>586</c:v>
                </c:pt>
                <c:pt idx="165">
                  <c:v>585</c:v>
                </c:pt>
                <c:pt idx="166">
                  <c:v>584</c:v>
                </c:pt>
                <c:pt idx="167">
                  <c:v>583</c:v>
                </c:pt>
                <c:pt idx="168">
                  <c:v>582</c:v>
                </c:pt>
                <c:pt idx="169">
                  <c:v>581</c:v>
                </c:pt>
                <c:pt idx="170">
                  <c:v>580</c:v>
                </c:pt>
                <c:pt idx="171">
                  <c:v>579</c:v>
                </c:pt>
                <c:pt idx="172">
                  <c:v>578</c:v>
                </c:pt>
                <c:pt idx="173">
                  <c:v>577</c:v>
                </c:pt>
                <c:pt idx="174">
                  <c:v>576</c:v>
                </c:pt>
                <c:pt idx="175">
                  <c:v>575</c:v>
                </c:pt>
                <c:pt idx="176">
                  <c:v>574</c:v>
                </c:pt>
                <c:pt idx="177">
                  <c:v>573</c:v>
                </c:pt>
                <c:pt idx="178">
                  <c:v>572</c:v>
                </c:pt>
                <c:pt idx="179">
                  <c:v>571</c:v>
                </c:pt>
                <c:pt idx="180">
                  <c:v>570</c:v>
                </c:pt>
                <c:pt idx="181">
                  <c:v>569</c:v>
                </c:pt>
                <c:pt idx="182">
                  <c:v>568</c:v>
                </c:pt>
                <c:pt idx="183">
                  <c:v>567</c:v>
                </c:pt>
                <c:pt idx="184">
                  <c:v>566</c:v>
                </c:pt>
                <c:pt idx="185">
                  <c:v>565</c:v>
                </c:pt>
                <c:pt idx="186">
                  <c:v>564</c:v>
                </c:pt>
                <c:pt idx="187">
                  <c:v>563</c:v>
                </c:pt>
                <c:pt idx="188">
                  <c:v>562</c:v>
                </c:pt>
                <c:pt idx="189">
                  <c:v>561</c:v>
                </c:pt>
                <c:pt idx="190">
                  <c:v>560</c:v>
                </c:pt>
                <c:pt idx="191">
                  <c:v>559</c:v>
                </c:pt>
                <c:pt idx="192">
                  <c:v>558</c:v>
                </c:pt>
                <c:pt idx="193">
                  <c:v>557</c:v>
                </c:pt>
                <c:pt idx="194">
                  <c:v>556</c:v>
                </c:pt>
                <c:pt idx="195">
                  <c:v>555</c:v>
                </c:pt>
                <c:pt idx="196">
                  <c:v>554</c:v>
                </c:pt>
                <c:pt idx="197">
                  <c:v>553</c:v>
                </c:pt>
                <c:pt idx="198">
                  <c:v>552</c:v>
                </c:pt>
                <c:pt idx="199">
                  <c:v>551</c:v>
                </c:pt>
                <c:pt idx="200">
                  <c:v>550</c:v>
                </c:pt>
                <c:pt idx="201">
                  <c:v>549</c:v>
                </c:pt>
                <c:pt idx="202">
                  <c:v>548</c:v>
                </c:pt>
                <c:pt idx="203">
                  <c:v>547</c:v>
                </c:pt>
                <c:pt idx="204">
                  <c:v>546</c:v>
                </c:pt>
                <c:pt idx="205">
                  <c:v>545</c:v>
                </c:pt>
                <c:pt idx="206">
                  <c:v>544</c:v>
                </c:pt>
                <c:pt idx="207">
                  <c:v>543</c:v>
                </c:pt>
                <c:pt idx="208">
                  <c:v>542</c:v>
                </c:pt>
                <c:pt idx="209">
                  <c:v>541</c:v>
                </c:pt>
                <c:pt idx="210">
                  <c:v>540</c:v>
                </c:pt>
                <c:pt idx="211">
                  <c:v>539</c:v>
                </c:pt>
                <c:pt idx="212">
                  <c:v>538</c:v>
                </c:pt>
                <c:pt idx="213">
                  <c:v>537</c:v>
                </c:pt>
                <c:pt idx="214">
                  <c:v>536</c:v>
                </c:pt>
                <c:pt idx="215">
                  <c:v>535</c:v>
                </c:pt>
                <c:pt idx="216">
                  <c:v>534</c:v>
                </c:pt>
                <c:pt idx="217">
                  <c:v>533</c:v>
                </c:pt>
                <c:pt idx="218">
                  <c:v>532</c:v>
                </c:pt>
                <c:pt idx="219">
                  <c:v>531</c:v>
                </c:pt>
                <c:pt idx="220">
                  <c:v>530</c:v>
                </c:pt>
                <c:pt idx="221">
                  <c:v>529</c:v>
                </c:pt>
                <c:pt idx="222">
                  <c:v>528</c:v>
                </c:pt>
                <c:pt idx="223">
                  <c:v>527</c:v>
                </c:pt>
                <c:pt idx="224">
                  <c:v>526</c:v>
                </c:pt>
                <c:pt idx="225">
                  <c:v>525</c:v>
                </c:pt>
                <c:pt idx="226">
                  <c:v>524</c:v>
                </c:pt>
                <c:pt idx="227">
                  <c:v>523</c:v>
                </c:pt>
                <c:pt idx="228">
                  <c:v>522</c:v>
                </c:pt>
                <c:pt idx="229">
                  <c:v>521</c:v>
                </c:pt>
                <c:pt idx="230">
                  <c:v>520</c:v>
                </c:pt>
                <c:pt idx="231">
                  <c:v>519</c:v>
                </c:pt>
                <c:pt idx="232">
                  <c:v>518</c:v>
                </c:pt>
                <c:pt idx="233">
                  <c:v>517</c:v>
                </c:pt>
                <c:pt idx="234">
                  <c:v>516</c:v>
                </c:pt>
                <c:pt idx="235">
                  <c:v>515</c:v>
                </c:pt>
                <c:pt idx="236">
                  <c:v>514</c:v>
                </c:pt>
                <c:pt idx="237">
                  <c:v>513</c:v>
                </c:pt>
                <c:pt idx="238">
                  <c:v>512</c:v>
                </c:pt>
                <c:pt idx="239">
                  <c:v>511</c:v>
                </c:pt>
                <c:pt idx="240">
                  <c:v>510</c:v>
                </c:pt>
                <c:pt idx="241">
                  <c:v>509</c:v>
                </c:pt>
                <c:pt idx="242">
                  <c:v>508</c:v>
                </c:pt>
                <c:pt idx="243">
                  <c:v>507</c:v>
                </c:pt>
                <c:pt idx="244">
                  <c:v>506</c:v>
                </c:pt>
                <c:pt idx="245">
                  <c:v>505</c:v>
                </c:pt>
                <c:pt idx="246">
                  <c:v>504</c:v>
                </c:pt>
                <c:pt idx="247">
                  <c:v>503</c:v>
                </c:pt>
                <c:pt idx="248">
                  <c:v>502</c:v>
                </c:pt>
                <c:pt idx="249">
                  <c:v>501</c:v>
                </c:pt>
                <c:pt idx="250">
                  <c:v>500</c:v>
                </c:pt>
                <c:pt idx="251">
                  <c:v>499</c:v>
                </c:pt>
                <c:pt idx="252">
                  <c:v>498</c:v>
                </c:pt>
                <c:pt idx="253">
                  <c:v>497</c:v>
                </c:pt>
                <c:pt idx="254">
                  <c:v>496</c:v>
                </c:pt>
                <c:pt idx="255">
                  <c:v>495</c:v>
                </c:pt>
                <c:pt idx="256">
                  <c:v>494</c:v>
                </c:pt>
                <c:pt idx="257">
                  <c:v>493</c:v>
                </c:pt>
                <c:pt idx="258">
                  <c:v>492</c:v>
                </c:pt>
                <c:pt idx="259">
                  <c:v>491</c:v>
                </c:pt>
                <c:pt idx="260">
                  <c:v>490</c:v>
                </c:pt>
                <c:pt idx="261">
                  <c:v>489</c:v>
                </c:pt>
                <c:pt idx="262">
                  <c:v>488</c:v>
                </c:pt>
                <c:pt idx="263">
                  <c:v>487</c:v>
                </c:pt>
                <c:pt idx="264">
                  <c:v>486</c:v>
                </c:pt>
                <c:pt idx="265">
                  <c:v>485</c:v>
                </c:pt>
                <c:pt idx="266">
                  <c:v>484</c:v>
                </c:pt>
                <c:pt idx="267">
                  <c:v>483</c:v>
                </c:pt>
                <c:pt idx="268">
                  <c:v>482</c:v>
                </c:pt>
                <c:pt idx="269">
                  <c:v>481</c:v>
                </c:pt>
                <c:pt idx="270">
                  <c:v>480</c:v>
                </c:pt>
                <c:pt idx="271">
                  <c:v>479</c:v>
                </c:pt>
                <c:pt idx="272">
                  <c:v>478</c:v>
                </c:pt>
                <c:pt idx="273">
                  <c:v>477</c:v>
                </c:pt>
                <c:pt idx="274">
                  <c:v>476</c:v>
                </c:pt>
                <c:pt idx="275">
                  <c:v>475</c:v>
                </c:pt>
                <c:pt idx="276">
                  <c:v>474</c:v>
                </c:pt>
                <c:pt idx="277">
                  <c:v>473</c:v>
                </c:pt>
                <c:pt idx="278">
                  <c:v>472</c:v>
                </c:pt>
                <c:pt idx="279">
                  <c:v>471</c:v>
                </c:pt>
                <c:pt idx="280">
                  <c:v>470</c:v>
                </c:pt>
                <c:pt idx="281">
                  <c:v>469</c:v>
                </c:pt>
                <c:pt idx="282">
                  <c:v>468</c:v>
                </c:pt>
                <c:pt idx="283">
                  <c:v>467</c:v>
                </c:pt>
                <c:pt idx="284">
                  <c:v>466</c:v>
                </c:pt>
                <c:pt idx="285">
                  <c:v>465</c:v>
                </c:pt>
                <c:pt idx="286">
                  <c:v>464</c:v>
                </c:pt>
                <c:pt idx="287">
                  <c:v>463</c:v>
                </c:pt>
                <c:pt idx="288">
                  <c:v>462</c:v>
                </c:pt>
                <c:pt idx="289">
                  <c:v>461</c:v>
                </c:pt>
                <c:pt idx="290">
                  <c:v>460</c:v>
                </c:pt>
                <c:pt idx="291">
                  <c:v>459</c:v>
                </c:pt>
                <c:pt idx="292">
                  <c:v>458</c:v>
                </c:pt>
                <c:pt idx="293">
                  <c:v>457</c:v>
                </c:pt>
                <c:pt idx="294">
                  <c:v>456</c:v>
                </c:pt>
                <c:pt idx="295">
                  <c:v>455</c:v>
                </c:pt>
                <c:pt idx="296">
                  <c:v>454</c:v>
                </c:pt>
                <c:pt idx="297">
                  <c:v>453</c:v>
                </c:pt>
                <c:pt idx="298">
                  <c:v>452</c:v>
                </c:pt>
                <c:pt idx="299">
                  <c:v>451</c:v>
                </c:pt>
                <c:pt idx="300">
                  <c:v>450</c:v>
                </c:pt>
                <c:pt idx="301">
                  <c:v>449</c:v>
                </c:pt>
                <c:pt idx="302">
                  <c:v>448</c:v>
                </c:pt>
                <c:pt idx="303">
                  <c:v>447</c:v>
                </c:pt>
                <c:pt idx="304">
                  <c:v>446</c:v>
                </c:pt>
                <c:pt idx="305">
                  <c:v>445</c:v>
                </c:pt>
                <c:pt idx="306">
                  <c:v>444</c:v>
                </c:pt>
                <c:pt idx="307">
                  <c:v>443</c:v>
                </c:pt>
                <c:pt idx="308">
                  <c:v>442</c:v>
                </c:pt>
                <c:pt idx="309">
                  <c:v>441</c:v>
                </c:pt>
                <c:pt idx="310">
                  <c:v>440</c:v>
                </c:pt>
                <c:pt idx="311">
                  <c:v>439</c:v>
                </c:pt>
                <c:pt idx="312">
                  <c:v>438</c:v>
                </c:pt>
                <c:pt idx="313">
                  <c:v>437</c:v>
                </c:pt>
                <c:pt idx="314">
                  <c:v>436</c:v>
                </c:pt>
                <c:pt idx="315">
                  <c:v>435</c:v>
                </c:pt>
                <c:pt idx="316">
                  <c:v>434</c:v>
                </c:pt>
                <c:pt idx="317">
                  <c:v>433</c:v>
                </c:pt>
                <c:pt idx="318">
                  <c:v>432</c:v>
                </c:pt>
                <c:pt idx="319">
                  <c:v>431</c:v>
                </c:pt>
                <c:pt idx="320">
                  <c:v>430</c:v>
                </c:pt>
                <c:pt idx="321">
                  <c:v>429</c:v>
                </c:pt>
                <c:pt idx="322">
                  <c:v>428</c:v>
                </c:pt>
                <c:pt idx="323">
                  <c:v>427</c:v>
                </c:pt>
                <c:pt idx="324">
                  <c:v>426</c:v>
                </c:pt>
                <c:pt idx="325">
                  <c:v>425</c:v>
                </c:pt>
                <c:pt idx="326">
                  <c:v>424</c:v>
                </c:pt>
                <c:pt idx="327">
                  <c:v>423</c:v>
                </c:pt>
                <c:pt idx="328">
                  <c:v>422</c:v>
                </c:pt>
                <c:pt idx="329">
                  <c:v>421</c:v>
                </c:pt>
                <c:pt idx="330">
                  <c:v>420</c:v>
                </c:pt>
                <c:pt idx="331">
                  <c:v>419</c:v>
                </c:pt>
                <c:pt idx="332">
                  <c:v>418</c:v>
                </c:pt>
                <c:pt idx="333">
                  <c:v>417</c:v>
                </c:pt>
                <c:pt idx="334">
                  <c:v>416</c:v>
                </c:pt>
                <c:pt idx="335">
                  <c:v>415</c:v>
                </c:pt>
                <c:pt idx="336">
                  <c:v>414</c:v>
                </c:pt>
                <c:pt idx="337">
                  <c:v>413</c:v>
                </c:pt>
                <c:pt idx="338">
                  <c:v>412</c:v>
                </c:pt>
                <c:pt idx="339">
                  <c:v>411</c:v>
                </c:pt>
                <c:pt idx="340">
                  <c:v>410</c:v>
                </c:pt>
                <c:pt idx="341">
                  <c:v>409</c:v>
                </c:pt>
                <c:pt idx="342">
                  <c:v>408</c:v>
                </c:pt>
                <c:pt idx="343">
                  <c:v>407</c:v>
                </c:pt>
                <c:pt idx="344">
                  <c:v>406</c:v>
                </c:pt>
                <c:pt idx="345">
                  <c:v>405</c:v>
                </c:pt>
                <c:pt idx="346">
                  <c:v>404</c:v>
                </c:pt>
                <c:pt idx="347">
                  <c:v>403</c:v>
                </c:pt>
                <c:pt idx="348">
                  <c:v>402</c:v>
                </c:pt>
                <c:pt idx="349">
                  <c:v>401</c:v>
                </c:pt>
                <c:pt idx="350">
                  <c:v>400</c:v>
                </c:pt>
                <c:pt idx="351">
                  <c:v>399</c:v>
                </c:pt>
                <c:pt idx="352">
                  <c:v>398</c:v>
                </c:pt>
                <c:pt idx="353">
                  <c:v>397</c:v>
                </c:pt>
                <c:pt idx="354">
                  <c:v>396</c:v>
                </c:pt>
                <c:pt idx="355">
                  <c:v>395</c:v>
                </c:pt>
                <c:pt idx="356">
                  <c:v>394</c:v>
                </c:pt>
                <c:pt idx="357">
                  <c:v>393</c:v>
                </c:pt>
                <c:pt idx="358">
                  <c:v>392</c:v>
                </c:pt>
                <c:pt idx="359">
                  <c:v>391</c:v>
                </c:pt>
                <c:pt idx="360">
                  <c:v>390</c:v>
                </c:pt>
                <c:pt idx="361">
                  <c:v>389</c:v>
                </c:pt>
                <c:pt idx="362">
                  <c:v>388</c:v>
                </c:pt>
                <c:pt idx="363">
                  <c:v>387</c:v>
                </c:pt>
                <c:pt idx="364">
                  <c:v>386</c:v>
                </c:pt>
                <c:pt idx="365">
                  <c:v>385</c:v>
                </c:pt>
                <c:pt idx="366">
                  <c:v>384</c:v>
                </c:pt>
                <c:pt idx="367">
                  <c:v>383</c:v>
                </c:pt>
                <c:pt idx="368">
                  <c:v>382</c:v>
                </c:pt>
                <c:pt idx="369">
                  <c:v>381</c:v>
                </c:pt>
                <c:pt idx="370">
                  <c:v>380</c:v>
                </c:pt>
                <c:pt idx="371">
                  <c:v>379</c:v>
                </c:pt>
                <c:pt idx="372">
                  <c:v>378</c:v>
                </c:pt>
                <c:pt idx="373">
                  <c:v>377</c:v>
                </c:pt>
                <c:pt idx="374">
                  <c:v>376</c:v>
                </c:pt>
                <c:pt idx="375">
                  <c:v>375</c:v>
                </c:pt>
                <c:pt idx="376">
                  <c:v>374</c:v>
                </c:pt>
                <c:pt idx="377">
                  <c:v>373</c:v>
                </c:pt>
                <c:pt idx="378">
                  <c:v>372</c:v>
                </c:pt>
                <c:pt idx="379">
                  <c:v>371</c:v>
                </c:pt>
                <c:pt idx="380">
                  <c:v>370</c:v>
                </c:pt>
                <c:pt idx="381">
                  <c:v>369</c:v>
                </c:pt>
                <c:pt idx="382">
                  <c:v>368</c:v>
                </c:pt>
                <c:pt idx="383">
                  <c:v>367</c:v>
                </c:pt>
                <c:pt idx="384">
                  <c:v>366</c:v>
                </c:pt>
                <c:pt idx="385">
                  <c:v>365</c:v>
                </c:pt>
                <c:pt idx="386">
                  <c:v>364</c:v>
                </c:pt>
                <c:pt idx="387">
                  <c:v>363</c:v>
                </c:pt>
                <c:pt idx="388">
                  <c:v>362</c:v>
                </c:pt>
                <c:pt idx="389">
                  <c:v>361</c:v>
                </c:pt>
                <c:pt idx="390">
                  <c:v>360</c:v>
                </c:pt>
                <c:pt idx="391">
                  <c:v>359</c:v>
                </c:pt>
                <c:pt idx="392">
                  <c:v>358</c:v>
                </c:pt>
                <c:pt idx="393">
                  <c:v>357</c:v>
                </c:pt>
                <c:pt idx="394">
                  <c:v>356</c:v>
                </c:pt>
                <c:pt idx="395">
                  <c:v>355</c:v>
                </c:pt>
                <c:pt idx="396">
                  <c:v>354</c:v>
                </c:pt>
                <c:pt idx="397">
                  <c:v>353</c:v>
                </c:pt>
                <c:pt idx="398">
                  <c:v>352</c:v>
                </c:pt>
                <c:pt idx="399">
                  <c:v>351</c:v>
                </c:pt>
                <c:pt idx="400">
                  <c:v>350</c:v>
                </c:pt>
                <c:pt idx="401">
                  <c:v>349</c:v>
                </c:pt>
                <c:pt idx="402">
                  <c:v>348</c:v>
                </c:pt>
                <c:pt idx="403">
                  <c:v>347</c:v>
                </c:pt>
                <c:pt idx="404">
                  <c:v>346</c:v>
                </c:pt>
                <c:pt idx="405">
                  <c:v>345</c:v>
                </c:pt>
                <c:pt idx="406">
                  <c:v>344</c:v>
                </c:pt>
                <c:pt idx="407">
                  <c:v>343</c:v>
                </c:pt>
                <c:pt idx="408">
                  <c:v>342</c:v>
                </c:pt>
                <c:pt idx="409">
                  <c:v>341</c:v>
                </c:pt>
                <c:pt idx="410">
                  <c:v>340</c:v>
                </c:pt>
                <c:pt idx="411">
                  <c:v>339</c:v>
                </c:pt>
                <c:pt idx="412">
                  <c:v>338</c:v>
                </c:pt>
                <c:pt idx="413">
                  <c:v>337</c:v>
                </c:pt>
                <c:pt idx="414">
                  <c:v>336</c:v>
                </c:pt>
                <c:pt idx="415">
                  <c:v>335</c:v>
                </c:pt>
                <c:pt idx="416">
                  <c:v>334</c:v>
                </c:pt>
                <c:pt idx="417">
                  <c:v>333</c:v>
                </c:pt>
                <c:pt idx="418">
                  <c:v>332</c:v>
                </c:pt>
                <c:pt idx="419">
                  <c:v>331</c:v>
                </c:pt>
                <c:pt idx="420">
                  <c:v>330</c:v>
                </c:pt>
                <c:pt idx="421">
                  <c:v>329</c:v>
                </c:pt>
                <c:pt idx="422">
                  <c:v>328</c:v>
                </c:pt>
                <c:pt idx="423">
                  <c:v>327</c:v>
                </c:pt>
                <c:pt idx="424">
                  <c:v>326</c:v>
                </c:pt>
                <c:pt idx="425">
                  <c:v>325</c:v>
                </c:pt>
                <c:pt idx="426">
                  <c:v>324</c:v>
                </c:pt>
                <c:pt idx="427">
                  <c:v>323</c:v>
                </c:pt>
                <c:pt idx="428">
                  <c:v>322</c:v>
                </c:pt>
                <c:pt idx="429">
                  <c:v>321</c:v>
                </c:pt>
                <c:pt idx="430">
                  <c:v>320</c:v>
                </c:pt>
                <c:pt idx="431">
                  <c:v>319</c:v>
                </c:pt>
                <c:pt idx="432">
                  <c:v>318</c:v>
                </c:pt>
                <c:pt idx="433">
                  <c:v>317</c:v>
                </c:pt>
                <c:pt idx="434">
                  <c:v>316</c:v>
                </c:pt>
                <c:pt idx="435">
                  <c:v>315</c:v>
                </c:pt>
                <c:pt idx="436">
                  <c:v>314</c:v>
                </c:pt>
                <c:pt idx="437">
                  <c:v>313</c:v>
                </c:pt>
                <c:pt idx="438">
                  <c:v>312</c:v>
                </c:pt>
                <c:pt idx="439">
                  <c:v>311</c:v>
                </c:pt>
                <c:pt idx="440">
                  <c:v>310</c:v>
                </c:pt>
                <c:pt idx="441">
                  <c:v>309</c:v>
                </c:pt>
                <c:pt idx="442">
                  <c:v>308</c:v>
                </c:pt>
                <c:pt idx="443">
                  <c:v>307</c:v>
                </c:pt>
                <c:pt idx="444">
                  <c:v>306</c:v>
                </c:pt>
                <c:pt idx="445">
                  <c:v>305</c:v>
                </c:pt>
                <c:pt idx="446">
                  <c:v>304</c:v>
                </c:pt>
                <c:pt idx="447">
                  <c:v>303</c:v>
                </c:pt>
                <c:pt idx="448">
                  <c:v>302</c:v>
                </c:pt>
                <c:pt idx="449">
                  <c:v>301</c:v>
                </c:pt>
                <c:pt idx="450">
                  <c:v>300</c:v>
                </c:pt>
                <c:pt idx="451">
                  <c:v>299</c:v>
                </c:pt>
                <c:pt idx="452">
                  <c:v>298</c:v>
                </c:pt>
                <c:pt idx="453">
                  <c:v>297</c:v>
                </c:pt>
                <c:pt idx="454">
                  <c:v>296</c:v>
                </c:pt>
                <c:pt idx="455">
                  <c:v>295</c:v>
                </c:pt>
                <c:pt idx="456">
                  <c:v>294</c:v>
                </c:pt>
                <c:pt idx="457">
                  <c:v>293</c:v>
                </c:pt>
                <c:pt idx="458">
                  <c:v>292</c:v>
                </c:pt>
                <c:pt idx="459">
                  <c:v>291</c:v>
                </c:pt>
                <c:pt idx="460">
                  <c:v>290</c:v>
                </c:pt>
                <c:pt idx="461">
                  <c:v>289</c:v>
                </c:pt>
                <c:pt idx="462">
                  <c:v>288</c:v>
                </c:pt>
                <c:pt idx="463">
                  <c:v>287</c:v>
                </c:pt>
                <c:pt idx="464">
                  <c:v>286</c:v>
                </c:pt>
                <c:pt idx="465">
                  <c:v>285</c:v>
                </c:pt>
                <c:pt idx="466">
                  <c:v>284</c:v>
                </c:pt>
                <c:pt idx="467">
                  <c:v>283</c:v>
                </c:pt>
                <c:pt idx="468">
                  <c:v>282</c:v>
                </c:pt>
                <c:pt idx="469">
                  <c:v>281</c:v>
                </c:pt>
                <c:pt idx="470">
                  <c:v>280</c:v>
                </c:pt>
                <c:pt idx="471">
                  <c:v>279</c:v>
                </c:pt>
                <c:pt idx="472">
                  <c:v>278</c:v>
                </c:pt>
                <c:pt idx="473">
                  <c:v>277</c:v>
                </c:pt>
                <c:pt idx="474">
                  <c:v>276</c:v>
                </c:pt>
                <c:pt idx="475">
                  <c:v>275</c:v>
                </c:pt>
                <c:pt idx="476">
                  <c:v>274</c:v>
                </c:pt>
                <c:pt idx="477">
                  <c:v>273</c:v>
                </c:pt>
                <c:pt idx="478">
                  <c:v>272</c:v>
                </c:pt>
                <c:pt idx="479">
                  <c:v>271</c:v>
                </c:pt>
                <c:pt idx="480">
                  <c:v>270</c:v>
                </c:pt>
                <c:pt idx="481">
                  <c:v>269</c:v>
                </c:pt>
                <c:pt idx="482">
                  <c:v>268</c:v>
                </c:pt>
                <c:pt idx="483">
                  <c:v>267</c:v>
                </c:pt>
                <c:pt idx="484">
                  <c:v>266</c:v>
                </c:pt>
                <c:pt idx="485">
                  <c:v>265</c:v>
                </c:pt>
                <c:pt idx="486">
                  <c:v>264</c:v>
                </c:pt>
                <c:pt idx="487">
                  <c:v>263</c:v>
                </c:pt>
                <c:pt idx="488">
                  <c:v>262</c:v>
                </c:pt>
                <c:pt idx="489">
                  <c:v>261</c:v>
                </c:pt>
                <c:pt idx="490">
                  <c:v>260</c:v>
                </c:pt>
                <c:pt idx="491">
                  <c:v>259</c:v>
                </c:pt>
                <c:pt idx="492">
                  <c:v>258</c:v>
                </c:pt>
                <c:pt idx="493">
                  <c:v>257</c:v>
                </c:pt>
                <c:pt idx="494">
                  <c:v>256</c:v>
                </c:pt>
                <c:pt idx="495">
                  <c:v>255</c:v>
                </c:pt>
                <c:pt idx="496">
                  <c:v>254</c:v>
                </c:pt>
                <c:pt idx="497">
                  <c:v>253</c:v>
                </c:pt>
                <c:pt idx="498">
                  <c:v>252</c:v>
                </c:pt>
                <c:pt idx="499">
                  <c:v>251</c:v>
                </c:pt>
                <c:pt idx="500">
                  <c:v>250</c:v>
                </c:pt>
              </c:numCache>
            </c:numRef>
          </c:xVal>
          <c:yVal>
            <c:numRef>
              <c:f>'SPETTRI Sorgente-Filtri'!$E$2:$E$552</c:f>
              <c:numCache>
                <c:formatCode>General</c:formatCode>
                <c:ptCount val="551"/>
                <c:pt idx="0">
                  <c:v>0.84518052999999993</c:v>
                </c:pt>
                <c:pt idx="1">
                  <c:v>0.84339714999999993</c:v>
                </c:pt>
                <c:pt idx="2">
                  <c:v>0.8427808</c:v>
                </c:pt>
                <c:pt idx="3">
                  <c:v>0.84167057000000001</c:v>
                </c:pt>
                <c:pt idx="4">
                  <c:v>0.84006041999999992</c:v>
                </c:pt>
                <c:pt idx="5">
                  <c:v>0.83820652999999989</c:v>
                </c:pt>
                <c:pt idx="6">
                  <c:v>0.83732286999999994</c:v>
                </c:pt>
                <c:pt idx="7">
                  <c:v>0.83579729000000003</c:v>
                </c:pt>
                <c:pt idx="8">
                  <c:v>0.83375140999999997</c:v>
                </c:pt>
                <c:pt idx="9">
                  <c:v>0.83135416000000006</c:v>
                </c:pt>
                <c:pt idx="10">
                  <c:v>0.82957018999999999</c:v>
                </c:pt>
                <c:pt idx="11">
                  <c:v>0.82667446</c:v>
                </c:pt>
                <c:pt idx="12">
                  <c:v>0.82393355999999995</c:v>
                </c:pt>
                <c:pt idx="13">
                  <c:v>0.82152877999999996</c:v>
                </c:pt>
                <c:pt idx="14">
                  <c:v>0.81816120999999997</c:v>
                </c:pt>
                <c:pt idx="15">
                  <c:v>0.81502076000000001</c:v>
                </c:pt>
                <c:pt idx="16">
                  <c:v>0.81235707000000001</c:v>
                </c:pt>
                <c:pt idx="17">
                  <c:v>0.80859547000000009</c:v>
                </c:pt>
                <c:pt idx="18">
                  <c:v>0.80418803999999999</c:v>
                </c:pt>
                <c:pt idx="19">
                  <c:v>0.80029638000000003</c:v>
                </c:pt>
                <c:pt idx="20">
                  <c:v>0.79662210999999994</c:v>
                </c:pt>
                <c:pt idx="21">
                  <c:v>0.79232393000000001</c:v>
                </c:pt>
                <c:pt idx="22">
                  <c:v>0.78809299999999993</c:v>
                </c:pt>
                <c:pt idx="23">
                  <c:v>0.78372763000000001</c:v>
                </c:pt>
                <c:pt idx="24">
                  <c:v>0.77989536999999998</c:v>
                </c:pt>
                <c:pt idx="25">
                  <c:v>0.77568415000000002</c:v>
                </c:pt>
                <c:pt idx="26">
                  <c:v>0.77168650999999999</c:v>
                </c:pt>
                <c:pt idx="27">
                  <c:v>0.76733725000000008</c:v>
                </c:pt>
                <c:pt idx="28">
                  <c:v>0.76315843999999999</c:v>
                </c:pt>
                <c:pt idx="29">
                  <c:v>0.75911253999999995</c:v>
                </c:pt>
                <c:pt idx="30">
                  <c:v>0.75538875000000005</c:v>
                </c:pt>
                <c:pt idx="31">
                  <c:v>0.75194541000000004</c:v>
                </c:pt>
                <c:pt idx="32">
                  <c:v>0.74832573999999996</c:v>
                </c:pt>
                <c:pt idx="33">
                  <c:v>0.74499579999999999</c:v>
                </c:pt>
                <c:pt idx="34">
                  <c:v>0.74119170999999995</c:v>
                </c:pt>
                <c:pt idx="35">
                  <c:v>0.73750676999999998</c:v>
                </c:pt>
                <c:pt idx="36">
                  <c:v>0.73384217000000007</c:v>
                </c:pt>
                <c:pt idx="37">
                  <c:v>0.73008572999999999</c:v>
                </c:pt>
                <c:pt idx="38">
                  <c:v>0.72630064000000005</c:v>
                </c:pt>
                <c:pt idx="39">
                  <c:v>0.72221436999999999</c:v>
                </c:pt>
                <c:pt idx="40">
                  <c:v>0.7181544700000001</c:v>
                </c:pt>
                <c:pt idx="41">
                  <c:v>0.71354432000000001</c:v>
                </c:pt>
                <c:pt idx="42">
                  <c:v>0.70833228000000004</c:v>
                </c:pt>
                <c:pt idx="43">
                  <c:v>0.70273995</c:v>
                </c:pt>
                <c:pt idx="44">
                  <c:v>0.69664919000000003</c:v>
                </c:pt>
                <c:pt idx="45">
                  <c:v>0.68949239000000007</c:v>
                </c:pt>
                <c:pt idx="46">
                  <c:v>0.68261764999999996</c:v>
                </c:pt>
                <c:pt idx="47">
                  <c:v>0.67468782000000005</c:v>
                </c:pt>
                <c:pt idx="48">
                  <c:v>0.66558339</c:v>
                </c:pt>
                <c:pt idx="49">
                  <c:v>0.65596931000000003</c:v>
                </c:pt>
                <c:pt idx="50">
                  <c:v>0.64628569000000002</c:v>
                </c:pt>
                <c:pt idx="51">
                  <c:v>0.63539290999999998</c:v>
                </c:pt>
                <c:pt idx="52">
                  <c:v>0.62319667000000001</c:v>
                </c:pt>
                <c:pt idx="53">
                  <c:v>0.61108099000000005</c:v>
                </c:pt>
                <c:pt idx="54">
                  <c:v>0.59785459000000007</c:v>
                </c:pt>
                <c:pt idx="55">
                  <c:v>0.58402036999999996</c:v>
                </c:pt>
                <c:pt idx="56">
                  <c:v>0.56974424999999995</c:v>
                </c:pt>
                <c:pt idx="57">
                  <c:v>0.55524249999999997</c:v>
                </c:pt>
                <c:pt idx="58">
                  <c:v>0.54045147999999998</c:v>
                </c:pt>
                <c:pt idx="59">
                  <c:v>0.52580800000000005</c:v>
                </c:pt>
                <c:pt idx="60">
                  <c:v>0.51150171999999994</c:v>
                </c:pt>
                <c:pt idx="61">
                  <c:v>0.49667230000000001</c:v>
                </c:pt>
                <c:pt idx="62">
                  <c:v>0.48280845999999999</c:v>
                </c:pt>
                <c:pt idx="63">
                  <c:v>0.46937029000000002</c:v>
                </c:pt>
                <c:pt idx="64">
                  <c:v>0.45604996999999997</c:v>
                </c:pt>
                <c:pt idx="65">
                  <c:v>0.44385212000000002</c:v>
                </c:pt>
                <c:pt idx="66">
                  <c:v>0.43215063999999997</c:v>
                </c:pt>
                <c:pt idx="67">
                  <c:v>0.42150657000000002</c:v>
                </c:pt>
                <c:pt idx="68">
                  <c:v>0.41190511999999996</c:v>
                </c:pt>
                <c:pt idx="69">
                  <c:v>0.40291034000000003</c:v>
                </c:pt>
                <c:pt idx="70">
                  <c:v>0.39523364999999999</c:v>
                </c:pt>
                <c:pt idx="71">
                  <c:v>0.38895556999999997</c:v>
                </c:pt>
                <c:pt idx="72">
                  <c:v>0.38372247999999998</c:v>
                </c:pt>
                <c:pt idx="73">
                  <c:v>0.37944729999999999</c:v>
                </c:pt>
                <c:pt idx="74">
                  <c:v>0.37571567</c:v>
                </c:pt>
                <c:pt idx="75">
                  <c:v>0.37331408999999999</c:v>
                </c:pt>
                <c:pt idx="76">
                  <c:v>0.37204241999999998</c:v>
                </c:pt>
                <c:pt idx="77">
                  <c:v>0.37146431999999996</c:v>
                </c:pt>
                <c:pt idx="78">
                  <c:v>0.3719384</c:v>
                </c:pt>
                <c:pt idx="79">
                  <c:v>0.37304461000000005</c:v>
                </c:pt>
                <c:pt idx="80">
                  <c:v>0.3744806</c:v>
                </c:pt>
                <c:pt idx="81">
                  <c:v>0.37737188999999999</c:v>
                </c:pt>
                <c:pt idx="82">
                  <c:v>0.37980395</c:v>
                </c:pt>
                <c:pt idx="83">
                  <c:v>0.38292915999999999</c:v>
                </c:pt>
                <c:pt idx="84">
                  <c:v>0.38698920999999997</c:v>
                </c:pt>
                <c:pt idx="85">
                  <c:v>0.39023845000000001</c:v>
                </c:pt>
                <c:pt idx="86">
                  <c:v>0.39437937000000001</c:v>
                </c:pt>
                <c:pt idx="87">
                  <c:v>0.39960678999999999</c:v>
                </c:pt>
                <c:pt idx="88">
                  <c:v>0.40475144999999996</c:v>
                </c:pt>
                <c:pt idx="89">
                  <c:v>0.40948562999999999</c:v>
                </c:pt>
                <c:pt idx="90">
                  <c:v>0.41539335999999999</c:v>
                </c:pt>
                <c:pt idx="91">
                  <c:v>0.42068224999999998</c:v>
                </c:pt>
                <c:pt idx="92">
                  <c:v>0.42591942999999999</c:v>
                </c:pt>
                <c:pt idx="93">
                  <c:v>0.43050708999999998</c:v>
                </c:pt>
                <c:pt idx="94">
                  <c:v>0.43521438000000001</c:v>
                </c:pt>
                <c:pt idx="95">
                  <c:v>0.43923226999999998</c:v>
                </c:pt>
                <c:pt idx="96">
                  <c:v>0.44275356000000005</c:v>
                </c:pt>
                <c:pt idx="97">
                  <c:v>0.44537377</c:v>
                </c:pt>
                <c:pt idx="98">
                  <c:v>0.44812578999999997</c:v>
                </c:pt>
                <c:pt idx="99">
                  <c:v>0.44978857</c:v>
                </c:pt>
                <c:pt idx="100">
                  <c:v>0.45109917999999999</c:v>
                </c:pt>
                <c:pt idx="101">
                  <c:v>0.45232298999999998</c:v>
                </c:pt>
                <c:pt idx="102">
                  <c:v>0.45281424999999997</c:v>
                </c:pt>
                <c:pt idx="103">
                  <c:v>0.45272508</c:v>
                </c:pt>
                <c:pt idx="104">
                  <c:v>0.45243456999999998</c:v>
                </c:pt>
                <c:pt idx="105">
                  <c:v>0.45122906000000002</c:v>
                </c:pt>
                <c:pt idx="106">
                  <c:v>0.45010714999999996</c:v>
                </c:pt>
                <c:pt idx="107">
                  <c:v>0.44879882000000004</c:v>
                </c:pt>
                <c:pt idx="108">
                  <c:v>0.44704447000000003</c:v>
                </c:pt>
                <c:pt idx="109">
                  <c:v>0.44489980000000001</c:v>
                </c:pt>
                <c:pt idx="110">
                  <c:v>0.44236806000000001</c:v>
                </c:pt>
                <c:pt idx="111">
                  <c:v>0.43976263000000004</c:v>
                </c:pt>
                <c:pt idx="112">
                  <c:v>0.43707143000000004</c:v>
                </c:pt>
                <c:pt idx="113">
                  <c:v>0.43449124</c:v>
                </c:pt>
                <c:pt idx="114">
                  <c:v>0.43174488999999999</c:v>
                </c:pt>
                <c:pt idx="115">
                  <c:v>0.42889516</c:v>
                </c:pt>
                <c:pt idx="116">
                  <c:v>0.42619625</c:v>
                </c:pt>
                <c:pt idx="117">
                  <c:v>0.42415070999999999</c:v>
                </c:pt>
                <c:pt idx="118">
                  <c:v>0.42218991</c:v>
                </c:pt>
                <c:pt idx="119">
                  <c:v>0.42010131000000001</c:v>
                </c:pt>
                <c:pt idx="120">
                  <c:v>0.41771464000000003</c:v>
                </c:pt>
                <c:pt idx="121">
                  <c:v>0.41713160000000005</c:v>
                </c:pt>
                <c:pt idx="122">
                  <c:v>0.41645459000000001</c:v>
                </c:pt>
                <c:pt idx="123">
                  <c:v>0.41546464999999999</c:v>
                </c:pt>
                <c:pt idx="124">
                  <c:v>0.41561562000000002</c:v>
                </c:pt>
                <c:pt idx="125">
                  <c:v>0.41577275000000002</c:v>
                </c:pt>
                <c:pt idx="126">
                  <c:v>0.41624893000000002</c:v>
                </c:pt>
                <c:pt idx="127">
                  <c:v>0.41721533</c:v>
                </c:pt>
                <c:pt idx="128">
                  <c:v>0.41805556999999999</c:v>
                </c:pt>
                <c:pt idx="129">
                  <c:v>0.41901108999999997</c:v>
                </c:pt>
                <c:pt idx="130">
                  <c:v>0.42012643</c:v>
                </c:pt>
                <c:pt idx="131">
                  <c:v>0.42138745999999999</c:v>
                </c:pt>
                <c:pt idx="132">
                  <c:v>0.42281787000000004</c:v>
                </c:pt>
                <c:pt idx="133">
                  <c:v>0.42388567999999999</c:v>
                </c:pt>
                <c:pt idx="134">
                  <c:v>0.42504413000000002</c:v>
                </c:pt>
                <c:pt idx="135">
                  <c:v>0.42585523999999997</c:v>
                </c:pt>
                <c:pt idx="136">
                  <c:v>0.42678417000000002</c:v>
                </c:pt>
                <c:pt idx="137">
                  <c:v>0.42763049000000003</c:v>
                </c:pt>
                <c:pt idx="138">
                  <c:v>0.42872261</c:v>
                </c:pt>
                <c:pt idx="139">
                  <c:v>0.42933861000000001</c:v>
                </c:pt>
                <c:pt idx="140">
                  <c:v>0.43006025999999997</c:v>
                </c:pt>
                <c:pt idx="141">
                  <c:v>0.43102432000000002</c:v>
                </c:pt>
                <c:pt idx="142">
                  <c:v>0.43240181</c:v>
                </c:pt>
                <c:pt idx="143">
                  <c:v>0.43372321999999996</c:v>
                </c:pt>
                <c:pt idx="144">
                  <c:v>0.43546172</c:v>
                </c:pt>
                <c:pt idx="145">
                  <c:v>0.43692621999999998</c:v>
                </c:pt>
                <c:pt idx="146">
                  <c:v>0.43922710999999998</c:v>
                </c:pt>
                <c:pt idx="147">
                  <c:v>0.44197670999999999</c:v>
                </c:pt>
                <c:pt idx="148">
                  <c:v>0.44458919000000002</c:v>
                </c:pt>
                <c:pt idx="149">
                  <c:v>0.44762515000000003</c:v>
                </c:pt>
                <c:pt idx="150">
                  <c:v>0.45099345999999996</c:v>
                </c:pt>
                <c:pt idx="151">
                  <c:v>0.45495348999999996</c:v>
                </c:pt>
                <c:pt idx="152">
                  <c:v>0.45888195000000004</c:v>
                </c:pt>
                <c:pt idx="153">
                  <c:v>0.46248601</c:v>
                </c:pt>
                <c:pt idx="154">
                  <c:v>0.46606319000000002</c:v>
                </c:pt>
                <c:pt idx="155">
                  <c:v>0.47021306000000002</c:v>
                </c:pt>
                <c:pt idx="156">
                  <c:v>0.47393584</c:v>
                </c:pt>
                <c:pt idx="157">
                  <c:v>0.47761949000000004</c:v>
                </c:pt>
                <c:pt idx="158">
                  <c:v>0.48128096999999997</c:v>
                </c:pt>
                <c:pt idx="159">
                  <c:v>0.48415363999999994</c:v>
                </c:pt>
                <c:pt idx="160">
                  <c:v>0.48674028999999996</c:v>
                </c:pt>
                <c:pt idx="161">
                  <c:v>0.48948214000000001</c:v>
                </c:pt>
                <c:pt idx="162">
                  <c:v>0.49131628999999999</c:v>
                </c:pt>
                <c:pt idx="163">
                  <c:v>0.49350796000000002</c:v>
                </c:pt>
                <c:pt idx="164">
                  <c:v>0.49495927000000001</c:v>
                </c:pt>
                <c:pt idx="165">
                  <c:v>0.49638474000000005</c:v>
                </c:pt>
                <c:pt idx="166">
                  <c:v>0.49783406999999996</c:v>
                </c:pt>
                <c:pt idx="167">
                  <c:v>0.49910285999999998</c:v>
                </c:pt>
                <c:pt idx="168">
                  <c:v>0.50000303000000001</c:v>
                </c:pt>
                <c:pt idx="169">
                  <c:v>0.50069854000000003</c:v>
                </c:pt>
                <c:pt idx="170">
                  <c:v>0.50148625999999996</c:v>
                </c:pt>
                <c:pt idx="171">
                  <c:v>0.50205094000000006</c:v>
                </c:pt>
                <c:pt idx="172">
                  <c:v>0.50249763999999997</c:v>
                </c:pt>
                <c:pt idx="173">
                  <c:v>0.50263871000000004</c:v>
                </c:pt>
                <c:pt idx="174">
                  <c:v>0.50239336999999995</c:v>
                </c:pt>
                <c:pt idx="175">
                  <c:v>0.50189731999999998</c:v>
                </c:pt>
                <c:pt idx="176">
                  <c:v>0.50119773999999995</c:v>
                </c:pt>
                <c:pt idx="177">
                  <c:v>0.49985677000000001</c:v>
                </c:pt>
                <c:pt idx="178">
                  <c:v>0.49816851999999995</c:v>
                </c:pt>
                <c:pt idx="179">
                  <c:v>0.49612645999999999</c:v>
                </c:pt>
                <c:pt idx="180">
                  <c:v>0.49351923999999997</c:v>
                </c:pt>
                <c:pt idx="181">
                  <c:v>0.49073124999999995</c:v>
                </c:pt>
                <c:pt idx="182">
                  <c:v>0.48798814999999995</c:v>
                </c:pt>
                <c:pt idx="183">
                  <c:v>0.48473010999999999</c:v>
                </c:pt>
                <c:pt idx="184">
                  <c:v>0.48142083000000002</c:v>
                </c:pt>
                <c:pt idx="185">
                  <c:v>0.47821920000000001</c:v>
                </c:pt>
                <c:pt idx="186">
                  <c:v>0.47530476999999999</c:v>
                </c:pt>
                <c:pt idx="187">
                  <c:v>0.47285964999999996</c:v>
                </c:pt>
                <c:pt idx="188">
                  <c:v>0.47038563999999999</c:v>
                </c:pt>
                <c:pt idx="189">
                  <c:v>0.46805383</c:v>
                </c:pt>
                <c:pt idx="190">
                  <c:v>0.46621481000000004</c:v>
                </c:pt>
                <c:pt idx="191">
                  <c:v>0.46519241</c:v>
                </c:pt>
                <c:pt idx="192">
                  <c:v>0.46510872999999997</c:v>
                </c:pt>
                <c:pt idx="193">
                  <c:v>0.4646381</c:v>
                </c:pt>
                <c:pt idx="194">
                  <c:v>0.46414110000000003</c:v>
                </c:pt>
                <c:pt idx="195">
                  <c:v>0.46468114999999999</c:v>
                </c:pt>
                <c:pt idx="196">
                  <c:v>0.46511048999999999</c:v>
                </c:pt>
                <c:pt idx="197">
                  <c:v>0.46520972999999999</c:v>
                </c:pt>
                <c:pt idx="198">
                  <c:v>0.46586404000000003</c:v>
                </c:pt>
                <c:pt idx="199">
                  <c:v>0.46664812</c:v>
                </c:pt>
                <c:pt idx="200">
                  <c:v>0.46676443000000001</c:v>
                </c:pt>
                <c:pt idx="201">
                  <c:v>0.46685560999999998</c:v>
                </c:pt>
                <c:pt idx="202">
                  <c:v>0.46695802999999997</c:v>
                </c:pt>
                <c:pt idx="203">
                  <c:v>0.46653749</c:v>
                </c:pt>
                <c:pt idx="204">
                  <c:v>0.46576548000000001</c:v>
                </c:pt>
                <c:pt idx="205">
                  <c:v>0.46510429999999997</c:v>
                </c:pt>
                <c:pt idx="206">
                  <c:v>0.46421899000000005</c:v>
                </c:pt>
                <c:pt idx="207">
                  <c:v>0.46353782000000004</c:v>
                </c:pt>
                <c:pt idx="208">
                  <c:v>0.46291283999999999</c:v>
                </c:pt>
                <c:pt idx="209">
                  <c:v>0.46271465999999994</c:v>
                </c:pt>
                <c:pt idx="210">
                  <c:v>0.46206262000000003</c:v>
                </c:pt>
                <c:pt idx="211">
                  <c:v>0.46159131999999997</c:v>
                </c:pt>
                <c:pt idx="212">
                  <c:v>0.46165818999999997</c:v>
                </c:pt>
                <c:pt idx="213">
                  <c:v>0.46172753999999999</c:v>
                </c:pt>
                <c:pt idx="214">
                  <c:v>0.46163341000000002</c:v>
                </c:pt>
                <c:pt idx="215">
                  <c:v>0.4623871</c:v>
                </c:pt>
                <c:pt idx="216">
                  <c:v>0.46325383000000003</c:v>
                </c:pt>
                <c:pt idx="217">
                  <c:v>0.46353473000000001</c:v>
                </c:pt>
                <c:pt idx="218">
                  <c:v>0.46410213</c:v>
                </c:pt>
                <c:pt idx="219">
                  <c:v>0.4646111</c:v>
                </c:pt>
                <c:pt idx="220">
                  <c:v>0.46499235</c:v>
                </c:pt>
                <c:pt idx="221">
                  <c:v>0.46511639000000005</c:v>
                </c:pt>
                <c:pt idx="222">
                  <c:v>0.46515138</c:v>
                </c:pt>
                <c:pt idx="223">
                  <c:v>0.46528052000000003</c:v>
                </c:pt>
                <c:pt idx="224">
                  <c:v>0.46569555000000001</c:v>
                </c:pt>
                <c:pt idx="225">
                  <c:v>0.46530065999999998</c:v>
                </c:pt>
                <c:pt idx="226">
                  <c:v>0.46536929999999999</c:v>
                </c:pt>
                <c:pt idx="227">
                  <c:v>0.46516784</c:v>
                </c:pt>
                <c:pt idx="228">
                  <c:v>0.46522365999999998</c:v>
                </c:pt>
                <c:pt idx="229">
                  <c:v>0.46522198000000003</c:v>
                </c:pt>
                <c:pt idx="230">
                  <c:v>0.46522675999999996</c:v>
                </c:pt>
                <c:pt idx="231">
                  <c:v>0.46541766000000001</c:v>
                </c:pt>
                <c:pt idx="232">
                  <c:v>0.46500849999999999</c:v>
                </c:pt>
                <c:pt idx="233">
                  <c:v>0.46434876000000003</c:v>
                </c:pt>
                <c:pt idx="234">
                  <c:v>0.46355455000000001</c:v>
                </c:pt>
                <c:pt idx="235">
                  <c:v>0.46244107000000001</c:v>
                </c:pt>
                <c:pt idx="236">
                  <c:v>0.46092225999999997</c:v>
                </c:pt>
                <c:pt idx="237">
                  <c:v>0.45923693999999998</c:v>
                </c:pt>
                <c:pt idx="238">
                  <c:v>0.45774594999999996</c:v>
                </c:pt>
                <c:pt idx="239">
                  <c:v>0.45530802999999997</c:v>
                </c:pt>
                <c:pt idx="240">
                  <c:v>0.45310417999999997</c:v>
                </c:pt>
                <c:pt idx="241">
                  <c:v>0.45166379999999995</c:v>
                </c:pt>
                <c:pt idx="242">
                  <c:v>0.44974724999999999</c:v>
                </c:pt>
                <c:pt idx="243">
                  <c:v>0.44827533000000003</c:v>
                </c:pt>
                <c:pt idx="244">
                  <c:v>0.44784692999999998</c:v>
                </c:pt>
                <c:pt idx="245">
                  <c:v>0.44744512000000003</c:v>
                </c:pt>
                <c:pt idx="246">
                  <c:v>0.44794423</c:v>
                </c:pt>
                <c:pt idx="247">
                  <c:v>0.44885545999999998</c:v>
                </c:pt>
                <c:pt idx="248">
                  <c:v>0.45028042999999995</c:v>
                </c:pt>
                <c:pt idx="249">
                  <c:v>0.45129482000000004</c:v>
                </c:pt>
                <c:pt idx="250">
                  <c:v>0.45235314999999998</c:v>
                </c:pt>
                <c:pt idx="251">
                  <c:v>0.45367846000000001</c:v>
                </c:pt>
                <c:pt idx="252">
                  <c:v>0.45487239000000002</c:v>
                </c:pt>
                <c:pt idx="253">
                  <c:v>0.45552874999999998</c:v>
                </c:pt>
                <c:pt idx="254">
                  <c:v>0.45580708999999997</c:v>
                </c:pt>
                <c:pt idx="255">
                  <c:v>0.45574347999999998</c:v>
                </c:pt>
                <c:pt idx="256">
                  <c:v>0.45489660999999998</c:v>
                </c:pt>
                <c:pt idx="257">
                  <c:v>0.45380847000000002</c:v>
                </c:pt>
                <c:pt idx="258">
                  <c:v>0.45303544000000001</c:v>
                </c:pt>
                <c:pt idx="259">
                  <c:v>0.45148957000000001</c:v>
                </c:pt>
                <c:pt idx="260">
                  <c:v>0.45013927000000004</c:v>
                </c:pt>
                <c:pt idx="261">
                  <c:v>0.44927594999999998</c:v>
                </c:pt>
                <c:pt idx="262">
                  <c:v>0.44870908999999998</c:v>
                </c:pt>
                <c:pt idx="263">
                  <c:v>0.44794440000000002</c:v>
                </c:pt>
                <c:pt idx="264">
                  <c:v>0.44754477000000004</c:v>
                </c:pt>
                <c:pt idx="265">
                  <c:v>0.44749398999999995</c:v>
                </c:pt>
                <c:pt idx="266">
                  <c:v>0.44761422000000001</c:v>
                </c:pt>
                <c:pt idx="267">
                  <c:v>0.44748238000000001</c:v>
                </c:pt>
                <c:pt idx="268">
                  <c:v>0.44752988999999999</c:v>
                </c:pt>
                <c:pt idx="269">
                  <c:v>0.44786411000000004</c:v>
                </c:pt>
                <c:pt idx="270">
                  <c:v>0.44805874000000001</c:v>
                </c:pt>
                <c:pt idx="271">
                  <c:v>0.44840009000000003</c:v>
                </c:pt>
                <c:pt idx="272">
                  <c:v>0.44923917000000002</c:v>
                </c:pt>
                <c:pt idx="273">
                  <c:v>0.44910342999999997</c:v>
                </c:pt>
                <c:pt idx="274">
                  <c:v>0.44998497999999998</c:v>
                </c:pt>
                <c:pt idx="275">
                  <c:v>0.45033941</c:v>
                </c:pt>
                <c:pt idx="276">
                  <c:v>0.45106918000000001</c:v>
                </c:pt>
                <c:pt idx="277">
                  <c:v>0.45223260000000004</c:v>
                </c:pt>
                <c:pt idx="278">
                  <c:v>0.45233328</c:v>
                </c:pt>
                <c:pt idx="279">
                  <c:v>0.45302508000000002</c:v>
                </c:pt>
                <c:pt idx="280">
                  <c:v>0.45253821999999999</c:v>
                </c:pt>
                <c:pt idx="281">
                  <c:v>0.45226059999999996</c:v>
                </c:pt>
                <c:pt idx="282">
                  <c:v>0.45126483000000001</c:v>
                </c:pt>
                <c:pt idx="283">
                  <c:v>0.44946942000000001</c:v>
                </c:pt>
                <c:pt idx="284">
                  <c:v>0.44826666000000004</c:v>
                </c:pt>
                <c:pt idx="285">
                  <c:v>0.44708218</c:v>
                </c:pt>
                <c:pt idx="286">
                  <c:v>0.44530847000000001</c:v>
                </c:pt>
                <c:pt idx="287">
                  <c:v>0.44408012999999996</c:v>
                </c:pt>
                <c:pt idx="288">
                  <c:v>0.44349524000000001</c:v>
                </c:pt>
                <c:pt idx="289">
                  <c:v>0.44361963999999998</c:v>
                </c:pt>
                <c:pt idx="290">
                  <c:v>0.44445345000000003</c:v>
                </c:pt>
                <c:pt idx="291">
                  <c:v>0.44610722000000003</c:v>
                </c:pt>
                <c:pt idx="292">
                  <c:v>0.44859679999999996</c:v>
                </c:pt>
                <c:pt idx="293">
                  <c:v>0.45078487</c:v>
                </c:pt>
                <c:pt idx="294">
                  <c:v>0.45375915999999994</c:v>
                </c:pt>
                <c:pt idx="295">
                  <c:v>0.45669930999999997</c:v>
                </c:pt>
                <c:pt idx="296">
                  <c:v>0.45932403999999999</c:v>
                </c:pt>
                <c:pt idx="297">
                  <c:v>0.46125714000000001</c:v>
                </c:pt>
                <c:pt idx="298">
                  <c:v>0.46327061000000003</c:v>
                </c:pt>
                <c:pt idx="299">
                  <c:v>0.46503587000000002</c:v>
                </c:pt>
                <c:pt idx="300">
                  <c:v>0.46560471999999997</c:v>
                </c:pt>
                <c:pt idx="301">
                  <c:v>0.46631858000000004</c:v>
                </c:pt>
                <c:pt idx="302">
                  <c:v>0.46711139000000002</c:v>
                </c:pt>
                <c:pt idx="303">
                  <c:v>0.46753269000000003</c:v>
                </c:pt>
                <c:pt idx="304">
                  <c:v>0.46827134999999998</c:v>
                </c:pt>
                <c:pt idx="305">
                  <c:v>0.46885953000000002</c:v>
                </c:pt>
                <c:pt idx="306">
                  <c:v>0.46960642000000002</c:v>
                </c:pt>
                <c:pt idx="307">
                  <c:v>0.47063360000000004</c:v>
                </c:pt>
                <c:pt idx="308">
                  <c:v>0.47135162999999997</c:v>
                </c:pt>
                <c:pt idx="309">
                  <c:v>0.47214865000000006</c:v>
                </c:pt>
                <c:pt idx="310">
                  <c:v>0.47315179999999996</c:v>
                </c:pt>
                <c:pt idx="311">
                  <c:v>0.47399606</c:v>
                </c:pt>
                <c:pt idx="312">
                  <c:v>0.47514372999999999</c:v>
                </c:pt>
                <c:pt idx="313">
                  <c:v>0.47630924000000002</c:v>
                </c:pt>
                <c:pt idx="314">
                  <c:v>0.47752356000000001</c:v>
                </c:pt>
                <c:pt idx="315">
                  <c:v>0.47908121000000004</c:v>
                </c:pt>
                <c:pt idx="316">
                  <c:v>0.48062100999999996</c:v>
                </c:pt>
                <c:pt idx="317">
                  <c:v>0.48113289000000004</c:v>
                </c:pt>
                <c:pt idx="318">
                  <c:v>0.48134244999999998</c:v>
                </c:pt>
                <c:pt idx="319">
                  <c:v>0.48123757</c:v>
                </c:pt>
                <c:pt idx="320">
                  <c:v>0.48061821999999998</c:v>
                </c:pt>
                <c:pt idx="321">
                  <c:v>0.47922081</c:v>
                </c:pt>
                <c:pt idx="322">
                  <c:v>0.47789821000000005</c:v>
                </c:pt>
                <c:pt idx="323">
                  <c:v>0.47654125000000003</c:v>
                </c:pt>
                <c:pt idx="324">
                  <c:v>0.47543978000000003</c:v>
                </c:pt>
                <c:pt idx="325">
                  <c:v>0.47556784999999996</c:v>
                </c:pt>
                <c:pt idx="326">
                  <c:v>0.47612139999999997</c:v>
                </c:pt>
                <c:pt idx="327">
                  <c:v>0.47769250999999996</c:v>
                </c:pt>
                <c:pt idx="328">
                  <c:v>0.47956459000000001</c:v>
                </c:pt>
                <c:pt idx="329">
                  <c:v>0.48208865000000001</c:v>
                </c:pt>
                <c:pt idx="330">
                  <c:v>0.48496240999999995</c:v>
                </c:pt>
                <c:pt idx="331">
                  <c:v>0.48707172999999998</c:v>
                </c:pt>
                <c:pt idx="332">
                  <c:v>0.48845371999999998</c:v>
                </c:pt>
                <c:pt idx="333">
                  <c:v>0.48923479000000003</c:v>
                </c:pt>
                <c:pt idx="334">
                  <c:v>0.48866121000000001</c:v>
                </c:pt>
                <c:pt idx="335">
                  <c:v>0.48764850000000004</c:v>
                </c:pt>
                <c:pt idx="336">
                  <c:v>0.48601322000000002</c:v>
                </c:pt>
                <c:pt idx="337">
                  <c:v>0.48383341000000002</c:v>
                </c:pt>
                <c:pt idx="338">
                  <c:v>0.48145491000000001</c:v>
                </c:pt>
                <c:pt idx="339">
                  <c:v>0.47911084000000004</c:v>
                </c:pt>
                <c:pt idx="340">
                  <c:v>0.47698013000000006</c:v>
                </c:pt>
                <c:pt idx="341">
                  <c:v>0.47500700000000001</c:v>
                </c:pt>
                <c:pt idx="342">
                  <c:v>0.47312919000000003</c:v>
                </c:pt>
                <c:pt idx="343">
                  <c:v>0.47206119000000002</c:v>
                </c:pt>
                <c:pt idx="344">
                  <c:v>0.47200944</c:v>
                </c:pt>
                <c:pt idx="345">
                  <c:v>0.47234699999999996</c:v>
                </c:pt>
                <c:pt idx="346">
                  <c:v>0.47323925</c:v>
                </c:pt>
                <c:pt idx="347">
                  <c:v>0.47462480999999995</c:v>
                </c:pt>
                <c:pt idx="348">
                  <c:v>0.47615312000000004</c:v>
                </c:pt>
                <c:pt idx="349">
                  <c:v>0.47737911</c:v>
                </c:pt>
                <c:pt idx="350">
                  <c:v>0.47799714999999998</c:v>
                </c:pt>
                <c:pt idx="351">
                  <c:v>0.47769789000000001</c:v>
                </c:pt>
                <c:pt idx="352">
                  <c:v>0.47634087000000003</c:v>
                </c:pt>
                <c:pt idx="353">
                  <c:v>0.47405016999999999</c:v>
                </c:pt>
                <c:pt idx="354">
                  <c:v>0.47092553000000004</c:v>
                </c:pt>
                <c:pt idx="355">
                  <c:v>0.46726692999999997</c:v>
                </c:pt>
                <c:pt idx="356">
                  <c:v>0.46397569</c:v>
                </c:pt>
                <c:pt idx="357">
                  <c:v>0.46116765999999998</c:v>
                </c:pt>
                <c:pt idx="358">
                  <c:v>0.45892657999999997</c:v>
                </c:pt>
                <c:pt idx="359">
                  <c:v>0.45732098999999998</c:v>
                </c:pt>
                <c:pt idx="360">
                  <c:v>0.45610683000000002</c:v>
                </c:pt>
                <c:pt idx="361">
                  <c:v>0.45471778000000002</c:v>
                </c:pt>
                <c:pt idx="362">
                  <c:v>0.45323248999999999</c:v>
                </c:pt>
                <c:pt idx="363">
                  <c:v>0.45161701999999998</c:v>
                </c:pt>
                <c:pt idx="364">
                  <c:v>0.44965786000000002</c:v>
                </c:pt>
                <c:pt idx="365">
                  <c:v>0.44718276000000001</c:v>
                </c:pt>
                <c:pt idx="366">
                  <c:v>0.44414116999999997</c:v>
                </c:pt>
                <c:pt idx="367">
                  <c:v>0.44077150000000004</c:v>
                </c:pt>
                <c:pt idx="368">
                  <c:v>0.43703874999999998</c:v>
                </c:pt>
                <c:pt idx="369">
                  <c:v>0.43313412999999995</c:v>
                </c:pt>
                <c:pt idx="370">
                  <c:v>0.42917577000000001</c:v>
                </c:pt>
                <c:pt idx="371">
                  <c:v>0.42493595999999995</c:v>
                </c:pt>
                <c:pt idx="372">
                  <c:v>0.42094306000000004</c:v>
                </c:pt>
                <c:pt idx="373">
                  <c:v>0.41722591000000003</c:v>
                </c:pt>
                <c:pt idx="374">
                  <c:v>0.41322565999999999</c:v>
                </c:pt>
                <c:pt idx="375">
                  <c:v>0.40917549000000003</c:v>
                </c:pt>
                <c:pt idx="376">
                  <c:v>0.40576506000000001</c:v>
                </c:pt>
                <c:pt idx="377">
                  <c:v>0.40196764000000001</c:v>
                </c:pt>
                <c:pt idx="378">
                  <c:v>0.39752245000000003</c:v>
                </c:pt>
                <c:pt idx="379">
                  <c:v>0.39273637</c:v>
                </c:pt>
                <c:pt idx="380">
                  <c:v>0.38739091000000003</c:v>
                </c:pt>
                <c:pt idx="381">
                  <c:v>0.38149911000000003</c:v>
                </c:pt>
                <c:pt idx="382">
                  <c:v>0.37590947000000002</c:v>
                </c:pt>
                <c:pt idx="383">
                  <c:v>0.37057870999999998</c:v>
                </c:pt>
                <c:pt idx="384">
                  <c:v>0.36548338999999996</c:v>
                </c:pt>
                <c:pt idx="385">
                  <c:v>0.36014166000000003</c:v>
                </c:pt>
                <c:pt idx="386">
                  <c:v>0.35477179999999997</c:v>
                </c:pt>
                <c:pt idx="387">
                  <c:v>0.34999659</c:v>
                </c:pt>
                <c:pt idx="388">
                  <c:v>0.34507958999999999</c:v>
                </c:pt>
                <c:pt idx="389">
                  <c:v>0.33975813999999999</c:v>
                </c:pt>
                <c:pt idx="390">
                  <c:v>0.33408023999999997</c:v>
                </c:pt>
                <c:pt idx="391">
                  <c:v>0.32826949</c:v>
                </c:pt>
                <c:pt idx="392">
                  <c:v>0.32265631</c:v>
                </c:pt>
                <c:pt idx="393">
                  <c:v>0.31727957000000001</c:v>
                </c:pt>
                <c:pt idx="394">
                  <c:v>0.31184108999999999</c:v>
                </c:pt>
                <c:pt idx="395">
                  <c:v>0.30680326999999996</c:v>
                </c:pt>
                <c:pt idx="396">
                  <c:v>0.30191761</c:v>
                </c:pt>
                <c:pt idx="397">
                  <c:v>0.29753830000000003</c:v>
                </c:pt>
                <c:pt idx="398">
                  <c:v>0.29337722999999999</c:v>
                </c:pt>
                <c:pt idx="399">
                  <c:v>0.28947435999999999</c:v>
                </c:pt>
                <c:pt idx="400">
                  <c:v>0.28600719000000002</c:v>
                </c:pt>
                <c:pt idx="401">
                  <c:v>0.28261918000000003</c:v>
                </c:pt>
                <c:pt idx="402">
                  <c:v>0.27931840000000002</c:v>
                </c:pt>
                <c:pt idx="403">
                  <c:v>0.27616648999999999</c:v>
                </c:pt>
                <c:pt idx="404">
                  <c:v>0.27309304000000001</c:v>
                </c:pt>
                <c:pt idx="405">
                  <c:v>0.27016245</c:v>
                </c:pt>
                <c:pt idx="406">
                  <c:v>0.26754949</c:v>
                </c:pt>
                <c:pt idx="407">
                  <c:v>0.26470621</c:v>
                </c:pt>
                <c:pt idx="408">
                  <c:v>0.26210324000000002</c:v>
                </c:pt>
                <c:pt idx="409">
                  <c:v>0.25948272</c:v>
                </c:pt>
                <c:pt idx="410">
                  <c:v>0.25813280999999999</c:v>
                </c:pt>
                <c:pt idx="411">
                  <c:v>0.25722269000000003</c:v>
                </c:pt>
                <c:pt idx="412">
                  <c:v>0.25646546000000003</c:v>
                </c:pt>
                <c:pt idx="413">
                  <c:v>0.25571632999999999</c:v>
                </c:pt>
                <c:pt idx="414">
                  <c:v>0.25462707000000001</c:v>
                </c:pt>
                <c:pt idx="415">
                  <c:v>0.25276607000000001</c:v>
                </c:pt>
                <c:pt idx="416">
                  <c:v>0.25052102000000004</c:v>
                </c:pt>
                <c:pt idx="417">
                  <c:v>0.24781607999999999</c:v>
                </c:pt>
                <c:pt idx="418">
                  <c:v>0.24550535000000001</c:v>
                </c:pt>
                <c:pt idx="419">
                  <c:v>0.24331628999999999</c:v>
                </c:pt>
                <c:pt idx="420">
                  <c:v>0.24167314999999998</c:v>
                </c:pt>
                <c:pt idx="421">
                  <c:v>0.24008728999999998</c:v>
                </c:pt>
                <c:pt idx="422">
                  <c:v>0.23815560000000002</c:v>
                </c:pt>
                <c:pt idx="423">
                  <c:v>0.23550067999999999</c:v>
                </c:pt>
                <c:pt idx="424">
                  <c:v>0.23088360999999999</c:v>
                </c:pt>
                <c:pt idx="425">
                  <c:v>0.22478504000000002</c:v>
                </c:pt>
                <c:pt idx="426">
                  <c:v>0.21732375000000001</c:v>
                </c:pt>
                <c:pt idx="427">
                  <c:v>0.20847560999999998</c:v>
                </c:pt>
                <c:pt idx="428">
                  <c:v>0.19842549000000001</c:v>
                </c:pt>
                <c:pt idx="429">
                  <c:v>0.18726166</c:v>
                </c:pt>
                <c:pt idx="430">
                  <c:v>0.17513276</c:v>
                </c:pt>
                <c:pt idx="431">
                  <c:v>0.15971695</c:v>
                </c:pt>
                <c:pt idx="432">
                  <c:v>0.14027191</c:v>
                </c:pt>
                <c:pt idx="433">
                  <c:v>0.11834462999999999</c:v>
                </c:pt>
                <c:pt idx="434">
                  <c:v>9.2780810000000005E-2</c:v>
                </c:pt>
                <c:pt idx="435">
                  <c:v>6.5840079999999995E-2</c:v>
                </c:pt>
                <c:pt idx="436">
                  <c:v>4.0706400000000004E-2</c:v>
                </c:pt>
                <c:pt idx="437">
                  <c:v>2.1026720000000002E-2</c:v>
                </c:pt>
                <c:pt idx="438">
                  <c:v>8.4401900000000002E-3</c:v>
                </c:pt>
                <c:pt idx="439">
                  <c:v>2.34614E-3</c:v>
                </c:pt>
                <c:pt idx="440">
                  <c:v>4.7140000000000002E-4</c:v>
                </c:pt>
                <c:pt idx="441">
                  <c:v>8.2590000000000007E-5</c:v>
                </c:pt>
                <c:pt idx="442">
                  <c:v>-5.0590000000000002E-5</c:v>
                </c:pt>
                <c:pt idx="443">
                  <c:v>-3.3040000000000002E-5</c:v>
                </c:pt>
                <c:pt idx="444">
                  <c:v>-4.2370000000000003E-5</c:v>
                </c:pt>
                <c:pt idx="445">
                  <c:v>-1.0299999999999999E-6</c:v>
                </c:pt>
                <c:pt idx="446">
                  <c:v>7.0259999999999995E-5</c:v>
                </c:pt>
                <c:pt idx="447">
                  <c:v>1.2915E-4</c:v>
                </c:pt>
                <c:pt idx="448">
                  <c:v>-5.2700000000000007E-5</c:v>
                </c:pt>
                <c:pt idx="449">
                  <c:v>-5.1650000000000002E-5</c:v>
                </c:pt>
                <c:pt idx="450">
                  <c:v>2.1690000000000001E-5</c:v>
                </c:pt>
                <c:pt idx="451">
                  <c:v>4.3380000000000001E-5</c:v>
                </c:pt>
                <c:pt idx="452">
                  <c:v>-1.5500000000000001E-5</c:v>
                </c:pt>
                <c:pt idx="453">
                  <c:v>-1.24E-5</c:v>
                </c:pt>
                <c:pt idx="454">
                  <c:v>-3.1010000000000003E-5</c:v>
                </c:pt>
                <c:pt idx="455">
                  <c:v>-1.0299999999999999E-6</c:v>
                </c:pt>
                <c:pt idx="456">
                  <c:v>5.3720000000000001E-5</c:v>
                </c:pt>
                <c:pt idx="457">
                  <c:v>-5.0610000000000005E-5</c:v>
                </c:pt>
                <c:pt idx="458">
                  <c:v>-8.9920000000000006E-5</c:v>
                </c:pt>
                <c:pt idx="459">
                  <c:v>-7.2360000000000005E-5</c:v>
                </c:pt>
                <c:pt idx="460">
                  <c:v>1.6529999999999999E-5</c:v>
                </c:pt>
                <c:pt idx="461">
                  <c:v>6.4129999999999998E-5</c:v>
                </c:pt>
                <c:pt idx="462">
                  <c:v>4.3439999999999997E-5</c:v>
                </c:pt>
                <c:pt idx="463">
                  <c:v>-2.3779999999999999E-5</c:v>
                </c:pt>
                <c:pt idx="464">
                  <c:v>3.3089999999999997E-5</c:v>
                </c:pt>
                <c:pt idx="465">
                  <c:v>3.5139999999999999E-5</c:v>
                </c:pt>
                <c:pt idx="466">
                  <c:v>6.7200000000000007E-5</c:v>
                </c:pt>
                <c:pt idx="467">
                  <c:v>4.3420000000000001E-5</c:v>
                </c:pt>
                <c:pt idx="468">
                  <c:v>-4.9639999999999999E-5</c:v>
                </c:pt>
                <c:pt idx="469">
                  <c:v>-6.5129999999999995E-5</c:v>
                </c:pt>
                <c:pt idx="470">
                  <c:v>3.1010000000000003E-5</c:v>
                </c:pt>
                <c:pt idx="471">
                  <c:v>3.5129999999999997E-5</c:v>
                </c:pt>
                <c:pt idx="472">
                  <c:v>-4.8570000000000004E-5</c:v>
                </c:pt>
                <c:pt idx="473">
                  <c:v>-8.2650000000000003E-5</c:v>
                </c:pt>
                <c:pt idx="474">
                  <c:v>-5.1619999999999997E-5</c:v>
                </c:pt>
                <c:pt idx="475">
                  <c:v>-4.1300000000000003E-6</c:v>
                </c:pt>
                <c:pt idx="476">
                  <c:v>-4.7509999999999997E-5</c:v>
                </c:pt>
                <c:pt idx="477">
                  <c:v>-1.5489999999999999E-5</c:v>
                </c:pt>
                <c:pt idx="478">
                  <c:v>-2.065E-5</c:v>
                </c:pt>
                <c:pt idx="479">
                  <c:v>-1.6520000000000001E-5</c:v>
                </c:pt>
                <c:pt idx="480">
                  <c:v>4.8510000000000001E-5</c:v>
                </c:pt>
                <c:pt idx="481">
                  <c:v>5.2630000000000003E-5</c:v>
                </c:pt>
                <c:pt idx="482">
                  <c:v>-8.2500000000000006E-6</c:v>
                </c:pt>
                <c:pt idx="483">
                  <c:v>-1.0299999999999999E-6</c:v>
                </c:pt>
                <c:pt idx="484">
                  <c:v>5.2649999999999999E-5</c:v>
                </c:pt>
                <c:pt idx="485">
                  <c:v>7.3310000000000001E-5</c:v>
                </c:pt>
                <c:pt idx="486">
                  <c:v>5.2670000000000002E-5</c:v>
                </c:pt>
                <c:pt idx="487">
                  <c:v>-6.6100000000000007E-5</c:v>
                </c:pt>
                <c:pt idx="488">
                  <c:v>-8.6760000000000003E-5</c:v>
                </c:pt>
                <c:pt idx="489">
                  <c:v>-1.9620000000000002E-5</c:v>
                </c:pt>
                <c:pt idx="490">
                  <c:v>-1.7560000000000001E-5</c:v>
                </c:pt>
                <c:pt idx="491">
                  <c:v>-4.9579999999999996E-5</c:v>
                </c:pt>
                <c:pt idx="492">
                  <c:v>-3.8250000000000001E-5</c:v>
                </c:pt>
                <c:pt idx="493">
                  <c:v>-3.1010000000000003E-5</c:v>
                </c:pt>
                <c:pt idx="494">
                  <c:v>2.3790000000000001E-5</c:v>
                </c:pt>
                <c:pt idx="495">
                  <c:v>9.7249999999999992E-5</c:v>
                </c:pt>
                <c:pt idx="496">
                  <c:v>5.7939999999999998E-5</c:v>
                </c:pt>
                <c:pt idx="497">
                  <c:v>3.5170000000000004E-5</c:v>
                </c:pt>
                <c:pt idx="498">
                  <c:v>5.0689999999999997E-5</c:v>
                </c:pt>
                <c:pt idx="499">
                  <c:v>3.2079999999999998E-5</c:v>
                </c:pt>
                <c:pt idx="500">
                  <c:v>5.3819999999999996E-5</c:v>
                </c:pt>
                <c:pt idx="501">
                  <c:v>7.2400000000000001E-6</c:v>
                </c:pt>
                <c:pt idx="502">
                  <c:v>-6.7299999999999996E-5</c:v>
                </c:pt>
                <c:pt idx="503">
                  <c:v>-5.7990000000000006E-5</c:v>
                </c:pt>
                <c:pt idx="504">
                  <c:v>-2.0700000000000001E-6</c:v>
                </c:pt>
                <c:pt idx="505">
                  <c:v>1.1379999999999999E-5</c:v>
                </c:pt>
                <c:pt idx="506">
                  <c:v>4.1400000000000002E-6</c:v>
                </c:pt>
                <c:pt idx="507">
                  <c:v>-3.5209999999999997E-5</c:v>
                </c:pt>
                <c:pt idx="508">
                  <c:v>-4.8690000000000003E-5</c:v>
                </c:pt>
                <c:pt idx="509">
                  <c:v>7.1489999999999995E-5</c:v>
                </c:pt>
                <c:pt idx="510">
                  <c:v>1.2432E-4</c:v>
                </c:pt>
                <c:pt idx="511">
                  <c:v>3.4190000000000003E-5</c:v>
                </c:pt>
                <c:pt idx="512">
                  <c:v>-2.4870000000000001E-5</c:v>
                </c:pt>
                <c:pt idx="513">
                  <c:v>-1.8660000000000001E-5</c:v>
                </c:pt>
                <c:pt idx="514">
                  <c:v>4.7679999999999998E-5</c:v>
                </c:pt>
                <c:pt idx="515">
                  <c:v>8.5000000000000006E-5</c:v>
                </c:pt>
                <c:pt idx="516">
                  <c:v>4.1400000000000002E-6</c:v>
                </c:pt>
                <c:pt idx="517">
                  <c:v>-7.8829999999999989E-5</c:v>
                </c:pt>
                <c:pt idx="518">
                  <c:v>-1.2347000000000001E-4</c:v>
                </c:pt>
                <c:pt idx="519">
                  <c:v>-4.6690000000000002E-5</c:v>
                </c:pt>
                <c:pt idx="520">
                  <c:v>1.0299999999999999E-6</c:v>
                </c:pt>
                <c:pt idx="521">
                  <c:v>-4.0439999999999999E-5</c:v>
                </c:pt>
                <c:pt idx="522">
                  <c:v>-5.2900000000000005E-5</c:v>
                </c:pt>
                <c:pt idx="523">
                  <c:v>-2.0739999999999998E-5</c:v>
                </c:pt>
                <c:pt idx="524">
                  <c:v>3.4239999999999997E-5</c:v>
                </c:pt>
                <c:pt idx="525">
                  <c:v>8.7170000000000007E-5</c:v>
                </c:pt>
                <c:pt idx="526">
                  <c:v>7.3670000000000004E-5</c:v>
                </c:pt>
                <c:pt idx="527">
                  <c:v>-5.1800000000000004E-6</c:v>
                </c:pt>
                <c:pt idx="528">
                  <c:v>9.3300000000000005E-6</c:v>
                </c:pt>
                <c:pt idx="529">
                  <c:v>6.3269999999999996E-5</c:v>
                </c:pt>
                <c:pt idx="530">
                  <c:v>9.3300000000000005E-6</c:v>
                </c:pt>
                <c:pt idx="531">
                  <c:v>-5.6020000000000002E-5</c:v>
                </c:pt>
                <c:pt idx="532">
                  <c:v>-8.9219999999999989E-5</c:v>
                </c:pt>
                <c:pt idx="533">
                  <c:v>-7.4720000000000003E-5</c:v>
                </c:pt>
                <c:pt idx="534">
                  <c:v>-1.0369999999999999E-5</c:v>
                </c:pt>
                <c:pt idx="535">
                  <c:v>-6.2200000000000006E-6</c:v>
                </c:pt>
                <c:pt idx="536">
                  <c:v>-7.6790000000000002E-5</c:v>
                </c:pt>
                <c:pt idx="537">
                  <c:v>-1.2459999999999999E-4</c:v>
                </c:pt>
                <c:pt idx="538">
                  <c:v>-3.6359999999999997E-5</c:v>
                </c:pt>
                <c:pt idx="539">
                  <c:v>2.8039999999999999E-5</c:v>
                </c:pt>
                <c:pt idx="540">
                  <c:v>2.9090000000000001E-5</c:v>
                </c:pt>
                <c:pt idx="541">
                  <c:v>-3.1199999999999998E-6</c:v>
                </c:pt>
                <c:pt idx="542">
                  <c:v>-1.0517E-4</c:v>
                </c:pt>
                <c:pt idx="543">
                  <c:v>-3.5450000000000001E-5</c:v>
                </c:pt>
                <c:pt idx="544">
                  <c:v>8.6639999999999997E-5</c:v>
                </c:pt>
                <c:pt idx="545">
                  <c:v>3.345E-5</c:v>
                </c:pt>
                <c:pt idx="546">
                  <c:v>-5.0250000000000002E-5</c:v>
                </c:pt>
                <c:pt idx="547">
                  <c:v>-5.9790000000000002E-5</c:v>
                </c:pt>
                <c:pt idx="548">
                  <c:v>8.4000000000000009E-6</c:v>
                </c:pt>
                <c:pt idx="549">
                  <c:v>8.106E-5</c:v>
                </c:pt>
                <c:pt idx="550">
                  <c:v>3.9039999999999999E-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1B0-420F-A730-A5A6354D5ECD}"/>
            </c:ext>
          </c:extLst>
        </c:ser>
        <c:ser>
          <c:idx val="3"/>
          <c:order val="3"/>
          <c:tx>
            <c:strRef>
              <c:f>'SPETTRI Sorgente-Filtri'!$B$1</c:f>
              <c:strCache>
                <c:ptCount val="1"/>
                <c:pt idx="0">
                  <c:v>LED Source</c:v>
                </c:pt>
              </c:strCache>
            </c:strRef>
          </c:tx>
          <c:spPr>
            <a:ln w="25400" cap="rnd">
              <a:solidFill>
                <a:srgbClr val="FF000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'SPETTRI Sorgente-Filtri'!$A$2:$A$552</c:f>
              <c:numCache>
                <c:formatCode>General</c:formatCode>
                <c:ptCount val="551"/>
                <c:pt idx="0">
                  <c:v>750</c:v>
                </c:pt>
                <c:pt idx="1">
                  <c:v>749</c:v>
                </c:pt>
                <c:pt idx="2">
                  <c:v>748</c:v>
                </c:pt>
                <c:pt idx="3">
                  <c:v>747</c:v>
                </c:pt>
                <c:pt idx="4">
                  <c:v>746</c:v>
                </c:pt>
                <c:pt idx="5">
                  <c:v>745</c:v>
                </c:pt>
                <c:pt idx="6">
                  <c:v>744</c:v>
                </c:pt>
                <c:pt idx="7">
                  <c:v>743</c:v>
                </c:pt>
                <c:pt idx="8">
                  <c:v>742</c:v>
                </c:pt>
                <c:pt idx="9">
                  <c:v>741</c:v>
                </c:pt>
                <c:pt idx="10">
                  <c:v>740</c:v>
                </c:pt>
                <c:pt idx="11">
                  <c:v>739</c:v>
                </c:pt>
                <c:pt idx="12">
                  <c:v>738</c:v>
                </c:pt>
                <c:pt idx="13">
                  <c:v>737</c:v>
                </c:pt>
                <c:pt idx="14">
                  <c:v>736</c:v>
                </c:pt>
                <c:pt idx="15">
                  <c:v>735</c:v>
                </c:pt>
                <c:pt idx="16">
                  <c:v>734</c:v>
                </c:pt>
                <c:pt idx="17">
                  <c:v>733</c:v>
                </c:pt>
                <c:pt idx="18">
                  <c:v>732</c:v>
                </c:pt>
                <c:pt idx="19">
                  <c:v>731</c:v>
                </c:pt>
                <c:pt idx="20">
                  <c:v>730</c:v>
                </c:pt>
                <c:pt idx="21">
                  <c:v>729</c:v>
                </c:pt>
                <c:pt idx="22">
                  <c:v>728</c:v>
                </c:pt>
                <c:pt idx="23">
                  <c:v>727</c:v>
                </c:pt>
                <c:pt idx="24">
                  <c:v>726</c:v>
                </c:pt>
                <c:pt idx="25">
                  <c:v>725</c:v>
                </c:pt>
                <c:pt idx="26">
                  <c:v>724</c:v>
                </c:pt>
                <c:pt idx="27">
                  <c:v>723</c:v>
                </c:pt>
                <c:pt idx="28">
                  <c:v>722</c:v>
                </c:pt>
                <c:pt idx="29">
                  <c:v>721</c:v>
                </c:pt>
                <c:pt idx="30">
                  <c:v>720</c:v>
                </c:pt>
                <c:pt idx="31">
                  <c:v>719</c:v>
                </c:pt>
                <c:pt idx="32">
                  <c:v>718</c:v>
                </c:pt>
                <c:pt idx="33">
                  <c:v>717</c:v>
                </c:pt>
                <c:pt idx="34">
                  <c:v>716</c:v>
                </c:pt>
                <c:pt idx="35">
                  <c:v>715</c:v>
                </c:pt>
                <c:pt idx="36">
                  <c:v>714</c:v>
                </c:pt>
                <c:pt idx="37">
                  <c:v>713</c:v>
                </c:pt>
                <c:pt idx="38">
                  <c:v>712</c:v>
                </c:pt>
                <c:pt idx="39">
                  <c:v>711</c:v>
                </c:pt>
                <c:pt idx="40">
                  <c:v>710</c:v>
                </c:pt>
                <c:pt idx="41">
                  <c:v>709</c:v>
                </c:pt>
                <c:pt idx="42">
                  <c:v>708</c:v>
                </c:pt>
                <c:pt idx="43">
                  <c:v>707</c:v>
                </c:pt>
                <c:pt idx="44">
                  <c:v>706</c:v>
                </c:pt>
                <c:pt idx="45">
                  <c:v>705</c:v>
                </c:pt>
                <c:pt idx="46">
                  <c:v>704</c:v>
                </c:pt>
                <c:pt idx="47">
                  <c:v>703</c:v>
                </c:pt>
                <c:pt idx="48">
                  <c:v>702</c:v>
                </c:pt>
                <c:pt idx="49">
                  <c:v>701</c:v>
                </c:pt>
                <c:pt idx="50">
                  <c:v>700</c:v>
                </c:pt>
                <c:pt idx="51">
                  <c:v>699</c:v>
                </c:pt>
                <c:pt idx="52">
                  <c:v>698</c:v>
                </c:pt>
                <c:pt idx="53">
                  <c:v>697</c:v>
                </c:pt>
                <c:pt idx="54">
                  <c:v>696</c:v>
                </c:pt>
                <c:pt idx="55">
                  <c:v>695</c:v>
                </c:pt>
                <c:pt idx="56">
                  <c:v>694</c:v>
                </c:pt>
                <c:pt idx="57">
                  <c:v>693</c:v>
                </c:pt>
                <c:pt idx="58">
                  <c:v>692</c:v>
                </c:pt>
                <c:pt idx="59">
                  <c:v>691</c:v>
                </c:pt>
                <c:pt idx="60">
                  <c:v>690</c:v>
                </c:pt>
                <c:pt idx="61">
                  <c:v>689</c:v>
                </c:pt>
                <c:pt idx="62">
                  <c:v>688</c:v>
                </c:pt>
                <c:pt idx="63">
                  <c:v>687</c:v>
                </c:pt>
                <c:pt idx="64">
                  <c:v>686</c:v>
                </c:pt>
                <c:pt idx="65">
                  <c:v>685</c:v>
                </c:pt>
                <c:pt idx="66">
                  <c:v>684</c:v>
                </c:pt>
                <c:pt idx="67">
                  <c:v>683</c:v>
                </c:pt>
                <c:pt idx="68">
                  <c:v>682</c:v>
                </c:pt>
                <c:pt idx="69">
                  <c:v>681</c:v>
                </c:pt>
                <c:pt idx="70">
                  <c:v>680</c:v>
                </c:pt>
                <c:pt idx="71">
                  <c:v>679</c:v>
                </c:pt>
                <c:pt idx="72">
                  <c:v>678</c:v>
                </c:pt>
                <c:pt idx="73">
                  <c:v>677</c:v>
                </c:pt>
                <c:pt idx="74">
                  <c:v>676</c:v>
                </c:pt>
                <c:pt idx="75">
                  <c:v>675</c:v>
                </c:pt>
                <c:pt idx="76">
                  <c:v>674</c:v>
                </c:pt>
                <c:pt idx="77">
                  <c:v>673</c:v>
                </c:pt>
                <c:pt idx="78">
                  <c:v>672</c:v>
                </c:pt>
                <c:pt idx="79">
                  <c:v>671</c:v>
                </c:pt>
                <c:pt idx="80">
                  <c:v>670</c:v>
                </c:pt>
                <c:pt idx="81">
                  <c:v>669</c:v>
                </c:pt>
                <c:pt idx="82">
                  <c:v>668</c:v>
                </c:pt>
                <c:pt idx="83">
                  <c:v>667</c:v>
                </c:pt>
                <c:pt idx="84">
                  <c:v>666</c:v>
                </c:pt>
                <c:pt idx="85">
                  <c:v>665</c:v>
                </c:pt>
                <c:pt idx="86">
                  <c:v>664</c:v>
                </c:pt>
                <c:pt idx="87">
                  <c:v>663</c:v>
                </c:pt>
                <c:pt idx="88">
                  <c:v>662</c:v>
                </c:pt>
                <c:pt idx="89">
                  <c:v>661</c:v>
                </c:pt>
                <c:pt idx="90">
                  <c:v>660</c:v>
                </c:pt>
                <c:pt idx="91">
                  <c:v>659</c:v>
                </c:pt>
                <c:pt idx="92">
                  <c:v>658</c:v>
                </c:pt>
                <c:pt idx="93">
                  <c:v>657</c:v>
                </c:pt>
                <c:pt idx="94">
                  <c:v>656</c:v>
                </c:pt>
                <c:pt idx="95">
                  <c:v>655</c:v>
                </c:pt>
                <c:pt idx="96">
                  <c:v>654</c:v>
                </c:pt>
                <c:pt idx="97">
                  <c:v>653</c:v>
                </c:pt>
                <c:pt idx="98">
                  <c:v>652</c:v>
                </c:pt>
                <c:pt idx="99">
                  <c:v>651</c:v>
                </c:pt>
                <c:pt idx="100">
                  <c:v>650</c:v>
                </c:pt>
                <c:pt idx="101">
                  <c:v>649</c:v>
                </c:pt>
                <c:pt idx="102">
                  <c:v>648</c:v>
                </c:pt>
                <c:pt idx="103">
                  <c:v>647</c:v>
                </c:pt>
                <c:pt idx="104">
                  <c:v>646</c:v>
                </c:pt>
                <c:pt idx="105">
                  <c:v>645</c:v>
                </c:pt>
                <c:pt idx="106">
                  <c:v>644</c:v>
                </c:pt>
                <c:pt idx="107">
                  <c:v>643</c:v>
                </c:pt>
                <c:pt idx="108">
                  <c:v>642</c:v>
                </c:pt>
                <c:pt idx="109">
                  <c:v>641</c:v>
                </c:pt>
                <c:pt idx="110">
                  <c:v>640</c:v>
                </c:pt>
                <c:pt idx="111">
                  <c:v>639</c:v>
                </c:pt>
                <c:pt idx="112">
                  <c:v>638</c:v>
                </c:pt>
                <c:pt idx="113">
                  <c:v>637</c:v>
                </c:pt>
                <c:pt idx="114">
                  <c:v>636</c:v>
                </c:pt>
                <c:pt idx="115">
                  <c:v>635</c:v>
                </c:pt>
                <c:pt idx="116">
                  <c:v>634</c:v>
                </c:pt>
                <c:pt idx="117">
                  <c:v>633</c:v>
                </c:pt>
                <c:pt idx="118">
                  <c:v>632</c:v>
                </c:pt>
                <c:pt idx="119">
                  <c:v>631</c:v>
                </c:pt>
                <c:pt idx="120">
                  <c:v>630</c:v>
                </c:pt>
                <c:pt idx="121">
                  <c:v>629</c:v>
                </c:pt>
                <c:pt idx="122">
                  <c:v>628</c:v>
                </c:pt>
                <c:pt idx="123">
                  <c:v>627</c:v>
                </c:pt>
                <c:pt idx="124">
                  <c:v>626</c:v>
                </c:pt>
                <c:pt idx="125">
                  <c:v>625</c:v>
                </c:pt>
                <c:pt idx="126">
                  <c:v>624</c:v>
                </c:pt>
                <c:pt idx="127">
                  <c:v>623</c:v>
                </c:pt>
                <c:pt idx="128">
                  <c:v>622</c:v>
                </c:pt>
                <c:pt idx="129">
                  <c:v>621</c:v>
                </c:pt>
                <c:pt idx="130">
                  <c:v>620</c:v>
                </c:pt>
                <c:pt idx="131">
                  <c:v>619</c:v>
                </c:pt>
                <c:pt idx="132">
                  <c:v>618</c:v>
                </c:pt>
                <c:pt idx="133">
                  <c:v>617</c:v>
                </c:pt>
                <c:pt idx="134">
                  <c:v>616</c:v>
                </c:pt>
                <c:pt idx="135">
                  <c:v>615</c:v>
                </c:pt>
                <c:pt idx="136">
                  <c:v>614</c:v>
                </c:pt>
                <c:pt idx="137">
                  <c:v>613</c:v>
                </c:pt>
                <c:pt idx="138">
                  <c:v>612</c:v>
                </c:pt>
                <c:pt idx="139">
                  <c:v>611</c:v>
                </c:pt>
                <c:pt idx="140">
                  <c:v>610</c:v>
                </c:pt>
                <c:pt idx="141">
                  <c:v>609</c:v>
                </c:pt>
                <c:pt idx="142">
                  <c:v>608</c:v>
                </c:pt>
                <c:pt idx="143">
                  <c:v>607</c:v>
                </c:pt>
                <c:pt idx="144">
                  <c:v>606</c:v>
                </c:pt>
                <c:pt idx="145">
                  <c:v>605</c:v>
                </c:pt>
                <c:pt idx="146">
                  <c:v>604</c:v>
                </c:pt>
                <c:pt idx="147">
                  <c:v>603</c:v>
                </c:pt>
                <c:pt idx="148">
                  <c:v>602</c:v>
                </c:pt>
                <c:pt idx="149">
                  <c:v>601</c:v>
                </c:pt>
                <c:pt idx="150">
                  <c:v>600</c:v>
                </c:pt>
                <c:pt idx="151">
                  <c:v>599</c:v>
                </c:pt>
                <c:pt idx="152">
                  <c:v>598</c:v>
                </c:pt>
                <c:pt idx="153">
                  <c:v>597</c:v>
                </c:pt>
                <c:pt idx="154">
                  <c:v>596</c:v>
                </c:pt>
                <c:pt idx="155">
                  <c:v>595</c:v>
                </c:pt>
                <c:pt idx="156">
                  <c:v>594</c:v>
                </c:pt>
                <c:pt idx="157">
                  <c:v>593</c:v>
                </c:pt>
                <c:pt idx="158">
                  <c:v>592</c:v>
                </c:pt>
                <c:pt idx="159">
                  <c:v>591</c:v>
                </c:pt>
                <c:pt idx="160">
                  <c:v>590</c:v>
                </c:pt>
                <c:pt idx="161">
                  <c:v>589</c:v>
                </c:pt>
                <c:pt idx="162">
                  <c:v>588</c:v>
                </c:pt>
                <c:pt idx="163">
                  <c:v>587</c:v>
                </c:pt>
                <c:pt idx="164">
                  <c:v>586</c:v>
                </c:pt>
                <c:pt idx="165">
                  <c:v>585</c:v>
                </c:pt>
                <c:pt idx="166">
                  <c:v>584</c:v>
                </c:pt>
                <c:pt idx="167">
                  <c:v>583</c:v>
                </c:pt>
                <c:pt idx="168">
                  <c:v>582</c:v>
                </c:pt>
                <c:pt idx="169">
                  <c:v>581</c:v>
                </c:pt>
                <c:pt idx="170">
                  <c:v>580</c:v>
                </c:pt>
                <c:pt idx="171">
                  <c:v>579</c:v>
                </c:pt>
                <c:pt idx="172">
                  <c:v>578</c:v>
                </c:pt>
                <c:pt idx="173">
                  <c:v>577</c:v>
                </c:pt>
                <c:pt idx="174">
                  <c:v>576</c:v>
                </c:pt>
                <c:pt idx="175">
                  <c:v>575</c:v>
                </c:pt>
                <c:pt idx="176">
                  <c:v>574</c:v>
                </c:pt>
                <c:pt idx="177">
                  <c:v>573</c:v>
                </c:pt>
                <c:pt idx="178">
                  <c:v>572</c:v>
                </c:pt>
                <c:pt idx="179">
                  <c:v>571</c:v>
                </c:pt>
                <c:pt idx="180">
                  <c:v>570</c:v>
                </c:pt>
                <c:pt idx="181">
                  <c:v>569</c:v>
                </c:pt>
                <c:pt idx="182">
                  <c:v>568</c:v>
                </c:pt>
                <c:pt idx="183">
                  <c:v>567</c:v>
                </c:pt>
                <c:pt idx="184">
                  <c:v>566</c:v>
                </c:pt>
                <c:pt idx="185">
                  <c:v>565</c:v>
                </c:pt>
                <c:pt idx="186">
                  <c:v>564</c:v>
                </c:pt>
                <c:pt idx="187">
                  <c:v>563</c:v>
                </c:pt>
                <c:pt idx="188">
                  <c:v>562</c:v>
                </c:pt>
                <c:pt idx="189">
                  <c:v>561</c:v>
                </c:pt>
                <c:pt idx="190">
                  <c:v>560</c:v>
                </c:pt>
                <c:pt idx="191">
                  <c:v>559</c:v>
                </c:pt>
                <c:pt idx="192">
                  <c:v>558</c:v>
                </c:pt>
                <c:pt idx="193">
                  <c:v>557</c:v>
                </c:pt>
                <c:pt idx="194">
                  <c:v>556</c:v>
                </c:pt>
                <c:pt idx="195">
                  <c:v>555</c:v>
                </c:pt>
                <c:pt idx="196">
                  <c:v>554</c:v>
                </c:pt>
                <c:pt idx="197">
                  <c:v>553</c:v>
                </c:pt>
                <c:pt idx="198">
                  <c:v>552</c:v>
                </c:pt>
                <c:pt idx="199">
                  <c:v>551</c:v>
                </c:pt>
                <c:pt idx="200">
                  <c:v>550</c:v>
                </c:pt>
                <c:pt idx="201">
                  <c:v>549</c:v>
                </c:pt>
                <c:pt idx="202">
                  <c:v>548</c:v>
                </c:pt>
                <c:pt idx="203">
                  <c:v>547</c:v>
                </c:pt>
                <c:pt idx="204">
                  <c:v>546</c:v>
                </c:pt>
                <c:pt idx="205">
                  <c:v>545</c:v>
                </c:pt>
                <c:pt idx="206">
                  <c:v>544</c:v>
                </c:pt>
                <c:pt idx="207">
                  <c:v>543</c:v>
                </c:pt>
                <c:pt idx="208">
                  <c:v>542</c:v>
                </c:pt>
                <c:pt idx="209">
                  <c:v>541</c:v>
                </c:pt>
                <c:pt idx="210">
                  <c:v>540</c:v>
                </c:pt>
                <c:pt idx="211">
                  <c:v>539</c:v>
                </c:pt>
                <c:pt idx="212">
                  <c:v>538</c:v>
                </c:pt>
                <c:pt idx="213">
                  <c:v>537</c:v>
                </c:pt>
                <c:pt idx="214">
                  <c:v>536</c:v>
                </c:pt>
                <c:pt idx="215">
                  <c:v>535</c:v>
                </c:pt>
                <c:pt idx="216">
                  <c:v>534</c:v>
                </c:pt>
                <c:pt idx="217">
                  <c:v>533</c:v>
                </c:pt>
                <c:pt idx="218">
                  <c:v>532</c:v>
                </c:pt>
                <c:pt idx="219">
                  <c:v>531</c:v>
                </c:pt>
                <c:pt idx="220">
                  <c:v>530</c:v>
                </c:pt>
                <c:pt idx="221">
                  <c:v>529</c:v>
                </c:pt>
                <c:pt idx="222">
                  <c:v>528</c:v>
                </c:pt>
                <c:pt idx="223">
                  <c:v>527</c:v>
                </c:pt>
                <c:pt idx="224">
                  <c:v>526</c:v>
                </c:pt>
                <c:pt idx="225">
                  <c:v>525</c:v>
                </c:pt>
                <c:pt idx="226">
                  <c:v>524</c:v>
                </c:pt>
                <c:pt idx="227">
                  <c:v>523</c:v>
                </c:pt>
                <c:pt idx="228">
                  <c:v>522</c:v>
                </c:pt>
                <c:pt idx="229">
                  <c:v>521</c:v>
                </c:pt>
                <c:pt idx="230">
                  <c:v>520</c:v>
                </c:pt>
                <c:pt idx="231">
                  <c:v>519</c:v>
                </c:pt>
                <c:pt idx="232">
                  <c:v>518</c:v>
                </c:pt>
                <c:pt idx="233">
                  <c:v>517</c:v>
                </c:pt>
                <c:pt idx="234">
                  <c:v>516</c:v>
                </c:pt>
                <c:pt idx="235">
                  <c:v>515</c:v>
                </c:pt>
                <c:pt idx="236">
                  <c:v>514</c:v>
                </c:pt>
                <c:pt idx="237">
                  <c:v>513</c:v>
                </c:pt>
                <c:pt idx="238">
                  <c:v>512</c:v>
                </c:pt>
                <c:pt idx="239">
                  <c:v>511</c:v>
                </c:pt>
                <c:pt idx="240">
                  <c:v>510</c:v>
                </c:pt>
                <c:pt idx="241">
                  <c:v>509</c:v>
                </c:pt>
                <c:pt idx="242">
                  <c:v>508</c:v>
                </c:pt>
                <c:pt idx="243">
                  <c:v>507</c:v>
                </c:pt>
                <c:pt idx="244">
                  <c:v>506</c:v>
                </c:pt>
                <c:pt idx="245">
                  <c:v>505</c:v>
                </c:pt>
                <c:pt idx="246">
                  <c:v>504</c:v>
                </c:pt>
                <c:pt idx="247">
                  <c:v>503</c:v>
                </c:pt>
                <c:pt idx="248">
                  <c:v>502</c:v>
                </c:pt>
                <c:pt idx="249">
                  <c:v>501</c:v>
                </c:pt>
                <c:pt idx="250">
                  <c:v>500</c:v>
                </c:pt>
                <c:pt idx="251">
                  <c:v>499</c:v>
                </c:pt>
                <c:pt idx="252">
                  <c:v>498</c:v>
                </c:pt>
                <c:pt idx="253">
                  <c:v>497</c:v>
                </c:pt>
                <c:pt idx="254">
                  <c:v>496</c:v>
                </c:pt>
                <c:pt idx="255">
                  <c:v>495</c:v>
                </c:pt>
                <c:pt idx="256">
                  <c:v>494</c:v>
                </c:pt>
                <c:pt idx="257">
                  <c:v>493</c:v>
                </c:pt>
                <c:pt idx="258">
                  <c:v>492</c:v>
                </c:pt>
                <c:pt idx="259">
                  <c:v>491</c:v>
                </c:pt>
                <c:pt idx="260">
                  <c:v>490</c:v>
                </c:pt>
                <c:pt idx="261">
                  <c:v>489</c:v>
                </c:pt>
                <c:pt idx="262">
                  <c:v>488</c:v>
                </c:pt>
                <c:pt idx="263">
                  <c:v>487</c:v>
                </c:pt>
                <c:pt idx="264">
                  <c:v>486</c:v>
                </c:pt>
                <c:pt idx="265">
                  <c:v>485</c:v>
                </c:pt>
                <c:pt idx="266">
                  <c:v>484</c:v>
                </c:pt>
                <c:pt idx="267">
                  <c:v>483</c:v>
                </c:pt>
                <c:pt idx="268">
                  <c:v>482</c:v>
                </c:pt>
                <c:pt idx="269">
                  <c:v>481</c:v>
                </c:pt>
                <c:pt idx="270">
                  <c:v>480</c:v>
                </c:pt>
                <c:pt idx="271">
                  <c:v>479</c:v>
                </c:pt>
                <c:pt idx="272">
                  <c:v>478</c:v>
                </c:pt>
                <c:pt idx="273">
                  <c:v>477</c:v>
                </c:pt>
                <c:pt idx="274">
                  <c:v>476</c:v>
                </c:pt>
                <c:pt idx="275">
                  <c:v>475</c:v>
                </c:pt>
                <c:pt idx="276">
                  <c:v>474</c:v>
                </c:pt>
                <c:pt idx="277">
                  <c:v>473</c:v>
                </c:pt>
                <c:pt idx="278">
                  <c:v>472</c:v>
                </c:pt>
                <c:pt idx="279">
                  <c:v>471</c:v>
                </c:pt>
                <c:pt idx="280">
                  <c:v>470</c:v>
                </c:pt>
                <c:pt idx="281">
                  <c:v>469</c:v>
                </c:pt>
                <c:pt idx="282">
                  <c:v>468</c:v>
                </c:pt>
                <c:pt idx="283">
                  <c:v>467</c:v>
                </c:pt>
                <c:pt idx="284">
                  <c:v>466</c:v>
                </c:pt>
                <c:pt idx="285">
                  <c:v>465</c:v>
                </c:pt>
                <c:pt idx="286">
                  <c:v>464</c:v>
                </c:pt>
                <c:pt idx="287">
                  <c:v>463</c:v>
                </c:pt>
                <c:pt idx="288">
                  <c:v>462</c:v>
                </c:pt>
                <c:pt idx="289">
                  <c:v>461</c:v>
                </c:pt>
                <c:pt idx="290">
                  <c:v>460</c:v>
                </c:pt>
                <c:pt idx="291">
                  <c:v>459</c:v>
                </c:pt>
                <c:pt idx="292">
                  <c:v>458</c:v>
                </c:pt>
                <c:pt idx="293">
                  <c:v>457</c:v>
                </c:pt>
                <c:pt idx="294">
                  <c:v>456</c:v>
                </c:pt>
                <c:pt idx="295">
                  <c:v>455</c:v>
                </c:pt>
                <c:pt idx="296">
                  <c:v>454</c:v>
                </c:pt>
                <c:pt idx="297">
                  <c:v>453</c:v>
                </c:pt>
                <c:pt idx="298">
                  <c:v>452</c:v>
                </c:pt>
                <c:pt idx="299">
                  <c:v>451</c:v>
                </c:pt>
                <c:pt idx="300">
                  <c:v>450</c:v>
                </c:pt>
                <c:pt idx="301">
                  <c:v>449</c:v>
                </c:pt>
                <c:pt idx="302">
                  <c:v>448</c:v>
                </c:pt>
                <c:pt idx="303">
                  <c:v>447</c:v>
                </c:pt>
                <c:pt idx="304">
                  <c:v>446</c:v>
                </c:pt>
                <c:pt idx="305">
                  <c:v>445</c:v>
                </c:pt>
                <c:pt idx="306">
                  <c:v>444</c:v>
                </c:pt>
                <c:pt idx="307">
                  <c:v>443</c:v>
                </c:pt>
                <c:pt idx="308">
                  <c:v>442</c:v>
                </c:pt>
                <c:pt idx="309">
                  <c:v>441</c:v>
                </c:pt>
                <c:pt idx="310">
                  <c:v>440</c:v>
                </c:pt>
                <c:pt idx="311">
                  <c:v>439</c:v>
                </c:pt>
                <c:pt idx="312">
                  <c:v>438</c:v>
                </c:pt>
                <c:pt idx="313">
                  <c:v>437</c:v>
                </c:pt>
                <c:pt idx="314">
                  <c:v>436</c:v>
                </c:pt>
                <c:pt idx="315">
                  <c:v>435</c:v>
                </c:pt>
                <c:pt idx="316">
                  <c:v>434</c:v>
                </c:pt>
                <c:pt idx="317">
                  <c:v>433</c:v>
                </c:pt>
                <c:pt idx="318">
                  <c:v>432</c:v>
                </c:pt>
                <c:pt idx="319">
                  <c:v>431</c:v>
                </c:pt>
                <c:pt idx="320">
                  <c:v>430</c:v>
                </c:pt>
                <c:pt idx="321">
                  <c:v>429</c:v>
                </c:pt>
                <c:pt idx="322">
                  <c:v>428</c:v>
                </c:pt>
                <c:pt idx="323">
                  <c:v>427</c:v>
                </c:pt>
                <c:pt idx="324">
                  <c:v>426</c:v>
                </c:pt>
                <c:pt idx="325">
                  <c:v>425</c:v>
                </c:pt>
                <c:pt idx="326">
                  <c:v>424</c:v>
                </c:pt>
                <c:pt idx="327">
                  <c:v>423</c:v>
                </c:pt>
                <c:pt idx="328">
                  <c:v>422</c:v>
                </c:pt>
                <c:pt idx="329">
                  <c:v>421</c:v>
                </c:pt>
                <c:pt idx="330">
                  <c:v>420</c:v>
                </c:pt>
                <c:pt idx="331">
                  <c:v>419</c:v>
                </c:pt>
                <c:pt idx="332">
                  <c:v>418</c:v>
                </c:pt>
                <c:pt idx="333">
                  <c:v>417</c:v>
                </c:pt>
                <c:pt idx="334">
                  <c:v>416</c:v>
                </c:pt>
                <c:pt idx="335">
                  <c:v>415</c:v>
                </c:pt>
                <c:pt idx="336">
                  <c:v>414</c:v>
                </c:pt>
                <c:pt idx="337">
                  <c:v>413</c:v>
                </c:pt>
                <c:pt idx="338">
                  <c:v>412</c:v>
                </c:pt>
                <c:pt idx="339">
                  <c:v>411</c:v>
                </c:pt>
                <c:pt idx="340">
                  <c:v>410</c:v>
                </c:pt>
                <c:pt idx="341">
                  <c:v>409</c:v>
                </c:pt>
                <c:pt idx="342">
                  <c:v>408</c:v>
                </c:pt>
                <c:pt idx="343">
                  <c:v>407</c:v>
                </c:pt>
                <c:pt idx="344">
                  <c:v>406</c:v>
                </c:pt>
                <c:pt idx="345">
                  <c:v>405</c:v>
                </c:pt>
                <c:pt idx="346">
                  <c:v>404</c:v>
                </c:pt>
                <c:pt idx="347">
                  <c:v>403</c:v>
                </c:pt>
                <c:pt idx="348">
                  <c:v>402</c:v>
                </c:pt>
                <c:pt idx="349">
                  <c:v>401</c:v>
                </c:pt>
                <c:pt idx="350">
                  <c:v>400</c:v>
                </c:pt>
                <c:pt idx="351">
                  <c:v>399</c:v>
                </c:pt>
                <c:pt idx="352">
                  <c:v>398</c:v>
                </c:pt>
                <c:pt idx="353">
                  <c:v>397</c:v>
                </c:pt>
                <c:pt idx="354">
                  <c:v>396</c:v>
                </c:pt>
                <c:pt idx="355">
                  <c:v>395</c:v>
                </c:pt>
                <c:pt idx="356">
                  <c:v>394</c:v>
                </c:pt>
                <c:pt idx="357">
                  <c:v>393</c:v>
                </c:pt>
                <c:pt idx="358">
                  <c:v>392</c:v>
                </c:pt>
                <c:pt idx="359">
                  <c:v>391</c:v>
                </c:pt>
                <c:pt idx="360">
                  <c:v>390</c:v>
                </c:pt>
                <c:pt idx="361">
                  <c:v>389</c:v>
                </c:pt>
                <c:pt idx="362">
                  <c:v>388</c:v>
                </c:pt>
                <c:pt idx="363">
                  <c:v>387</c:v>
                </c:pt>
                <c:pt idx="364">
                  <c:v>386</c:v>
                </c:pt>
                <c:pt idx="365">
                  <c:v>385</c:v>
                </c:pt>
                <c:pt idx="366">
                  <c:v>384</c:v>
                </c:pt>
                <c:pt idx="367">
                  <c:v>383</c:v>
                </c:pt>
                <c:pt idx="368">
                  <c:v>382</c:v>
                </c:pt>
                <c:pt idx="369">
                  <c:v>381</c:v>
                </c:pt>
                <c:pt idx="370">
                  <c:v>380</c:v>
                </c:pt>
                <c:pt idx="371">
                  <c:v>379</c:v>
                </c:pt>
                <c:pt idx="372">
                  <c:v>378</c:v>
                </c:pt>
                <c:pt idx="373">
                  <c:v>377</c:v>
                </c:pt>
                <c:pt idx="374">
                  <c:v>376</c:v>
                </c:pt>
                <c:pt idx="375">
                  <c:v>375</c:v>
                </c:pt>
                <c:pt idx="376">
                  <c:v>374</c:v>
                </c:pt>
                <c:pt idx="377">
                  <c:v>373</c:v>
                </c:pt>
                <c:pt idx="378">
                  <c:v>372</c:v>
                </c:pt>
                <c:pt idx="379">
                  <c:v>371</c:v>
                </c:pt>
                <c:pt idx="380">
                  <c:v>370</c:v>
                </c:pt>
                <c:pt idx="381">
                  <c:v>369</c:v>
                </c:pt>
                <c:pt idx="382">
                  <c:v>368</c:v>
                </c:pt>
                <c:pt idx="383">
                  <c:v>367</c:v>
                </c:pt>
                <c:pt idx="384">
                  <c:v>366</c:v>
                </c:pt>
                <c:pt idx="385">
                  <c:v>365</c:v>
                </c:pt>
                <c:pt idx="386">
                  <c:v>364</c:v>
                </c:pt>
                <c:pt idx="387">
                  <c:v>363</c:v>
                </c:pt>
                <c:pt idx="388">
                  <c:v>362</c:v>
                </c:pt>
                <c:pt idx="389">
                  <c:v>361</c:v>
                </c:pt>
                <c:pt idx="390">
                  <c:v>360</c:v>
                </c:pt>
                <c:pt idx="391">
                  <c:v>359</c:v>
                </c:pt>
                <c:pt idx="392">
                  <c:v>358</c:v>
                </c:pt>
                <c:pt idx="393">
                  <c:v>357</c:v>
                </c:pt>
                <c:pt idx="394">
                  <c:v>356</c:v>
                </c:pt>
                <c:pt idx="395">
                  <c:v>355</c:v>
                </c:pt>
                <c:pt idx="396">
                  <c:v>354</c:v>
                </c:pt>
                <c:pt idx="397">
                  <c:v>353</c:v>
                </c:pt>
                <c:pt idx="398">
                  <c:v>352</c:v>
                </c:pt>
                <c:pt idx="399">
                  <c:v>351</c:v>
                </c:pt>
                <c:pt idx="400">
                  <c:v>350</c:v>
                </c:pt>
                <c:pt idx="401">
                  <c:v>349</c:v>
                </c:pt>
                <c:pt idx="402">
                  <c:v>348</c:v>
                </c:pt>
                <c:pt idx="403">
                  <c:v>347</c:v>
                </c:pt>
                <c:pt idx="404">
                  <c:v>346</c:v>
                </c:pt>
                <c:pt idx="405">
                  <c:v>345</c:v>
                </c:pt>
                <c:pt idx="406">
                  <c:v>344</c:v>
                </c:pt>
                <c:pt idx="407">
                  <c:v>343</c:v>
                </c:pt>
                <c:pt idx="408">
                  <c:v>342</c:v>
                </c:pt>
                <c:pt idx="409">
                  <c:v>341</c:v>
                </c:pt>
                <c:pt idx="410">
                  <c:v>340</c:v>
                </c:pt>
                <c:pt idx="411">
                  <c:v>339</c:v>
                </c:pt>
                <c:pt idx="412">
                  <c:v>338</c:v>
                </c:pt>
                <c:pt idx="413">
                  <c:v>337</c:v>
                </c:pt>
                <c:pt idx="414">
                  <c:v>336</c:v>
                </c:pt>
                <c:pt idx="415">
                  <c:v>335</c:v>
                </c:pt>
                <c:pt idx="416">
                  <c:v>334</c:v>
                </c:pt>
                <c:pt idx="417">
                  <c:v>333</c:v>
                </c:pt>
                <c:pt idx="418">
                  <c:v>332</c:v>
                </c:pt>
                <c:pt idx="419">
                  <c:v>331</c:v>
                </c:pt>
                <c:pt idx="420">
                  <c:v>330</c:v>
                </c:pt>
                <c:pt idx="421">
                  <c:v>329</c:v>
                </c:pt>
                <c:pt idx="422">
                  <c:v>328</c:v>
                </c:pt>
                <c:pt idx="423">
                  <c:v>327</c:v>
                </c:pt>
                <c:pt idx="424">
                  <c:v>326</c:v>
                </c:pt>
                <c:pt idx="425">
                  <c:v>325</c:v>
                </c:pt>
                <c:pt idx="426">
                  <c:v>324</c:v>
                </c:pt>
                <c:pt idx="427">
                  <c:v>323</c:v>
                </c:pt>
                <c:pt idx="428">
                  <c:v>322</c:v>
                </c:pt>
                <c:pt idx="429">
                  <c:v>321</c:v>
                </c:pt>
                <c:pt idx="430">
                  <c:v>320</c:v>
                </c:pt>
                <c:pt idx="431">
                  <c:v>319</c:v>
                </c:pt>
                <c:pt idx="432">
                  <c:v>318</c:v>
                </c:pt>
                <c:pt idx="433">
                  <c:v>317</c:v>
                </c:pt>
                <c:pt idx="434">
                  <c:v>316</c:v>
                </c:pt>
                <c:pt idx="435">
                  <c:v>315</c:v>
                </c:pt>
                <c:pt idx="436">
                  <c:v>314</c:v>
                </c:pt>
                <c:pt idx="437">
                  <c:v>313</c:v>
                </c:pt>
                <c:pt idx="438">
                  <c:v>312</c:v>
                </c:pt>
                <c:pt idx="439">
                  <c:v>311</c:v>
                </c:pt>
                <c:pt idx="440">
                  <c:v>310</c:v>
                </c:pt>
                <c:pt idx="441">
                  <c:v>309</c:v>
                </c:pt>
                <c:pt idx="442">
                  <c:v>308</c:v>
                </c:pt>
                <c:pt idx="443">
                  <c:v>307</c:v>
                </c:pt>
                <c:pt idx="444">
                  <c:v>306</c:v>
                </c:pt>
                <c:pt idx="445">
                  <c:v>305</c:v>
                </c:pt>
                <c:pt idx="446">
                  <c:v>304</c:v>
                </c:pt>
                <c:pt idx="447">
                  <c:v>303</c:v>
                </c:pt>
                <c:pt idx="448">
                  <c:v>302</c:v>
                </c:pt>
                <c:pt idx="449">
                  <c:v>301</c:v>
                </c:pt>
                <c:pt idx="450">
                  <c:v>300</c:v>
                </c:pt>
                <c:pt idx="451">
                  <c:v>299</c:v>
                </c:pt>
                <c:pt idx="452">
                  <c:v>298</c:v>
                </c:pt>
                <c:pt idx="453">
                  <c:v>297</c:v>
                </c:pt>
                <c:pt idx="454">
                  <c:v>296</c:v>
                </c:pt>
                <c:pt idx="455">
                  <c:v>295</c:v>
                </c:pt>
                <c:pt idx="456">
                  <c:v>294</c:v>
                </c:pt>
                <c:pt idx="457">
                  <c:v>293</c:v>
                </c:pt>
                <c:pt idx="458">
                  <c:v>292</c:v>
                </c:pt>
                <c:pt idx="459">
                  <c:v>291</c:v>
                </c:pt>
                <c:pt idx="460">
                  <c:v>290</c:v>
                </c:pt>
                <c:pt idx="461">
                  <c:v>289</c:v>
                </c:pt>
                <c:pt idx="462">
                  <c:v>288</c:v>
                </c:pt>
                <c:pt idx="463">
                  <c:v>287</c:v>
                </c:pt>
                <c:pt idx="464">
                  <c:v>286</c:v>
                </c:pt>
                <c:pt idx="465">
                  <c:v>285</c:v>
                </c:pt>
                <c:pt idx="466">
                  <c:v>284</c:v>
                </c:pt>
                <c:pt idx="467">
                  <c:v>283</c:v>
                </c:pt>
                <c:pt idx="468">
                  <c:v>282</c:v>
                </c:pt>
                <c:pt idx="469">
                  <c:v>281</c:v>
                </c:pt>
                <c:pt idx="470">
                  <c:v>280</c:v>
                </c:pt>
                <c:pt idx="471">
                  <c:v>279</c:v>
                </c:pt>
                <c:pt idx="472">
                  <c:v>278</c:v>
                </c:pt>
                <c:pt idx="473">
                  <c:v>277</c:v>
                </c:pt>
                <c:pt idx="474">
                  <c:v>276</c:v>
                </c:pt>
                <c:pt idx="475">
                  <c:v>275</c:v>
                </c:pt>
                <c:pt idx="476">
                  <c:v>274</c:v>
                </c:pt>
                <c:pt idx="477">
                  <c:v>273</c:v>
                </c:pt>
                <c:pt idx="478">
                  <c:v>272</c:v>
                </c:pt>
                <c:pt idx="479">
                  <c:v>271</c:v>
                </c:pt>
                <c:pt idx="480">
                  <c:v>270</c:v>
                </c:pt>
                <c:pt idx="481">
                  <c:v>269</c:v>
                </c:pt>
                <c:pt idx="482">
                  <c:v>268</c:v>
                </c:pt>
                <c:pt idx="483">
                  <c:v>267</c:v>
                </c:pt>
                <c:pt idx="484">
                  <c:v>266</c:v>
                </c:pt>
                <c:pt idx="485">
                  <c:v>265</c:v>
                </c:pt>
                <c:pt idx="486">
                  <c:v>264</c:v>
                </c:pt>
                <c:pt idx="487">
                  <c:v>263</c:v>
                </c:pt>
                <c:pt idx="488">
                  <c:v>262</c:v>
                </c:pt>
                <c:pt idx="489">
                  <c:v>261</c:v>
                </c:pt>
                <c:pt idx="490">
                  <c:v>260</c:v>
                </c:pt>
                <c:pt idx="491">
                  <c:v>259</c:v>
                </c:pt>
                <c:pt idx="492">
                  <c:v>258</c:v>
                </c:pt>
                <c:pt idx="493">
                  <c:v>257</c:v>
                </c:pt>
                <c:pt idx="494">
                  <c:v>256</c:v>
                </c:pt>
                <c:pt idx="495">
                  <c:v>255</c:v>
                </c:pt>
                <c:pt idx="496">
                  <c:v>254</c:v>
                </c:pt>
                <c:pt idx="497">
                  <c:v>253</c:v>
                </c:pt>
                <c:pt idx="498">
                  <c:v>252</c:v>
                </c:pt>
                <c:pt idx="499">
                  <c:v>251</c:v>
                </c:pt>
                <c:pt idx="500">
                  <c:v>250</c:v>
                </c:pt>
              </c:numCache>
            </c:numRef>
          </c:xVal>
          <c:yVal>
            <c:numRef>
              <c:f>'SPETTRI Sorgente-Filtri'!$B$2:$B$552</c:f>
              <c:numCache>
                <c:formatCode>General</c:formatCode>
                <c:ptCount val="551"/>
                <c:pt idx="0">
                  <c:v>3.716621693087882E-2</c:v>
                </c:pt>
                <c:pt idx="1">
                  <c:v>3.8615977175754337E-2</c:v>
                </c:pt>
                <c:pt idx="2">
                  <c:v>3.993422351621622E-2</c:v>
                </c:pt>
                <c:pt idx="3">
                  <c:v>4.1419804518714382E-2</c:v>
                </c:pt>
                <c:pt idx="4">
                  <c:v>4.2773010837817288E-2</c:v>
                </c:pt>
                <c:pt idx="5">
                  <c:v>4.4424270564311058E-2</c:v>
                </c:pt>
                <c:pt idx="6">
                  <c:v>4.6016815900266204E-2</c:v>
                </c:pt>
                <c:pt idx="7">
                  <c:v>4.7870424307373163E-2</c:v>
                </c:pt>
                <c:pt idx="8">
                  <c:v>4.9656706674129809E-2</c:v>
                </c:pt>
                <c:pt idx="9">
                  <c:v>5.1754019752924457E-2</c:v>
                </c:pt>
                <c:pt idx="10">
                  <c:v>5.3917987232864444E-2</c:v>
                </c:pt>
                <c:pt idx="11">
                  <c:v>5.6217309312674407E-2</c:v>
                </c:pt>
                <c:pt idx="12">
                  <c:v>5.8612471219102014E-2</c:v>
                </c:pt>
                <c:pt idx="13">
                  <c:v>6.1130404140286719E-2</c:v>
                </c:pt>
                <c:pt idx="14">
                  <c:v>6.3708159270699297E-2</c:v>
                </c:pt>
                <c:pt idx="15">
                  <c:v>6.6506046080687303E-2</c:v>
                </c:pt>
                <c:pt idx="16">
                  <c:v>6.9360906423273305E-2</c:v>
                </c:pt>
                <c:pt idx="17">
                  <c:v>7.2492505278466637E-2</c:v>
                </c:pt>
                <c:pt idx="18">
                  <c:v>7.5754903938918386E-2</c:v>
                </c:pt>
                <c:pt idx="19">
                  <c:v>7.8905046212174312E-2</c:v>
                </c:pt>
                <c:pt idx="20">
                  <c:v>8.2193577041710583E-2</c:v>
                </c:pt>
                <c:pt idx="21">
                  <c:v>8.5918549834918798E-2</c:v>
                </c:pt>
                <c:pt idx="22">
                  <c:v>8.9464650439739959E-2</c:v>
                </c:pt>
                <c:pt idx="23">
                  <c:v>9.28515725528756E-2</c:v>
                </c:pt>
                <c:pt idx="24">
                  <c:v>9.6486175132995497E-2</c:v>
                </c:pt>
                <c:pt idx="25">
                  <c:v>0.1001755433283254</c:v>
                </c:pt>
                <c:pt idx="26">
                  <c:v>0.1041268044938254</c:v>
                </c:pt>
                <c:pt idx="27">
                  <c:v>0.10838513601604889</c:v>
                </c:pt>
                <c:pt idx="28">
                  <c:v>0.11278290601331095</c:v>
                </c:pt>
                <c:pt idx="29">
                  <c:v>0.11723057031154611</c:v>
                </c:pt>
                <c:pt idx="30">
                  <c:v>0.12141022740684461</c:v>
                </c:pt>
                <c:pt idx="31">
                  <c:v>0.12632396299369883</c:v>
                </c:pt>
                <c:pt idx="32">
                  <c:v>0.1314432819373399</c:v>
                </c:pt>
                <c:pt idx="33">
                  <c:v>0.13672909792400817</c:v>
                </c:pt>
                <c:pt idx="34">
                  <c:v>0.14240850992503659</c:v>
                </c:pt>
                <c:pt idx="35">
                  <c:v>0.14870075024106458</c:v>
                </c:pt>
                <c:pt idx="36">
                  <c:v>0.15445876718910029</c:v>
                </c:pt>
                <c:pt idx="37">
                  <c:v>0.16092788793587165</c:v>
                </c:pt>
                <c:pt idx="38">
                  <c:v>0.16799086126009169</c:v>
                </c:pt>
                <c:pt idx="39">
                  <c:v>0.17493666056293336</c:v>
                </c:pt>
                <c:pt idx="40">
                  <c:v>0.18259773245957875</c:v>
                </c:pt>
                <c:pt idx="41">
                  <c:v>0.19000872297208046</c:v>
                </c:pt>
                <c:pt idx="42">
                  <c:v>0.19784835825747837</c:v>
                </c:pt>
                <c:pt idx="43">
                  <c:v>0.20617876880226965</c:v>
                </c:pt>
                <c:pt idx="44">
                  <c:v>0.21469533920682615</c:v>
                </c:pt>
                <c:pt idx="45">
                  <c:v>0.22350945349937643</c:v>
                </c:pt>
                <c:pt idx="46">
                  <c:v>0.23225666635107375</c:v>
                </c:pt>
                <c:pt idx="47">
                  <c:v>0.24113068777275137</c:v>
                </c:pt>
                <c:pt idx="48">
                  <c:v>0.24987112247246759</c:v>
                </c:pt>
                <c:pt idx="49">
                  <c:v>0.25989315285600534</c:v>
                </c:pt>
                <c:pt idx="50">
                  <c:v>0.26879816232102122</c:v>
                </c:pt>
                <c:pt idx="51">
                  <c:v>0.27860251984207574</c:v>
                </c:pt>
                <c:pt idx="52">
                  <c:v>0.28832692913770891</c:v>
                </c:pt>
                <c:pt idx="53">
                  <c:v>0.29842026135689326</c:v>
                </c:pt>
                <c:pt idx="54">
                  <c:v>0.30848746912698388</c:v>
                </c:pt>
                <c:pt idx="55">
                  <c:v>0.31738803187726178</c:v>
                </c:pt>
                <c:pt idx="56">
                  <c:v>0.329292659233614</c:v>
                </c:pt>
                <c:pt idx="57">
                  <c:v>0.33928504485222</c:v>
                </c:pt>
                <c:pt idx="58">
                  <c:v>0.34933749199977432</c:v>
                </c:pt>
                <c:pt idx="59">
                  <c:v>0.36015069792731985</c:v>
                </c:pt>
                <c:pt idx="60">
                  <c:v>0.37139406174597073</c:v>
                </c:pt>
                <c:pt idx="61">
                  <c:v>0.38073787549186455</c:v>
                </c:pt>
                <c:pt idx="62">
                  <c:v>0.3910818912544794</c:v>
                </c:pt>
                <c:pt idx="63">
                  <c:v>0.40221986175781399</c:v>
                </c:pt>
                <c:pt idx="64">
                  <c:v>0.41245564324847567</c:v>
                </c:pt>
                <c:pt idx="65">
                  <c:v>0.42535713758549215</c:v>
                </c:pt>
                <c:pt idx="66">
                  <c:v>0.43577270222346209</c:v>
                </c:pt>
                <c:pt idx="67">
                  <c:v>0.44630721648070987</c:v>
                </c:pt>
                <c:pt idx="68">
                  <c:v>0.45776220068900764</c:v>
                </c:pt>
                <c:pt idx="69">
                  <c:v>0.46854847928840615</c:v>
                </c:pt>
                <c:pt idx="70">
                  <c:v>0.48004567640676277</c:v>
                </c:pt>
                <c:pt idx="71">
                  <c:v>0.49139631721850086</c:v>
                </c:pt>
                <c:pt idx="72">
                  <c:v>0.50231936317610071</c:v>
                </c:pt>
                <c:pt idx="73">
                  <c:v>0.51421102094779414</c:v>
                </c:pt>
                <c:pt idx="74">
                  <c:v>0.52611941565968801</c:v>
                </c:pt>
                <c:pt idx="75">
                  <c:v>0.53765197033621381</c:v>
                </c:pt>
                <c:pt idx="76">
                  <c:v>0.54921200818022575</c:v>
                </c:pt>
                <c:pt idx="77">
                  <c:v>0.56037122409842854</c:v>
                </c:pt>
                <c:pt idx="78">
                  <c:v>0.57119638057183453</c:v>
                </c:pt>
                <c:pt idx="79">
                  <c:v>0.58245521525218158</c:v>
                </c:pt>
                <c:pt idx="80">
                  <c:v>0.59448382566185509</c:v>
                </c:pt>
                <c:pt idx="81">
                  <c:v>0.60638527238196849</c:v>
                </c:pt>
                <c:pt idx="82">
                  <c:v>0.6169987775857666</c:v>
                </c:pt>
                <c:pt idx="83">
                  <c:v>0.62904807757096382</c:v>
                </c:pt>
                <c:pt idx="84">
                  <c:v>0.64075176900502795</c:v>
                </c:pt>
                <c:pt idx="85">
                  <c:v>0.65285739404359022</c:v>
                </c:pt>
                <c:pt idx="86">
                  <c:v>0.66331822870800339</c:v>
                </c:pt>
                <c:pt idx="87">
                  <c:v>0.67521776087037977</c:v>
                </c:pt>
                <c:pt idx="88">
                  <c:v>0.68572213628328349</c:v>
                </c:pt>
                <c:pt idx="89">
                  <c:v>0.69669940745673486</c:v>
                </c:pt>
                <c:pt idx="90">
                  <c:v>0.7081366665659975</c:v>
                </c:pt>
                <c:pt idx="91">
                  <c:v>0.71765590938435475</c:v>
                </c:pt>
                <c:pt idx="92">
                  <c:v>0.72911978702212854</c:v>
                </c:pt>
                <c:pt idx="93">
                  <c:v>0.73931375704225277</c:v>
                </c:pt>
                <c:pt idx="94">
                  <c:v>0.74914692556922258</c:v>
                </c:pt>
                <c:pt idx="95">
                  <c:v>0.75747068148188579</c:v>
                </c:pt>
                <c:pt idx="96">
                  <c:v>0.7667634506481692</c:v>
                </c:pt>
                <c:pt idx="97">
                  <c:v>0.77618029550766499</c:v>
                </c:pt>
                <c:pt idx="98">
                  <c:v>0.78609041690359371</c:v>
                </c:pt>
                <c:pt idx="99">
                  <c:v>0.79374753616491533</c:v>
                </c:pt>
                <c:pt idx="100">
                  <c:v>0.80339499259158953</c:v>
                </c:pt>
                <c:pt idx="101">
                  <c:v>0.81324557741795345</c:v>
                </c:pt>
                <c:pt idx="102">
                  <c:v>0.82266001364029728</c:v>
                </c:pt>
                <c:pt idx="103">
                  <c:v>0.82988018141855091</c:v>
                </c:pt>
                <c:pt idx="104">
                  <c:v>0.83950027819759065</c:v>
                </c:pt>
                <c:pt idx="105">
                  <c:v>0.84760836844539567</c:v>
                </c:pt>
                <c:pt idx="106">
                  <c:v>0.85814856461592226</c:v>
                </c:pt>
                <c:pt idx="107">
                  <c:v>0.86752464792364226</c:v>
                </c:pt>
                <c:pt idx="108">
                  <c:v>0.87634402724996319</c:v>
                </c:pt>
                <c:pt idx="109">
                  <c:v>0.88726404697114214</c:v>
                </c:pt>
                <c:pt idx="110">
                  <c:v>0.89635739333335041</c:v>
                </c:pt>
                <c:pt idx="111">
                  <c:v>0.9037297375715716</c:v>
                </c:pt>
                <c:pt idx="112">
                  <c:v>0.91291053599032124</c:v>
                </c:pt>
                <c:pt idx="113">
                  <c:v>0.92057290484543153</c:v>
                </c:pt>
                <c:pt idx="114">
                  <c:v>0.92963963267912875</c:v>
                </c:pt>
                <c:pt idx="115">
                  <c:v>0.93771659592376022</c:v>
                </c:pt>
                <c:pt idx="116">
                  <c:v>0.94726381598901588</c:v>
                </c:pt>
                <c:pt idx="117">
                  <c:v>0.95394420200585239</c:v>
                </c:pt>
                <c:pt idx="118">
                  <c:v>0.96197490706520572</c:v>
                </c:pt>
                <c:pt idx="119">
                  <c:v>0.97031008856435363</c:v>
                </c:pt>
                <c:pt idx="120">
                  <c:v>0.97300788569275054</c:v>
                </c:pt>
                <c:pt idx="121">
                  <c:v>0.98137567643332158</c:v>
                </c:pt>
                <c:pt idx="122">
                  <c:v>0.98700077057861024</c:v>
                </c:pt>
                <c:pt idx="123">
                  <c:v>0.98970807873575473</c:v>
                </c:pt>
                <c:pt idx="124">
                  <c:v>0.99146527217692515</c:v>
                </c:pt>
                <c:pt idx="125">
                  <c:v>0.99567884319210109</c:v>
                </c:pt>
                <c:pt idx="126">
                  <c:v>0.99530420747531012</c:v>
                </c:pt>
                <c:pt idx="127">
                  <c:v>0.99941729508936406</c:v>
                </c:pt>
                <c:pt idx="128">
                  <c:v>0.99719319660056038</c:v>
                </c:pt>
                <c:pt idx="129">
                  <c:v>0.99775095050071616</c:v>
                </c:pt>
                <c:pt idx="130">
                  <c:v>0.99862534754626953</c:v>
                </c:pt>
                <c:pt idx="131">
                  <c:v>1</c:v>
                </c:pt>
                <c:pt idx="132">
                  <c:v>0.9991473424487296</c:v>
                </c:pt>
                <c:pt idx="133">
                  <c:v>0.99707850841624146</c:v>
                </c:pt>
                <c:pt idx="134">
                  <c:v>0.99912856743094036</c:v>
                </c:pt>
                <c:pt idx="135">
                  <c:v>0.99673469090299094</c:v>
                </c:pt>
                <c:pt idx="136">
                  <c:v>0.99541432542503672</c:v>
                </c:pt>
                <c:pt idx="137">
                  <c:v>0.9929787609464068</c:v>
                </c:pt>
                <c:pt idx="138">
                  <c:v>0.9928489415799886</c:v>
                </c:pt>
                <c:pt idx="139">
                  <c:v>0.98975711611774242</c:v>
                </c:pt>
                <c:pt idx="140">
                  <c:v>0.98753672322455588</c:v>
                </c:pt>
                <c:pt idx="141">
                  <c:v>0.98854828906783188</c:v>
                </c:pt>
                <c:pt idx="142">
                  <c:v>0.98573506263599264</c:v>
                </c:pt>
                <c:pt idx="143">
                  <c:v>0.9833225963700355</c:v>
                </c:pt>
                <c:pt idx="144">
                  <c:v>0.97788228792614018</c:v>
                </c:pt>
                <c:pt idx="145">
                  <c:v>0.97038444751638442</c:v>
                </c:pt>
                <c:pt idx="146">
                  <c:v>0.96723524708201392</c:v>
                </c:pt>
                <c:pt idx="147">
                  <c:v>0.96083469529412258</c:v>
                </c:pt>
                <c:pt idx="148">
                  <c:v>0.95670795873621639</c:v>
                </c:pt>
                <c:pt idx="149">
                  <c:v>0.95144539536204042</c:v>
                </c:pt>
                <c:pt idx="150">
                  <c:v>0.94504996964808596</c:v>
                </c:pt>
                <c:pt idx="151">
                  <c:v>0.94026629274736462</c:v>
                </c:pt>
                <c:pt idx="152">
                  <c:v>0.93578289261140857</c:v>
                </c:pt>
                <c:pt idx="153">
                  <c:v>0.92851733128685721</c:v>
                </c:pt>
                <c:pt idx="154">
                  <c:v>0.92197244654971755</c:v>
                </c:pt>
                <c:pt idx="155">
                  <c:v>0.91541181303120966</c:v>
                </c:pt>
                <c:pt idx="156">
                  <c:v>0.91138580691413662</c:v>
                </c:pt>
                <c:pt idx="157">
                  <c:v>0.9031411037079482</c:v>
                </c:pt>
                <c:pt idx="158">
                  <c:v>0.89715156423381526</c:v>
                </c:pt>
                <c:pt idx="159">
                  <c:v>0.89327680817780486</c:v>
                </c:pt>
                <c:pt idx="160">
                  <c:v>0.88401714233236184</c:v>
                </c:pt>
                <c:pt idx="161">
                  <c:v>0.87851013316737347</c:v>
                </c:pt>
                <c:pt idx="162">
                  <c:v>0.87039574340702053</c:v>
                </c:pt>
                <c:pt idx="163">
                  <c:v>0.86270700306310788</c:v>
                </c:pt>
                <c:pt idx="164">
                  <c:v>0.8575617835501087</c:v>
                </c:pt>
                <c:pt idx="165">
                  <c:v>0.85144279526911548</c:v>
                </c:pt>
                <c:pt idx="166">
                  <c:v>0.8457321018650954</c:v>
                </c:pt>
                <c:pt idx="167">
                  <c:v>0.83976936619924991</c:v>
                </c:pt>
                <c:pt idx="168">
                  <c:v>0.83355742922822063</c:v>
                </c:pt>
                <c:pt idx="169">
                  <c:v>0.82791522758317126</c:v>
                </c:pt>
                <c:pt idx="170">
                  <c:v>0.82080523951457141</c:v>
                </c:pt>
                <c:pt idx="171">
                  <c:v>0.81570399306954755</c:v>
                </c:pt>
                <c:pt idx="172">
                  <c:v>0.8104809560486117</c:v>
                </c:pt>
                <c:pt idx="173">
                  <c:v>0.80633309759569416</c:v>
                </c:pt>
                <c:pt idx="174">
                  <c:v>0.80041618779563384</c:v>
                </c:pt>
                <c:pt idx="175">
                  <c:v>0.79321788303151741</c:v>
                </c:pt>
                <c:pt idx="176">
                  <c:v>0.78932299323932786</c:v>
                </c:pt>
                <c:pt idx="177">
                  <c:v>0.78602186338469593</c:v>
                </c:pt>
                <c:pt idx="178">
                  <c:v>0.78272579784407359</c:v>
                </c:pt>
                <c:pt idx="179">
                  <c:v>0.77721730644083842</c:v>
                </c:pt>
                <c:pt idx="180">
                  <c:v>0.7736542527360728</c:v>
                </c:pt>
                <c:pt idx="181">
                  <c:v>0.76912477969462023</c:v>
                </c:pt>
                <c:pt idx="182">
                  <c:v>0.76351141993544958</c:v>
                </c:pt>
                <c:pt idx="183">
                  <c:v>0.75931403002112963</c:v>
                </c:pt>
                <c:pt idx="184">
                  <c:v>0.75556674645431776</c:v>
                </c:pt>
                <c:pt idx="185">
                  <c:v>0.75237141135452623</c:v>
                </c:pt>
                <c:pt idx="186">
                  <c:v>0.74845947582250283</c:v>
                </c:pt>
                <c:pt idx="187">
                  <c:v>0.74518613793499311</c:v>
                </c:pt>
                <c:pt idx="188">
                  <c:v>0.74179712370433226</c:v>
                </c:pt>
                <c:pt idx="189">
                  <c:v>0.73802093649171197</c:v>
                </c:pt>
                <c:pt idx="190">
                  <c:v>0.73223872509230048</c:v>
                </c:pt>
                <c:pt idx="191">
                  <c:v>0.73052420776064275</c:v>
                </c:pt>
                <c:pt idx="192">
                  <c:v>0.72597280994512825</c:v>
                </c:pt>
                <c:pt idx="193">
                  <c:v>0.7226622308216758</c:v>
                </c:pt>
                <c:pt idx="194">
                  <c:v>0.71927136379320522</c:v>
                </c:pt>
                <c:pt idx="195">
                  <c:v>0.71638031985342665</c:v>
                </c:pt>
                <c:pt idx="196">
                  <c:v>0.71190365154950597</c:v>
                </c:pt>
                <c:pt idx="197">
                  <c:v>0.7086458154036559</c:v>
                </c:pt>
                <c:pt idx="198">
                  <c:v>0.7056473091910086</c:v>
                </c:pt>
                <c:pt idx="199">
                  <c:v>0.70051783845937776</c:v>
                </c:pt>
                <c:pt idx="200">
                  <c:v>0.69737987833171045</c:v>
                </c:pt>
                <c:pt idx="201">
                  <c:v>0.69338469041817774</c:v>
                </c:pt>
                <c:pt idx="202">
                  <c:v>0.68869921180128613</c:v>
                </c:pt>
                <c:pt idx="203">
                  <c:v>0.68429443205231477</c:v>
                </c:pt>
                <c:pt idx="204">
                  <c:v>0.68064528500940313</c:v>
                </c:pt>
                <c:pt idx="205">
                  <c:v>0.67545627770820471</c:v>
                </c:pt>
                <c:pt idx="206">
                  <c:v>0.67186814947310458</c:v>
                </c:pt>
                <c:pt idx="207">
                  <c:v>0.66847413268836398</c:v>
                </c:pt>
                <c:pt idx="208">
                  <c:v>0.66304957302583434</c:v>
                </c:pt>
                <c:pt idx="209">
                  <c:v>0.65742645519820742</c:v>
                </c:pt>
                <c:pt idx="210">
                  <c:v>0.6540347852906887</c:v>
                </c:pt>
                <c:pt idx="211">
                  <c:v>0.64929681073590095</c:v>
                </c:pt>
                <c:pt idx="212">
                  <c:v>0.64482001891212604</c:v>
                </c:pt>
                <c:pt idx="213">
                  <c:v>0.63964466055478009</c:v>
                </c:pt>
                <c:pt idx="214">
                  <c:v>0.63481571362761791</c:v>
                </c:pt>
                <c:pt idx="215">
                  <c:v>0.62995471329837727</c:v>
                </c:pt>
                <c:pt idx="216">
                  <c:v>0.62473519659327437</c:v>
                </c:pt>
                <c:pt idx="217">
                  <c:v>0.61900856912810198</c:v>
                </c:pt>
                <c:pt idx="218">
                  <c:v>0.6136655943290561</c:v>
                </c:pt>
                <c:pt idx="219">
                  <c:v>0.60915471102561125</c:v>
                </c:pt>
                <c:pt idx="220">
                  <c:v>0.60259210118944162</c:v>
                </c:pt>
                <c:pt idx="221">
                  <c:v>0.59735362418676807</c:v>
                </c:pt>
                <c:pt idx="222">
                  <c:v>0.59144764589377763</c:v>
                </c:pt>
                <c:pt idx="223">
                  <c:v>0.58424841473075639</c:v>
                </c:pt>
                <c:pt idx="224">
                  <c:v>0.57722828735584686</c:v>
                </c:pt>
                <c:pt idx="225">
                  <c:v>0.57259826915334522</c:v>
                </c:pt>
                <c:pt idx="226">
                  <c:v>0.56700109049503056</c:v>
                </c:pt>
                <c:pt idx="227">
                  <c:v>0.55978086095684965</c:v>
                </c:pt>
                <c:pt idx="228">
                  <c:v>0.55376408535493649</c:v>
                </c:pt>
                <c:pt idx="229">
                  <c:v>0.54548516714922901</c:v>
                </c:pt>
                <c:pt idx="230">
                  <c:v>0.53746619647599103</c:v>
                </c:pt>
                <c:pt idx="231">
                  <c:v>0.53121985922565873</c:v>
                </c:pt>
                <c:pt idx="232">
                  <c:v>0.5249807478867764</c:v>
                </c:pt>
                <c:pt idx="233">
                  <c:v>0.51710246632709933</c:v>
                </c:pt>
                <c:pt idx="234">
                  <c:v>0.50888027461428087</c:v>
                </c:pt>
                <c:pt idx="235">
                  <c:v>0.500716168112744</c:v>
                </c:pt>
                <c:pt idx="236">
                  <c:v>0.49353886172378458</c:v>
                </c:pt>
                <c:pt idx="237">
                  <c:v>0.48494268277340785</c:v>
                </c:pt>
                <c:pt idx="238">
                  <c:v>0.47743196541888688</c:v>
                </c:pt>
                <c:pt idx="239">
                  <c:v>0.46917571310636469</c:v>
                </c:pt>
                <c:pt idx="240">
                  <c:v>0.46109535306575455</c:v>
                </c:pt>
                <c:pt idx="241">
                  <c:v>0.4533898140217143</c:v>
                </c:pt>
                <c:pt idx="242">
                  <c:v>0.44415253614978428</c:v>
                </c:pt>
                <c:pt idx="243">
                  <c:v>0.43611673589645766</c:v>
                </c:pt>
                <c:pt idx="244">
                  <c:v>0.42733163332958563</c:v>
                </c:pt>
                <c:pt idx="245">
                  <c:v>0.41917237498231336</c:v>
                </c:pt>
                <c:pt idx="246">
                  <c:v>0.41014085030696995</c:v>
                </c:pt>
                <c:pt idx="247">
                  <c:v>0.40177972963850977</c:v>
                </c:pt>
                <c:pt idx="248">
                  <c:v>0.39159956296205323</c:v>
                </c:pt>
                <c:pt idx="249">
                  <c:v>0.38232488945436266</c:v>
                </c:pt>
                <c:pt idx="250">
                  <c:v>0.3729526043821505</c:v>
                </c:pt>
                <c:pt idx="251">
                  <c:v>0.36330675371357751</c:v>
                </c:pt>
                <c:pt idx="252">
                  <c:v>0.35378562721745194</c:v>
                </c:pt>
                <c:pt idx="253">
                  <c:v>0.34501392655472363</c:v>
                </c:pt>
                <c:pt idx="254">
                  <c:v>0.33532706729466633</c:v>
                </c:pt>
                <c:pt idx="255">
                  <c:v>0.32575458741929203</c:v>
                </c:pt>
                <c:pt idx="256">
                  <c:v>0.31509911634514109</c:v>
                </c:pt>
                <c:pt idx="257">
                  <c:v>0.30731168363798661</c:v>
                </c:pt>
                <c:pt idx="258">
                  <c:v>0.29843912901457326</c:v>
                </c:pt>
                <c:pt idx="259">
                  <c:v>0.29074251427997516</c:v>
                </c:pt>
                <c:pt idx="260">
                  <c:v>0.28297175675309383</c:v>
                </c:pt>
                <c:pt idx="261">
                  <c:v>0.27533659314579761</c:v>
                </c:pt>
                <c:pt idx="262">
                  <c:v>0.26870363875284764</c:v>
                </c:pt>
                <c:pt idx="263">
                  <c:v>0.26278663631289922</c:v>
                </c:pt>
                <c:pt idx="264">
                  <c:v>0.2568343380747049</c:v>
                </c:pt>
                <c:pt idx="265">
                  <c:v>0.25260606819691739</c:v>
                </c:pt>
                <c:pt idx="266">
                  <c:v>0.24746381316041058</c:v>
                </c:pt>
                <c:pt idx="267">
                  <c:v>0.24322790049166473</c:v>
                </c:pt>
                <c:pt idx="268">
                  <c:v>0.23961689020363452</c:v>
                </c:pt>
                <c:pt idx="269">
                  <c:v>0.23593237016256893</c:v>
                </c:pt>
                <c:pt idx="270">
                  <c:v>0.23255901207338645</c:v>
                </c:pt>
                <c:pt idx="271">
                  <c:v>0.22987436980942585</c:v>
                </c:pt>
                <c:pt idx="272">
                  <c:v>0.22804837580964976</c:v>
                </c:pt>
                <c:pt idx="273">
                  <c:v>0.22657206651618264</c:v>
                </c:pt>
                <c:pt idx="274">
                  <c:v>0.22668802077900405</c:v>
                </c:pt>
                <c:pt idx="275">
                  <c:v>0.22885599493420394</c:v>
                </c:pt>
                <c:pt idx="276">
                  <c:v>0.23258323740472703</c:v>
                </c:pt>
                <c:pt idx="277">
                  <c:v>0.23755745912002388</c:v>
                </c:pt>
                <c:pt idx="278">
                  <c:v>0.24474648445511923</c:v>
                </c:pt>
                <c:pt idx="279">
                  <c:v>0.25346846837666337</c:v>
                </c:pt>
                <c:pt idx="280">
                  <c:v>0.26425525649546139</c:v>
                </c:pt>
                <c:pt idx="281">
                  <c:v>0.27518345940696159</c:v>
                </c:pt>
                <c:pt idx="282">
                  <c:v>0.28624333448268457</c:v>
                </c:pt>
                <c:pt idx="283">
                  <c:v>0.29700997342532137</c:v>
                </c:pt>
                <c:pt idx="284">
                  <c:v>0.30726715473066663</c:v>
                </c:pt>
                <c:pt idx="285">
                  <c:v>0.31616027540974928</c:v>
                </c:pt>
                <c:pt idx="286">
                  <c:v>0.32353669580314803</c:v>
                </c:pt>
                <c:pt idx="287">
                  <c:v>0.33060227848427981</c:v>
                </c:pt>
                <c:pt idx="288">
                  <c:v>0.33795674322365565</c:v>
                </c:pt>
                <c:pt idx="289">
                  <c:v>0.34621389105511924</c:v>
                </c:pt>
                <c:pt idx="290">
                  <c:v>0.3566202225840111</c:v>
                </c:pt>
                <c:pt idx="291">
                  <c:v>0.37129641930148555</c:v>
                </c:pt>
                <c:pt idx="292">
                  <c:v>0.3902500159186208</c:v>
                </c:pt>
                <c:pt idx="293">
                  <c:v>0.41295398409891843</c:v>
                </c:pt>
                <c:pt idx="294">
                  <c:v>0.44039419755604825</c:v>
                </c:pt>
                <c:pt idx="295">
                  <c:v>0.47149856571833743</c:v>
                </c:pt>
                <c:pt idx="296">
                  <c:v>0.50417342706266932</c:v>
                </c:pt>
                <c:pt idx="297">
                  <c:v>0.53418495331783222</c:v>
                </c:pt>
                <c:pt idx="298">
                  <c:v>0.55933050756963798</c:v>
                </c:pt>
                <c:pt idx="299">
                  <c:v>0.57581441734851224</c:v>
                </c:pt>
                <c:pt idx="300">
                  <c:v>0.58188844440269538</c:v>
                </c:pt>
                <c:pt idx="301">
                  <c:v>0.5770081132163235</c:v>
                </c:pt>
                <c:pt idx="302">
                  <c:v>0.56210482524750882</c:v>
                </c:pt>
                <c:pt idx="303">
                  <c:v>0.53638935038994429</c:v>
                </c:pt>
                <c:pt idx="304">
                  <c:v>0.50443445539386167</c:v>
                </c:pt>
                <c:pt idx="305">
                  <c:v>0.4665670664324984</c:v>
                </c:pt>
                <c:pt idx="306">
                  <c:v>0.42628038673325175</c:v>
                </c:pt>
                <c:pt idx="307">
                  <c:v>0.3875092956410025</c:v>
                </c:pt>
                <c:pt idx="308">
                  <c:v>0.35013756097326043</c:v>
                </c:pt>
                <c:pt idx="309">
                  <c:v>0.31731642124198217</c:v>
                </c:pt>
                <c:pt idx="310">
                  <c:v>0.28531637973931057</c:v>
                </c:pt>
                <c:pt idx="311">
                  <c:v>0.2577174587099379</c:v>
                </c:pt>
                <c:pt idx="312">
                  <c:v>0.23252813210991888</c:v>
                </c:pt>
                <c:pt idx="313">
                  <c:v>0.21147228933982293</c:v>
                </c:pt>
                <c:pt idx="314">
                  <c:v>0.19202058347196901</c:v>
                </c:pt>
                <c:pt idx="315">
                  <c:v>0.17477688763195107</c:v>
                </c:pt>
                <c:pt idx="316">
                  <c:v>0.15838969389865656</c:v>
                </c:pt>
                <c:pt idx="317">
                  <c:v>0.144138112118848</c:v>
                </c:pt>
                <c:pt idx="318">
                  <c:v>0.13068598171325646</c:v>
                </c:pt>
                <c:pt idx="319">
                  <c:v>0.11828641802243624</c:v>
                </c:pt>
                <c:pt idx="320">
                  <c:v>0.10643429432397254</c:v>
                </c:pt>
                <c:pt idx="321">
                  <c:v>9.5926576155023438E-2</c:v>
                </c:pt>
                <c:pt idx="322">
                  <c:v>8.6422634358566661E-2</c:v>
                </c:pt>
                <c:pt idx="323">
                  <c:v>7.7163493472500649E-2</c:v>
                </c:pt>
                <c:pt idx="324">
                  <c:v>6.8943911116595522E-2</c:v>
                </c:pt>
                <c:pt idx="325">
                  <c:v>6.1135109474720041E-2</c:v>
                </c:pt>
                <c:pt idx="326">
                  <c:v>5.4133181978280452E-2</c:v>
                </c:pt>
                <c:pt idx="327">
                  <c:v>4.761790340611563E-2</c:v>
                </c:pt>
                <c:pt idx="328">
                  <c:v>4.1610920612616446E-2</c:v>
                </c:pt>
                <c:pt idx="329">
                  <c:v>3.6408947586758694E-2</c:v>
                </c:pt>
                <c:pt idx="330">
                  <c:v>3.1701017306428568E-2</c:v>
                </c:pt>
                <c:pt idx="331">
                  <c:v>2.7371079008918775E-2</c:v>
                </c:pt>
                <c:pt idx="332">
                  <c:v>2.3450776936792869E-2</c:v>
                </c:pt>
                <c:pt idx="333">
                  <c:v>2.0050624689308974E-2</c:v>
                </c:pt>
                <c:pt idx="334">
                  <c:v>1.7040623410260896E-2</c:v>
                </c:pt>
                <c:pt idx="335">
                  <c:v>1.4489194413703464E-2</c:v>
                </c:pt>
                <c:pt idx="336">
                  <c:v>1.2225615891607384E-2</c:v>
                </c:pt>
                <c:pt idx="337">
                  <c:v>1.0267106318602542E-2</c:v>
                </c:pt>
                <c:pt idx="338">
                  <c:v>8.5383359538070483E-3</c:v>
                </c:pt>
                <c:pt idx="339">
                  <c:v>7.0680231632458922E-3</c:v>
                </c:pt>
                <c:pt idx="340">
                  <c:v>5.8917682023025466E-3</c:v>
                </c:pt>
                <c:pt idx="341">
                  <c:v>4.8704544230576E-3</c:v>
                </c:pt>
                <c:pt idx="342">
                  <c:v>3.9864838650801255E-3</c:v>
                </c:pt>
                <c:pt idx="343">
                  <c:v>3.2287100678068457E-3</c:v>
                </c:pt>
                <c:pt idx="344">
                  <c:v>2.6457450899777268E-3</c:v>
                </c:pt>
                <c:pt idx="345">
                  <c:v>2.1630152673164193E-3</c:v>
                </c:pt>
                <c:pt idx="346">
                  <c:v>1.7534686662014306E-3</c:v>
                </c:pt>
                <c:pt idx="347">
                  <c:v>1.4182077978284471E-3</c:v>
                </c:pt>
                <c:pt idx="348">
                  <c:v>1.1497797347645845E-3</c:v>
                </c:pt>
                <c:pt idx="349">
                  <c:v>9.4829907062426804E-4</c:v>
                </c:pt>
                <c:pt idx="350">
                  <c:v>7.7644302706184314E-4</c:v>
                </c:pt>
                <c:pt idx="351">
                  <c:v>6.5018969329958584E-4</c:v>
                </c:pt>
                <c:pt idx="352">
                  <c:v>5.2699691372907163E-4</c:v>
                </c:pt>
                <c:pt idx="353">
                  <c:v>4.4749385434687187E-4</c:v>
                </c:pt>
                <c:pt idx="354">
                  <c:v>3.9946028226625825E-4</c:v>
                </c:pt>
                <c:pt idx="355">
                  <c:v>3.3762080323733598E-4</c:v>
                </c:pt>
                <c:pt idx="356">
                  <c:v>2.978918002383349E-4</c:v>
                </c:pt>
                <c:pt idx="357">
                  <c:v>2.7496400033158935E-4</c:v>
                </c:pt>
                <c:pt idx="358">
                  <c:v>2.4203635452068638E-4</c:v>
                </c:pt>
                <c:pt idx="359">
                  <c:v>2.136620558229917E-4</c:v>
                </c:pt>
                <c:pt idx="360">
                  <c:v>2.0527188832702051E-4</c:v>
                </c:pt>
                <c:pt idx="361">
                  <c:v>1.9289663742056231E-4</c:v>
                </c:pt>
                <c:pt idx="362">
                  <c:v>1.8309843104348224E-4</c:v>
                </c:pt>
                <c:pt idx="363">
                  <c:v>1.8088295952384882E-4</c:v>
                </c:pt>
                <c:pt idx="364">
                  <c:v>1.7312853026014871E-4</c:v>
                </c:pt>
                <c:pt idx="365">
                  <c:v>1.6815754973476747E-4</c:v>
                </c:pt>
                <c:pt idx="366">
                  <c:v>1.7077866757138032E-4</c:v>
                </c:pt>
                <c:pt idx="367">
                  <c:v>1.6577643012985217E-4</c:v>
                </c:pt>
                <c:pt idx="368">
                  <c:v>1.5960452360333963E-4</c:v>
                </c:pt>
                <c:pt idx="369">
                  <c:v>1.5962061194368132E-4</c:v>
                </c:pt>
                <c:pt idx="370">
                  <c:v>1.5932363354501881E-4</c:v>
                </c:pt>
                <c:pt idx="371">
                  <c:v>1.6241998316316329E-4</c:v>
                </c:pt>
                <c:pt idx="372">
                  <c:v>1.5328257483245778E-4</c:v>
                </c:pt>
                <c:pt idx="373">
                  <c:v>1.5772476613966767E-4</c:v>
                </c:pt>
                <c:pt idx="374">
                  <c:v>1.5087898884787114E-4</c:v>
                </c:pt>
                <c:pt idx="375">
                  <c:v>1.5118582832861774E-4</c:v>
                </c:pt>
                <c:pt idx="376">
                  <c:v>1.5485265813123636E-4</c:v>
                </c:pt>
                <c:pt idx="377">
                  <c:v>1.523355943121487E-4</c:v>
                </c:pt>
                <c:pt idx="378">
                  <c:v>1.5390128988174308E-4</c:v>
                </c:pt>
                <c:pt idx="379">
                  <c:v>1.524302697470187E-4</c:v>
                </c:pt>
                <c:pt idx="380">
                  <c:v>1.517801620786221E-4</c:v>
                </c:pt>
                <c:pt idx="381">
                  <c:v>1.1842056619279596E-4</c:v>
                </c:pt>
                <c:pt idx="382">
                  <c:v>1.2117419043514831E-4</c:v>
                </c:pt>
                <c:pt idx="383">
                  <c:v>1.274815963716724E-4</c:v>
                </c:pt>
                <c:pt idx="384">
                  <c:v>1.2190303597914485E-4</c:v>
                </c:pt>
                <c:pt idx="385">
                  <c:v>1.1537300932942767E-4</c:v>
                </c:pt>
                <c:pt idx="386">
                  <c:v>1.2569830109856935E-4</c:v>
                </c:pt>
                <c:pt idx="387">
                  <c:v>1.2235056173876642E-4</c:v>
                </c:pt>
                <c:pt idx="388">
                  <c:v>1.1856887445484139E-4</c:v>
                </c:pt>
                <c:pt idx="389">
                  <c:v>1.2299806089462425E-4</c:v>
                </c:pt>
                <c:pt idx="390">
                  <c:v>1.287804999131424E-4</c:v>
                </c:pt>
                <c:pt idx="391">
                  <c:v>1.1849189317872574E-4</c:v>
                </c:pt>
                <c:pt idx="392">
                  <c:v>1.1697134900102787E-4</c:v>
                </c:pt>
                <c:pt idx="393">
                  <c:v>1.2246026250742353E-4</c:v>
                </c:pt>
                <c:pt idx="394">
                  <c:v>1.2147335515934945E-4</c:v>
                </c:pt>
                <c:pt idx="395">
                  <c:v>1.2535344217061385E-4</c:v>
                </c:pt>
                <c:pt idx="396">
                  <c:v>1.3452988772076179E-4</c:v>
                </c:pt>
                <c:pt idx="397">
                  <c:v>1.1707620215823232E-4</c:v>
                </c:pt>
                <c:pt idx="398">
                  <c:v>1.1920424327348712E-4</c:v>
                </c:pt>
                <c:pt idx="399">
                  <c:v>1.3048207938448088E-4</c:v>
                </c:pt>
                <c:pt idx="400">
                  <c:v>1.2175440353779559E-4</c:v>
                </c:pt>
                <c:pt idx="401">
                  <c:v>1.1609415749971809E-4</c:v>
                </c:pt>
                <c:pt idx="402">
                  <c:v>1.1952961374793591E-4</c:v>
                </c:pt>
                <c:pt idx="403">
                  <c:v>1.1979149031312543E-4</c:v>
                </c:pt>
                <c:pt idx="404">
                  <c:v>1.133595392114433E-4</c:v>
                </c:pt>
                <c:pt idx="405">
                  <c:v>1.1204720107649196E-4</c:v>
                </c:pt>
                <c:pt idx="406">
                  <c:v>1.1250755076625484E-4</c:v>
                </c:pt>
                <c:pt idx="407">
                  <c:v>1.1165068455339935E-4</c:v>
                </c:pt>
                <c:pt idx="408">
                  <c:v>1.1109786837146547E-4</c:v>
                </c:pt>
                <c:pt idx="409">
                  <c:v>1.0853590194924923E-4</c:v>
                </c:pt>
                <c:pt idx="410">
                  <c:v>1.1291706461772099E-4</c:v>
                </c:pt>
                <c:pt idx="411">
                  <c:v>1.2049090339194176E-4</c:v>
                </c:pt>
                <c:pt idx="412">
                  <c:v>1.1132552517245088E-4</c:v>
                </c:pt>
                <c:pt idx="413">
                  <c:v>1.2063127303056638E-4</c:v>
                </c:pt>
                <c:pt idx="414">
                  <c:v>1.2445624202110016E-4</c:v>
                </c:pt>
                <c:pt idx="415">
                  <c:v>1.1612703531238486E-4</c:v>
                </c:pt>
                <c:pt idx="416">
                  <c:v>1.2078580855086965E-4</c:v>
                </c:pt>
                <c:pt idx="417">
                  <c:v>1.1149318618503862E-4</c:v>
                </c:pt>
                <c:pt idx="418">
                  <c:v>1.128632885485277E-4</c:v>
                </c:pt>
                <c:pt idx="419">
                  <c:v>1.1664422192709481E-4</c:v>
                </c:pt>
                <c:pt idx="420">
                  <c:v>1.0799881223308539E-4</c:v>
                </c:pt>
                <c:pt idx="421">
                  <c:v>1.2110488391557814E-4</c:v>
                </c:pt>
                <c:pt idx="422">
                  <c:v>1.1623911842197349E-4</c:v>
                </c:pt>
                <c:pt idx="423">
                  <c:v>1.1354006938849391E-4</c:v>
                </c:pt>
                <c:pt idx="424">
                  <c:v>1.0776495833005625E-4</c:v>
                </c:pt>
                <c:pt idx="425">
                  <c:v>1.2351949199650028E-4</c:v>
                </c:pt>
                <c:pt idx="426">
                  <c:v>1.0992294456613475E-4</c:v>
                </c:pt>
                <c:pt idx="427">
                  <c:v>1.1194941201249264E-4</c:v>
                </c:pt>
                <c:pt idx="428">
                  <c:v>1.1298454668632445E-4</c:v>
                </c:pt>
                <c:pt idx="429">
                  <c:v>1.2121271499894725E-4</c:v>
                </c:pt>
                <c:pt idx="430">
                  <c:v>1.1637655536875502E-4</c:v>
                </c:pt>
                <c:pt idx="431">
                  <c:v>1.0992677440535388E-4</c:v>
                </c:pt>
                <c:pt idx="432">
                  <c:v>1.2095314538415356E-4</c:v>
                </c:pt>
                <c:pt idx="433">
                  <c:v>1.1919538488552936E-4</c:v>
                </c:pt>
                <c:pt idx="434">
                  <c:v>1.1550112800598323E-4</c:v>
                </c:pt>
                <c:pt idx="435">
                  <c:v>1.1614010803129433E-4</c:v>
                </c:pt>
                <c:pt idx="436">
                  <c:v>1.1575772723366598E-4</c:v>
                </c:pt>
                <c:pt idx="437">
                  <c:v>1.1082560299044117E-4</c:v>
                </c:pt>
                <c:pt idx="438">
                  <c:v>1.1236176054810532E-4</c:v>
                </c:pt>
                <c:pt idx="439">
                  <c:v>1.1291261657610806E-4</c:v>
                </c:pt>
                <c:pt idx="440">
                  <c:v>1.131417208753811E-4</c:v>
                </c:pt>
                <c:pt idx="441">
                  <c:v>1.1513819796659377E-4</c:v>
                </c:pt>
                <c:pt idx="442">
                  <c:v>1.0861460966863476E-4</c:v>
                </c:pt>
                <c:pt idx="443">
                  <c:v>1.1488995954933248E-4</c:v>
                </c:pt>
                <c:pt idx="444">
                  <c:v>1.1743610903713559E-4</c:v>
                </c:pt>
                <c:pt idx="445">
                  <c:v>1.1610982365305938E-4</c:v>
                </c:pt>
                <c:pt idx="446">
                  <c:v>1.1358623855262394E-4</c:v>
                </c:pt>
                <c:pt idx="447">
                  <c:v>1.2070587196575026E-4</c:v>
                </c:pt>
                <c:pt idx="448">
                  <c:v>1.1567354616138053E-4</c:v>
                </c:pt>
                <c:pt idx="449">
                  <c:v>1.1197343143720166E-4</c:v>
                </c:pt>
                <c:pt idx="450">
                  <c:v>1.1168748267392812E-4</c:v>
                </c:pt>
                <c:pt idx="451">
                  <c:v>1.1165405451035001E-4</c:v>
                </c:pt>
                <c:pt idx="452">
                  <c:v>1.1534574811167867E-4</c:v>
                </c:pt>
                <c:pt idx="453">
                  <c:v>1.1378922757029242E-4</c:v>
                </c:pt>
                <c:pt idx="454">
                  <c:v>1.1770339110374281E-4</c:v>
                </c:pt>
                <c:pt idx="455">
                  <c:v>1.1536862913929722E-4</c:v>
                </c:pt>
                <c:pt idx="456">
                  <c:v>1.1267800876772101E-4</c:v>
                </c:pt>
                <c:pt idx="457">
                  <c:v>1.1864685842508312E-4</c:v>
                </c:pt>
                <c:pt idx="458">
                  <c:v>1.2153923894859395E-4</c:v>
                </c:pt>
                <c:pt idx="459">
                  <c:v>1.1891698271489034E-4</c:v>
                </c:pt>
                <c:pt idx="460">
                  <c:v>1.2744905781641666E-4</c:v>
                </c:pt>
                <c:pt idx="461">
                  <c:v>1.2178558506340659E-4</c:v>
                </c:pt>
                <c:pt idx="462">
                  <c:v>1.2766187022090114E-4</c:v>
                </c:pt>
                <c:pt idx="463">
                  <c:v>1.2081588183560427E-4</c:v>
                </c:pt>
                <c:pt idx="464">
                  <c:v>1.2459847380595908E-4</c:v>
                </c:pt>
                <c:pt idx="465">
                  <c:v>1.2205019076599234E-4</c:v>
                </c:pt>
                <c:pt idx="466">
                  <c:v>1.2163634195871702E-4</c:v>
                </c:pt>
                <c:pt idx="467">
                  <c:v>1.1796333013216212E-4</c:v>
                </c:pt>
                <c:pt idx="468">
                  <c:v>1.1803530547669979E-4</c:v>
                </c:pt>
                <c:pt idx="469">
                  <c:v>1.1224167850266715E-4</c:v>
                </c:pt>
                <c:pt idx="470">
                  <c:v>1.1579832503719978E-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1B0-420F-A730-A5A6354D5E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030720"/>
        <c:axId val="164033600"/>
      </c:scatterChart>
      <c:valAx>
        <c:axId val="164030720"/>
        <c:scaling>
          <c:orientation val="minMax"/>
          <c:max val="750"/>
          <c:min val="3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avelength (nm)</a:t>
                </a:r>
              </a:p>
            </c:rich>
          </c:tx>
          <c:layout>
            <c:manualLayout>
              <c:xMode val="edge"/>
              <c:yMode val="edge"/>
              <c:x val="0.40003484643591292"/>
              <c:y val="0.9200346400638248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it-IT"/>
          </a:p>
        </c:txPr>
        <c:crossAx val="164033600"/>
        <c:crosses val="autoZero"/>
        <c:crossBetween val="midCat"/>
        <c:majorUnit val="50"/>
      </c:valAx>
      <c:valAx>
        <c:axId val="164033600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Transmittance </a:t>
                </a:r>
                <a:endParaRPr lang="it-IT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it-IT"/>
          </a:p>
        </c:txPr>
        <c:crossAx val="16403072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ayout>
        <c:manualLayout>
          <c:xMode val="edge"/>
          <c:yMode val="edge"/>
          <c:x val="0.20092279116754741"/>
          <c:y val="1.9402721914126543E-2"/>
          <c:w val="0.30611239384550609"/>
          <c:h val="0.25069893829568157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3347AA3-7A32-C0F5-1437-ED77757575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CFCE5E-20A6-3AFA-8D05-AB6C0C0EEC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90F813E-7BFC-C5FF-6A74-D3671C043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ADF9D4A-A3E5-35B1-3AE9-9DF298C17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4E12E3-40E2-F13B-14BE-6310B9799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8637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EBFF0B6-3896-83FC-9569-04F6ABEB28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395DF67-79FB-E29A-A732-A7B43CF920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120DE50-ACBE-E68C-8388-3C406A9DA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9713963-3DD9-4D6F-AFFE-3B7292828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EA3DC28-0A93-DE21-2E0F-FC4A9E4A8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768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511C9C9-0EEF-2579-A0CF-842D225131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3C00182-00CB-B0A5-DDF3-8BABC50C4B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578A647-5C0E-BA43-AF0A-0BA9694B4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DCD5EA-043F-408F-B3E5-6C1626E85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AE5C0A-0420-2154-5B8E-D6A0B3CF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9711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E85803-5439-D54D-1BB1-87AE346AC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7DACE8C-DED1-0359-9ECD-2C43576C4E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34FAFC-8A01-996D-8DD7-91149A19D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ACF957-0E41-621B-9B09-11AAA8DB6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7F2F856-5854-AAD8-083C-18837DF9D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5510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937CEF-1869-D04A-CE71-879E84FF9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2C67DA-F944-945B-787F-479DC87E61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153531-1288-00D1-371F-259FCCDE4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2B47C4-C536-14A5-AAF7-F80E34DC8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5D074BE-4F00-AB64-D906-18B0F46D9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5221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5A5626-5A42-D7DE-3399-7388372FF3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B629894-D11D-27A6-7F21-DA16BB16E9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0C16D61-1049-50EB-E081-8DB7E6BAAB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7FCD84E-B152-FC1D-466F-F50988DD9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76DA1F5-4232-820C-7D3D-68DB9F039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46FC247-D5F2-D187-5340-59FB36B5C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8385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17B38C-A296-9897-AC3D-B1528BFC9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D6D6F18-B66E-18AD-42F0-32AE2250FE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49B378B-CEFD-F1A8-2810-E6B4902D61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CD938F1-BF9B-5A7D-597E-85FBCCBECB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3527AD7-6FCA-69C9-280A-1C2BD7DCC7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9F7849B-551E-0718-D9E7-D427822D2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4D59BF1-1CF5-F5A3-0A0A-5C0178248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7F1EA8EE-C1AD-A209-F846-02B3ED8E4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2626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67C6D0-321E-D43D-B1B7-A5337839F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2368422-54F5-4580-CDC2-072D894D0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2833305-B3D4-B387-14FD-2ABD1C9D5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82B063A-866D-04A3-830D-F70513414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800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7286933-EACE-88FD-9691-554B4FB36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922508E-1561-9AEE-CAD7-8F836630D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81982C3-7387-00F9-006E-D974D8686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8242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5A7EC9-660E-59E0-C44C-B9207082A5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B39C1D9-B08A-8EE7-14E2-141C4F84D8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CB2E9DF-9AF9-8ABA-BF51-5B58FB2B79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31FB7F9-EF11-A8F1-3507-10395C804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161D9D5-7CF4-D1E3-6BF8-1EE7CBFC2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2E614D6-2993-4FB8-EE3D-B8368E287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7341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35ABE7-3B46-5A95-2ACD-FE119C094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5124119-3C46-D60D-AFCF-BEC79BCF53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CC09715-D0E9-80C5-18A4-3324BDAE38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DE967EC-09D8-C645-04E2-07ACE96DD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80ADAC0-E91D-31A5-8E42-3AB91F129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793820D-2F95-F3C2-0E59-1EAB98292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08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2A0EE63-6410-6EC1-F85D-AE9D4BFCA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70C764B-E6CF-4DB9-C757-E1871F862A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644E3A-902E-FB87-55BE-AD3A64AEF2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BA6F6-24CF-47CE-BE01-9817D6C2957F}" type="datetimeFigureOut">
              <a:rPr lang="it-IT" smtClean="0"/>
              <a:t>23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84172B-75A6-41F7-021C-AF33ED5822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BC9DB22-46AF-D4E7-77BC-9981211E80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F1FB5-ED9B-4CB1-B414-B65F2E56717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193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30DDB785-61A1-D5F0-BC6B-C2D35F805E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0342630"/>
              </p:ext>
            </p:extLst>
          </p:nvPr>
        </p:nvGraphicFramePr>
        <p:xfrm>
          <a:off x="2967990" y="1375886"/>
          <a:ext cx="6256020" cy="41062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4D29B979-7BE0-BA4C-5D44-8BA0628CF480}"/>
              </a:ext>
            </a:extLst>
          </p:cNvPr>
          <p:cNvSpPr txBox="1"/>
          <p:nvPr/>
        </p:nvSpPr>
        <p:spPr>
          <a:xfrm>
            <a:off x="6921911" y="791111"/>
            <a:ext cx="2133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D source </a:t>
            </a:r>
            <a:r>
              <a:rPr lang="it-IT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um</a:t>
            </a:r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.U)</a:t>
            </a:r>
          </a:p>
        </p:txBody>
      </p:sp>
      <p:cxnSp>
        <p:nvCxnSpPr>
          <p:cNvPr id="3" name="Connettore 2 2">
            <a:extLst>
              <a:ext uri="{FF2B5EF4-FFF2-40B4-BE49-F238E27FC236}">
                <a16:creationId xmlns:a16="http://schemas.microsoft.com/office/drawing/2014/main" id="{E24335C7-71AF-2BE0-6666-163B2D1A445D}"/>
              </a:ext>
            </a:extLst>
          </p:cNvPr>
          <p:cNvCxnSpPr>
            <a:cxnSpLocks/>
          </p:cNvCxnSpPr>
          <p:nvPr/>
        </p:nvCxnSpPr>
        <p:spPr>
          <a:xfrm flipH="1">
            <a:off x="7678994" y="1375886"/>
            <a:ext cx="349046" cy="452914"/>
          </a:xfrm>
          <a:prstGeom prst="straightConnector1">
            <a:avLst/>
          </a:prstGeom>
          <a:ln w="254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28582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1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a Mercatelli</dc:creator>
  <cp:lastModifiedBy>Alberto</cp:lastModifiedBy>
  <cp:revision>15</cp:revision>
  <dcterms:created xsi:type="dcterms:W3CDTF">2022-10-06T16:07:31Z</dcterms:created>
  <dcterms:modified xsi:type="dcterms:W3CDTF">2023-02-23T15:30:03Z</dcterms:modified>
</cp:coreProperties>
</file>